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notesMasterIdLst>
    <p:notesMasterId r:id="rId3"/>
  </p:notesMasterIdLst>
  <p:sldIdLst>
    <p:sldId id="259" r:id="rId2"/>
  </p:sldIdLst>
  <p:sldSz cx="9144000" cy="5029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9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4351571-952B-5DBD-41C1-0047BFA69FA8}" name="Igudesman, Daria" initials="ID" userId="S::DIG8D0@multihosp.net::8ae08701-45ed-449c-a1ee-539f157c68ca" providerId="AD"/>
  <p188:author id="{8C4EABF9-909C-B9EA-9CF6-0A7BA2394B01}" name="Mucinski, Justine" initials="MJ" userId="S::JMM815@multihosp.net::2c03fd17-7195-4ea0-94f8-d886f3058fbb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AE3F3"/>
    <a:srgbClr val="E2F0D9"/>
    <a:srgbClr val="98B78B"/>
    <a:srgbClr val="FFEBEB"/>
    <a:srgbClr val="FFBDBD"/>
    <a:srgbClr val="80A67E"/>
    <a:srgbClr val="BCCCEA"/>
    <a:srgbClr val="FAEFFB"/>
    <a:srgbClr val="EFD2F2"/>
    <a:srgbClr val="E3E1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41" d="100"/>
          <a:sy n="141" d="100"/>
        </p:scale>
        <p:origin x="744" y="120"/>
      </p:cViewPr>
      <p:guideLst>
        <p:guide orient="horz" pos="159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gudesman, Daria" userId="8ae08701-45ed-449c-a1ee-539f157c68ca" providerId="ADAL" clId="{E792F027-F17D-4624-80F5-D08FE1A0A0F1}"/>
    <pc:docChg chg="undo custSel modSld modMainMaster modNotesMaster">
      <pc:chgData name="Igudesman, Daria" userId="8ae08701-45ed-449c-a1ee-539f157c68ca" providerId="ADAL" clId="{E792F027-F17D-4624-80F5-D08FE1A0A0F1}" dt="2023-10-10T16:45:51.405" v="542" actId="20577"/>
      <pc:docMkLst>
        <pc:docMk/>
      </pc:docMkLst>
      <pc:sldChg chg="addSp delSp modSp mod modNotes">
        <pc:chgData name="Igudesman, Daria" userId="8ae08701-45ed-449c-a1ee-539f157c68ca" providerId="ADAL" clId="{E792F027-F17D-4624-80F5-D08FE1A0A0F1}" dt="2023-10-10T16:45:51.405" v="542" actId="20577"/>
        <pc:sldMkLst>
          <pc:docMk/>
          <pc:sldMk cId="1922018481" sldId="259"/>
        </pc:sldMkLst>
        <pc:spChg chg="mod">
          <ac:chgData name="Igudesman, Daria" userId="8ae08701-45ed-449c-a1ee-539f157c68ca" providerId="ADAL" clId="{E792F027-F17D-4624-80F5-D08FE1A0A0F1}" dt="2023-10-10T16:45:51.405" v="542" actId="20577"/>
          <ac:spMkLst>
            <pc:docMk/>
            <pc:sldMk cId="1922018481" sldId="259"/>
            <ac:spMk id="7" creationId="{E43CE3C7-91E2-21C6-D58C-E16741F16F7B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9" creationId="{00000000-0000-0000-0000-000000000000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04" creationId="{9DA2BD1B-7155-D7D4-F1EB-EAF343D1BD44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05" creationId="{A47261E7-3E88-C978-98B8-56DDEC35443A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07" creationId="{3A963CD4-23FF-D1D6-E9EE-D9AEF76B0B48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08" creationId="{481650F8-C064-7CFF-0196-A3E4892A25A3}"/>
          </ac:spMkLst>
        </pc:spChg>
        <pc:spChg chg="mod or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09" creationId="{904B4849-B1D6-05D6-2D80-8709A70F18B5}"/>
          </ac:spMkLst>
        </pc:spChg>
        <pc:spChg chg="mod topLvl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11" creationId="{E09EE04A-FB33-853C-0423-8D96C544EF06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13" creationId="{0021E7A6-77F7-E271-E550-63FB67CE447A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15" creationId="{889F2975-05DE-3433-6F43-12429EFF9BF0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22" creationId="{4B7970E5-7323-8538-AE32-DBB67F98C343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23" creationId="{D6BC4DE0-D7EE-888C-3254-34F6FBC2B189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24" creationId="{DAFEC0BE-B6CD-4AEB-1E12-D7D8D0DBC993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25" creationId="{BC227F3F-0D38-A434-42F6-D7B9CA1F82F3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26" creationId="{5FACF7F6-ECF9-C015-7C40-88180965D983}"/>
          </ac:spMkLst>
        </pc:spChg>
        <pc:spChg chg="mod topLvl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28" creationId="{619D83FF-0D4D-2327-9F60-F6490A69573B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30" creationId="{813C144E-36D0-34B7-2E83-676711D2F926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33" creationId="{C6548962-FC4F-9FB9-8DD0-F1F504BCB2D9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35" creationId="{F56A0894-6700-5498-B86B-AD0DBD9CBE28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39" creationId="{E80C353C-6B00-2A07-DE6A-133857118DD3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40" creationId="{10DCD9C6-B33F-1BF2-6414-9BCAD10847F9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43" creationId="{AE69DA14-746D-C283-1CB5-7F4FD2C5E3B1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49" creationId="{9DDCB0F0-E3FC-912D-C9BD-E63680A4AC4A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50" creationId="{CCCE3695-D787-98C9-5B41-453E8B8E9945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51" creationId="{56BE045F-7C15-8452-1C5D-B4272AA8F353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52" creationId="{ED53E598-6B72-7C7B-91F3-7591B91062FB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53" creationId="{4FCCC94B-6DAD-5ADB-54D2-EA9DD20B489D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54" creationId="{343D4661-1506-F265-3E29-1CFA90287C96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55" creationId="{A10ACE75-AC6F-802D-BDAC-1D00AEE1536D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56" creationId="{CA8BDE01-6D94-13CD-6BA4-4C9EE8C5661E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57" creationId="{7B80E4CD-6657-90A5-791A-CE4C77DC444B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58" creationId="{9D6A2A29-A358-2DBF-E953-DF485E2FCF41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59" creationId="{B3F94EBD-BB05-499D-D285-B26D8EA726B9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60" creationId="{71227CE8-101F-EF72-D5EC-01E46CCE572A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61" creationId="{EED78570-895E-77DE-F9AF-D7F1A871EDD2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62" creationId="{8458D39F-0580-771E-ABD9-351A9CDB2F93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63" creationId="{A666FC61-2ED1-CBD5-2598-F9163F07AC53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64" creationId="{604185F5-B710-D47F-1F98-C691B4CD40BA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66" creationId="{77E0000F-9218-7ABE-A68A-EBE1C9578E3C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67" creationId="{57C6B827-FEDA-8557-9446-96A4291586D5}"/>
          </ac:spMkLst>
        </pc:spChg>
        <pc:spChg chg="add del mod topLvl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69" creationId="{6BE1F158-A882-4BFA-F8B7-D931FCE879CA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75" creationId="{82F66026-774D-B704-D977-A1FB8D650EB4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76" creationId="{A073806C-C4A7-2D52-D3EC-B26F305D9329}"/>
          </ac:spMkLst>
        </pc:spChg>
        <pc:spChg chg="mod ord topLvl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77" creationId="{4F51A89D-A0AE-346B-09AD-1153F0C76EFC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81" creationId="{E6C0BEC2-6ADD-AE50-F547-BD7BF65908FB}"/>
          </ac:spMkLst>
        </pc:spChg>
        <pc:spChg chg="mod or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82" creationId="{33DD94EC-7537-A352-52AF-0DBD4A1703B6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83" creationId="{CFF5DD40-A2D9-AD83-A6BA-72FE3570AA2C}"/>
          </ac:spMkLst>
        </pc:spChg>
        <pc:spChg chg="mod ord topLvl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86" creationId="{69CF30A4-12DC-3A6E-75F0-16ECDCB5B17C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87" creationId="{E838BB57-2611-9005-3119-7EDF5B431B26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89" creationId="{78B271E1-9581-F0D1-F9BB-96CE78F69FA4}"/>
          </ac:spMkLst>
        </pc:spChg>
        <pc:spChg chg="mod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92" creationId="{6B3BEFFE-A5FC-C3AF-CCE4-B31BF1E562BE}"/>
          </ac:spMkLst>
        </pc:spChg>
        <pc:spChg chg="mod topLvl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93" creationId="{35DE8228-52B3-B589-103C-83B639A49E38}"/>
          </ac:spMkLst>
        </pc:spChg>
        <pc:spChg chg="mod topLvl">
          <ac:chgData name="Igudesman, Daria" userId="8ae08701-45ed-449c-a1ee-539f157c68ca" providerId="ADAL" clId="{E792F027-F17D-4624-80F5-D08FE1A0A0F1}" dt="2023-09-29T15:55:32.043" v="539" actId="1036"/>
          <ac:spMkLst>
            <pc:docMk/>
            <pc:sldMk cId="1922018481" sldId="259"/>
            <ac:spMk id="194" creationId="{20F69FF0-1B9C-2786-2CEA-29CBC93117FA}"/>
          </ac:spMkLst>
        </pc:spChg>
        <pc:grpChg chg="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3" creationId="{74A93AB4-2BF1-73B6-0D97-4005CD52A6E4}"/>
          </ac:grpSpMkLst>
        </pc:grpChg>
        <pc:grpChg chg="del mod">
          <ac:chgData name="Igudesman, Daria" userId="8ae08701-45ed-449c-a1ee-539f157c68ca" providerId="ADAL" clId="{E792F027-F17D-4624-80F5-D08FE1A0A0F1}" dt="2023-09-29T15:39:46.859" v="163" actId="165"/>
          <ac:grpSpMkLst>
            <pc:docMk/>
            <pc:sldMk cId="1922018481" sldId="259"/>
            <ac:grpSpMk id="4" creationId="{75E551FF-1AE3-CF91-E355-F9FC5A942417}"/>
          </ac:grpSpMkLst>
        </pc:grpChg>
        <pc:grpChg chg="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5" creationId="{EF29DC0F-6DA6-24B4-A55D-85590C95C3AC}"/>
          </ac:grpSpMkLst>
        </pc:grpChg>
        <pc:grpChg chg="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6" creationId="{BE94CE84-E757-332D-F013-39D7716D43A0}"/>
          </ac:grpSpMkLst>
        </pc:grpChg>
        <pc:grpChg chg="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8" creationId="{EB169E5D-6B11-94FD-6732-8DF971778CD5}"/>
          </ac:grpSpMkLst>
        </pc:grpChg>
        <pc:grpChg chg="add 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0" creationId="{C915B7F9-64C2-2F19-C78F-44E322844756}"/>
          </ac:grpSpMkLst>
        </pc:grpChg>
        <pc:grpChg chg="add 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1" creationId="{7547195E-A0C9-AC58-AB7E-580A95357F56}"/>
          </ac:grpSpMkLst>
        </pc:grpChg>
        <pc:grpChg chg="add mod or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2" creationId="{910E7BF5-C35B-EE00-0FDF-B123BC280175}"/>
          </ac:grpSpMkLst>
        </pc:grpChg>
        <pc:grpChg chg="add 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3" creationId="{854B3BCD-3772-48D7-26CE-EB8D630F1AEF}"/>
          </ac:grpSpMkLst>
        </pc:grpChg>
        <pc:grpChg chg="add mod">
          <ac:chgData name="Igudesman, Daria" userId="8ae08701-45ed-449c-a1ee-539f157c68ca" providerId="ADAL" clId="{E792F027-F17D-4624-80F5-D08FE1A0A0F1}" dt="2023-09-29T15:44:46.231" v="293" actId="164"/>
          <ac:grpSpMkLst>
            <pc:docMk/>
            <pc:sldMk cId="1922018481" sldId="259"/>
            <ac:grpSpMk id="14" creationId="{5C58C626-5000-9662-A99A-67A4E6DECBED}"/>
          </ac:grpSpMkLst>
        </pc:grpChg>
        <pc:grpChg chg="add 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5" creationId="{605B47AF-C960-69AD-E104-6EAAD466D4C9}"/>
          </ac:grpSpMkLst>
        </pc:grpChg>
        <pc:grpChg chg="add 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6" creationId="{D9218F8A-CD56-7766-0E40-923A66E57B6B}"/>
          </ac:grpSpMkLst>
        </pc:grpChg>
        <pc:grpChg chg="mod topLvl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12" creationId="{832D8B2E-D2BB-EC1C-DE40-DCDB7FC84AD4}"/>
          </ac:grpSpMkLst>
        </pc:grpChg>
        <pc:grpChg chg="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14" creationId="{780C2F0D-1D9C-E73A-72DB-B468AE58AB59}"/>
          </ac:grpSpMkLst>
        </pc:grpChg>
        <pc:grpChg chg="mod topLvl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29" creationId="{16FB32BF-3AE1-A397-0D0A-26560515A106}"/>
          </ac:grpSpMkLst>
        </pc:grpChg>
        <pc:grpChg chg="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31" creationId="{83F5AC2A-A206-7C78-CD60-812B8D7C000C}"/>
          </ac:grpSpMkLst>
        </pc:grpChg>
        <pc:grpChg chg="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32" creationId="{33B38EE1-2244-6BC6-4269-536100B47475}"/>
          </ac:grpSpMkLst>
        </pc:grpChg>
        <pc:grpChg chg="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36" creationId="{C7B2F699-5D54-821C-D25C-28B770AF6D9A}"/>
          </ac:grpSpMkLst>
        </pc:grpChg>
        <pc:grpChg chg="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38" creationId="{6904F9C6-546F-65C1-676E-9632CE88E135}"/>
          </ac:grpSpMkLst>
        </pc:grpChg>
        <pc:grpChg chg="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41" creationId="{79A462D0-825C-05CB-01B2-46540F6E5F2F}"/>
          </ac:grpSpMkLst>
        </pc:grpChg>
        <pc:grpChg chg="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42" creationId="{32767BB3-E6BD-809D-F404-63ABFA6F5E41}"/>
          </ac:grpSpMkLst>
        </pc:grpChg>
        <pc:grpChg chg="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44" creationId="{4F11672D-64F9-94DD-13E7-A0A9B6E04A4F}"/>
          </ac:grpSpMkLst>
        </pc:grpChg>
        <pc:grpChg chg="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45" creationId="{7B2464FF-4209-8D72-F95D-87C876FD1A8D}"/>
          </ac:grpSpMkLst>
        </pc:grpChg>
        <pc:grpChg chg="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46" creationId="{9713FC86-770A-D0D5-0908-7485F097FA96}"/>
          </ac:grpSpMkLst>
        </pc:grpChg>
        <pc:grpChg chg="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47" creationId="{F049F63A-19B9-24AE-7E78-5451B8B7A2E7}"/>
          </ac:grpSpMkLst>
        </pc:grpChg>
        <pc:grpChg chg="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48" creationId="{33127B13-17BD-0E33-812C-C25C1D2C7069}"/>
          </ac:grpSpMkLst>
        </pc:grpChg>
        <pc:grpChg chg="add del mod topLvl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70" creationId="{028D3765-4ABD-80A0-C44E-A51731CD2BC7}"/>
          </ac:grpSpMkLst>
        </pc:grpChg>
        <pc:grpChg chg="add del mod topLvl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71" creationId="{A184804E-31B4-9137-168E-02BFCF6D3C3E}"/>
          </ac:grpSpMkLst>
        </pc:grpChg>
        <pc:grpChg chg="mod topLvl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79" creationId="{B8772E69-AE5C-E67A-D82F-780560019ED9}"/>
          </ac:grpSpMkLst>
        </pc:grpChg>
        <pc:grpChg chg="mod ord topLvl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85" creationId="{6C86BAF1-C36B-5757-B5BE-FBE50555B867}"/>
          </ac:grpSpMkLst>
        </pc:grpChg>
        <pc:grpChg chg="mod">
          <ac:chgData name="Igudesman, Daria" userId="8ae08701-45ed-449c-a1ee-539f157c68ca" providerId="ADAL" clId="{E792F027-F17D-4624-80F5-D08FE1A0A0F1}" dt="2023-09-29T15:55:32.043" v="539" actId="1036"/>
          <ac:grpSpMkLst>
            <pc:docMk/>
            <pc:sldMk cId="1922018481" sldId="259"/>
            <ac:grpSpMk id="188" creationId="{4F5141C7-B13D-4699-1815-5940F4001011}"/>
          </ac:grpSpMkLst>
        </pc:grpChg>
        <pc:picChg chg="add mod ord">
          <ac:chgData name="Igudesman, Daria" userId="8ae08701-45ed-449c-a1ee-539f157c68ca" providerId="ADAL" clId="{E792F027-F17D-4624-80F5-D08FE1A0A0F1}" dt="2023-09-29T15:55:32.043" v="539" actId="1036"/>
          <ac:picMkLst>
            <pc:docMk/>
            <pc:sldMk cId="1922018481" sldId="259"/>
            <ac:picMk id="2" creationId="{AF68E2C5-CDAB-C3DD-5BE1-71CCF1E84967}"/>
          </ac:picMkLst>
        </pc:picChg>
        <pc:picChg chg="mod">
          <ac:chgData name="Igudesman, Daria" userId="8ae08701-45ed-449c-a1ee-539f157c68ca" providerId="ADAL" clId="{E792F027-F17D-4624-80F5-D08FE1A0A0F1}" dt="2023-09-29T15:55:32.043" v="539" actId="1036"/>
          <ac:picMkLst>
            <pc:docMk/>
            <pc:sldMk cId="1922018481" sldId="259"/>
            <ac:picMk id="116" creationId="{0C2DA943-5E64-31AE-355D-EEB82A63444C}"/>
          </ac:picMkLst>
        </pc:picChg>
        <pc:picChg chg="mod">
          <ac:chgData name="Igudesman, Daria" userId="8ae08701-45ed-449c-a1ee-539f157c68ca" providerId="ADAL" clId="{E792F027-F17D-4624-80F5-D08FE1A0A0F1}" dt="2023-09-29T15:55:32.043" v="539" actId="1036"/>
          <ac:picMkLst>
            <pc:docMk/>
            <pc:sldMk cId="1922018481" sldId="259"/>
            <ac:picMk id="117" creationId="{F1A54A08-BB7C-2366-5E85-C1D3FDD66670}"/>
          </ac:picMkLst>
        </pc:picChg>
        <pc:picChg chg="mod">
          <ac:chgData name="Igudesman, Daria" userId="8ae08701-45ed-449c-a1ee-539f157c68ca" providerId="ADAL" clId="{E792F027-F17D-4624-80F5-D08FE1A0A0F1}" dt="2023-09-29T15:55:32.043" v="539" actId="1036"/>
          <ac:picMkLst>
            <pc:docMk/>
            <pc:sldMk cId="1922018481" sldId="259"/>
            <ac:picMk id="118" creationId="{DC9B4335-E192-5651-D1F8-5D1D77AF817E}"/>
          </ac:picMkLst>
        </pc:picChg>
        <pc:picChg chg="mod">
          <ac:chgData name="Igudesman, Daria" userId="8ae08701-45ed-449c-a1ee-539f157c68ca" providerId="ADAL" clId="{E792F027-F17D-4624-80F5-D08FE1A0A0F1}" dt="2023-09-29T15:55:32.043" v="539" actId="1036"/>
          <ac:picMkLst>
            <pc:docMk/>
            <pc:sldMk cId="1922018481" sldId="259"/>
            <ac:picMk id="119" creationId="{4D839F16-0A01-73C5-4C24-ED70CA6AEBDE}"/>
          </ac:picMkLst>
        </pc:picChg>
        <pc:picChg chg="mod">
          <ac:chgData name="Igudesman, Daria" userId="8ae08701-45ed-449c-a1ee-539f157c68ca" providerId="ADAL" clId="{E792F027-F17D-4624-80F5-D08FE1A0A0F1}" dt="2023-09-29T15:55:32.043" v="539" actId="1036"/>
          <ac:picMkLst>
            <pc:docMk/>
            <pc:sldMk cId="1922018481" sldId="259"/>
            <ac:picMk id="120" creationId="{93C314DA-8638-063B-CEBB-09CA4DAD19FA}"/>
          </ac:picMkLst>
        </pc:picChg>
        <pc:picChg chg="mod">
          <ac:chgData name="Igudesman, Daria" userId="8ae08701-45ed-449c-a1ee-539f157c68ca" providerId="ADAL" clId="{E792F027-F17D-4624-80F5-D08FE1A0A0F1}" dt="2023-09-29T15:55:32.043" v="539" actId="1036"/>
          <ac:picMkLst>
            <pc:docMk/>
            <pc:sldMk cId="1922018481" sldId="259"/>
            <ac:picMk id="121" creationId="{816FA891-6459-00F4-6AFD-F198A6DDAB79}"/>
          </ac:picMkLst>
        </pc:picChg>
        <pc:picChg chg="mod">
          <ac:chgData name="Igudesman, Daria" userId="8ae08701-45ed-449c-a1ee-539f157c68ca" providerId="ADAL" clId="{E792F027-F17D-4624-80F5-D08FE1A0A0F1}" dt="2023-09-29T15:55:32.043" v="539" actId="1036"/>
          <ac:picMkLst>
            <pc:docMk/>
            <pc:sldMk cId="1922018481" sldId="259"/>
            <ac:picMk id="137" creationId="{6E149A0C-D399-973A-BE0E-370F8B512A86}"/>
          </ac:picMkLst>
        </pc:picChg>
        <pc:picChg chg="add del mod topLvl">
          <ac:chgData name="Igudesman, Daria" userId="8ae08701-45ed-449c-a1ee-539f157c68ca" providerId="ADAL" clId="{E792F027-F17D-4624-80F5-D08FE1A0A0F1}" dt="2023-09-29T15:55:32.043" v="539" actId="1036"/>
          <ac:picMkLst>
            <pc:docMk/>
            <pc:sldMk cId="1922018481" sldId="259"/>
            <ac:picMk id="172" creationId="{B538AC54-07C3-E6A1-980C-B34CC0634775}"/>
          </ac:picMkLst>
        </pc:picChg>
        <pc:picChg chg="mod">
          <ac:chgData name="Igudesman, Daria" userId="8ae08701-45ed-449c-a1ee-539f157c68ca" providerId="ADAL" clId="{E792F027-F17D-4624-80F5-D08FE1A0A0F1}" dt="2023-09-29T15:55:32.043" v="539" actId="1036"/>
          <ac:picMkLst>
            <pc:docMk/>
            <pc:sldMk cId="1922018481" sldId="259"/>
            <ac:picMk id="173" creationId="{277CAFBC-4734-C4CE-A63B-600FE890BCDD}"/>
          </ac:picMkLst>
        </pc:picChg>
        <pc:picChg chg="mod">
          <ac:chgData name="Igudesman, Daria" userId="8ae08701-45ed-449c-a1ee-539f157c68ca" providerId="ADAL" clId="{E792F027-F17D-4624-80F5-D08FE1A0A0F1}" dt="2023-09-29T15:55:32.043" v="539" actId="1036"/>
          <ac:picMkLst>
            <pc:docMk/>
            <pc:sldMk cId="1922018481" sldId="259"/>
            <ac:picMk id="174" creationId="{64D5C3D3-DEE3-D125-B1CB-063A9B001996}"/>
          </ac:picMkLst>
        </pc:picChg>
        <pc:picChg chg="mod topLvl">
          <ac:chgData name="Igudesman, Daria" userId="8ae08701-45ed-449c-a1ee-539f157c68ca" providerId="ADAL" clId="{E792F027-F17D-4624-80F5-D08FE1A0A0F1}" dt="2023-09-29T15:55:32.043" v="539" actId="1036"/>
          <ac:picMkLst>
            <pc:docMk/>
            <pc:sldMk cId="1922018481" sldId="259"/>
            <ac:picMk id="180" creationId="{1E7B4C51-A75C-0461-9601-16881F740F8F}"/>
          </ac:picMkLst>
        </pc:picChg>
        <pc:picChg chg="mod">
          <ac:chgData name="Igudesman, Daria" userId="8ae08701-45ed-449c-a1ee-539f157c68ca" providerId="ADAL" clId="{E792F027-F17D-4624-80F5-D08FE1A0A0F1}" dt="2023-09-29T15:55:32.043" v="539" actId="1036"/>
          <ac:picMkLst>
            <pc:docMk/>
            <pc:sldMk cId="1922018481" sldId="259"/>
            <ac:picMk id="190" creationId="{CF5C4F49-29E1-BCCC-330E-7BB81E36AD13}"/>
          </ac:picMkLst>
        </pc:picChg>
        <pc:picChg chg="mod topLvl">
          <ac:chgData name="Igudesman, Daria" userId="8ae08701-45ed-449c-a1ee-539f157c68ca" providerId="ADAL" clId="{E792F027-F17D-4624-80F5-D08FE1A0A0F1}" dt="2023-09-29T15:55:32.043" v="539" actId="1036"/>
          <ac:picMkLst>
            <pc:docMk/>
            <pc:sldMk cId="1922018481" sldId="259"/>
            <ac:picMk id="195" creationId="{6077D78C-6415-EF9B-AB12-D4162C0D649D}"/>
          </ac:picMkLst>
        </pc:picChg>
        <pc:cxnChg chg="mod">
          <ac:chgData name="Igudesman, Daria" userId="8ae08701-45ed-449c-a1ee-539f157c68ca" providerId="ADAL" clId="{E792F027-F17D-4624-80F5-D08FE1A0A0F1}" dt="2023-09-29T15:55:32.043" v="539" actId="1036"/>
          <ac:cxnSpMkLst>
            <pc:docMk/>
            <pc:sldMk cId="1922018481" sldId="259"/>
            <ac:cxnSpMk id="134" creationId="{07FB5521-C05A-80F5-D01F-4F5149BB37E2}"/>
          </ac:cxnSpMkLst>
        </pc:cxnChg>
      </pc:sldChg>
      <pc:sldMasterChg chg="modSp modSldLayout">
        <pc:chgData name="Igudesman, Daria" userId="8ae08701-45ed-449c-a1ee-539f157c68ca" providerId="ADAL" clId="{E792F027-F17D-4624-80F5-D08FE1A0A0F1}" dt="2023-09-29T15:54:45.223" v="523"/>
        <pc:sldMasterMkLst>
          <pc:docMk/>
          <pc:sldMasterMk cId="4033719433" sldId="2147483720"/>
        </pc:sldMasterMkLst>
        <pc:spChg chg="mod">
          <ac:chgData name="Igudesman, Daria" userId="8ae08701-45ed-449c-a1ee-539f157c68ca" providerId="ADAL" clId="{E792F027-F17D-4624-80F5-D08FE1A0A0F1}" dt="2023-09-29T15:54:45.223" v="523"/>
          <ac:spMkLst>
            <pc:docMk/>
            <pc:sldMasterMk cId="4033719433" sldId="2147483720"/>
            <ac:spMk id="2" creationId="{00000000-0000-0000-0000-000000000000}"/>
          </ac:spMkLst>
        </pc:spChg>
        <pc:spChg chg="mod">
          <ac:chgData name="Igudesman, Daria" userId="8ae08701-45ed-449c-a1ee-539f157c68ca" providerId="ADAL" clId="{E792F027-F17D-4624-80F5-D08FE1A0A0F1}" dt="2023-09-29T15:54:45.223" v="523"/>
          <ac:spMkLst>
            <pc:docMk/>
            <pc:sldMasterMk cId="4033719433" sldId="2147483720"/>
            <ac:spMk id="3" creationId="{00000000-0000-0000-0000-000000000000}"/>
          </ac:spMkLst>
        </pc:spChg>
        <pc:spChg chg="mod">
          <ac:chgData name="Igudesman, Daria" userId="8ae08701-45ed-449c-a1ee-539f157c68ca" providerId="ADAL" clId="{E792F027-F17D-4624-80F5-D08FE1A0A0F1}" dt="2023-09-29T15:54:45.223" v="523"/>
          <ac:spMkLst>
            <pc:docMk/>
            <pc:sldMasterMk cId="4033719433" sldId="2147483720"/>
            <ac:spMk id="4" creationId="{00000000-0000-0000-0000-000000000000}"/>
          </ac:spMkLst>
        </pc:spChg>
        <pc:spChg chg="mod">
          <ac:chgData name="Igudesman, Daria" userId="8ae08701-45ed-449c-a1ee-539f157c68ca" providerId="ADAL" clId="{E792F027-F17D-4624-80F5-D08FE1A0A0F1}" dt="2023-09-29T15:54:45.223" v="523"/>
          <ac:spMkLst>
            <pc:docMk/>
            <pc:sldMasterMk cId="4033719433" sldId="2147483720"/>
            <ac:spMk id="5" creationId="{00000000-0000-0000-0000-000000000000}"/>
          </ac:spMkLst>
        </pc:spChg>
        <pc:spChg chg="mod">
          <ac:chgData name="Igudesman, Daria" userId="8ae08701-45ed-449c-a1ee-539f157c68ca" providerId="ADAL" clId="{E792F027-F17D-4624-80F5-D08FE1A0A0F1}" dt="2023-09-29T15:54:45.223" v="523"/>
          <ac:spMkLst>
            <pc:docMk/>
            <pc:sldMasterMk cId="4033719433" sldId="2147483720"/>
            <ac:spMk id="6" creationId="{00000000-0000-0000-0000-000000000000}"/>
          </ac:spMkLst>
        </pc:spChg>
        <pc:sldLayoutChg chg="modSp">
          <pc:chgData name="Igudesman, Daria" userId="8ae08701-45ed-449c-a1ee-539f157c68ca" providerId="ADAL" clId="{E792F027-F17D-4624-80F5-D08FE1A0A0F1}" dt="2023-09-29T15:54:45.223" v="523"/>
          <pc:sldLayoutMkLst>
            <pc:docMk/>
            <pc:sldMasterMk cId="4033719433" sldId="2147483720"/>
            <pc:sldLayoutMk cId="786292936" sldId="2147483721"/>
          </pc:sldLayoutMkLst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786292936" sldId="2147483721"/>
              <ac:spMk id="2" creationId="{00000000-0000-0000-0000-000000000000}"/>
            </ac:spMkLst>
          </pc:spChg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786292936" sldId="2147483721"/>
              <ac:spMk id="3" creationId="{00000000-0000-0000-0000-000000000000}"/>
            </ac:spMkLst>
          </pc:spChg>
        </pc:sldLayoutChg>
        <pc:sldLayoutChg chg="modSp">
          <pc:chgData name="Igudesman, Daria" userId="8ae08701-45ed-449c-a1ee-539f157c68ca" providerId="ADAL" clId="{E792F027-F17D-4624-80F5-D08FE1A0A0F1}" dt="2023-09-29T15:54:45.223" v="523"/>
          <pc:sldLayoutMkLst>
            <pc:docMk/>
            <pc:sldMasterMk cId="4033719433" sldId="2147483720"/>
            <pc:sldLayoutMk cId="190406443" sldId="2147483723"/>
          </pc:sldLayoutMkLst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190406443" sldId="2147483723"/>
              <ac:spMk id="2" creationId="{00000000-0000-0000-0000-000000000000}"/>
            </ac:spMkLst>
          </pc:spChg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190406443" sldId="2147483723"/>
              <ac:spMk id="3" creationId="{00000000-0000-0000-0000-000000000000}"/>
            </ac:spMkLst>
          </pc:spChg>
        </pc:sldLayoutChg>
        <pc:sldLayoutChg chg="modSp">
          <pc:chgData name="Igudesman, Daria" userId="8ae08701-45ed-449c-a1ee-539f157c68ca" providerId="ADAL" clId="{E792F027-F17D-4624-80F5-D08FE1A0A0F1}" dt="2023-09-29T15:54:45.223" v="523"/>
          <pc:sldLayoutMkLst>
            <pc:docMk/>
            <pc:sldMasterMk cId="4033719433" sldId="2147483720"/>
            <pc:sldLayoutMk cId="964621355" sldId="2147483724"/>
          </pc:sldLayoutMkLst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964621355" sldId="2147483724"/>
              <ac:spMk id="3" creationId="{00000000-0000-0000-0000-000000000000}"/>
            </ac:spMkLst>
          </pc:spChg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964621355" sldId="2147483724"/>
              <ac:spMk id="4" creationId="{00000000-0000-0000-0000-000000000000}"/>
            </ac:spMkLst>
          </pc:spChg>
        </pc:sldLayoutChg>
        <pc:sldLayoutChg chg="modSp">
          <pc:chgData name="Igudesman, Daria" userId="8ae08701-45ed-449c-a1ee-539f157c68ca" providerId="ADAL" clId="{E792F027-F17D-4624-80F5-D08FE1A0A0F1}" dt="2023-09-29T15:54:45.223" v="523"/>
          <pc:sldLayoutMkLst>
            <pc:docMk/>
            <pc:sldMasterMk cId="4033719433" sldId="2147483720"/>
            <pc:sldLayoutMk cId="4023419156" sldId="2147483725"/>
          </pc:sldLayoutMkLst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4023419156" sldId="2147483725"/>
              <ac:spMk id="2" creationId="{00000000-0000-0000-0000-000000000000}"/>
            </ac:spMkLst>
          </pc:spChg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4023419156" sldId="2147483725"/>
              <ac:spMk id="3" creationId="{00000000-0000-0000-0000-000000000000}"/>
            </ac:spMkLst>
          </pc:spChg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4023419156" sldId="2147483725"/>
              <ac:spMk id="4" creationId="{00000000-0000-0000-0000-000000000000}"/>
            </ac:spMkLst>
          </pc:spChg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4023419156" sldId="2147483725"/>
              <ac:spMk id="5" creationId="{00000000-0000-0000-0000-000000000000}"/>
            </ac:spMkLst>
          </pc:spChg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4023419156" sldId="2147483725"/>
              <ac:spMk id="6" creationId="{00000000-0000-0000-0000-000000000000}"/>
            </ac:spMkLst>
          </pc:spChg>
        </pc:sldLayoutChg>
        <pc:sldLayoutChg chg="modSp">
          <pc:chgData name="Igudesman, Daria" userId="8ae08701-45ed-449c-a1ee-539f157c68ca" providerId="ADAL" clId="{E792F027-F17D-4624-80F5-D08FE1A0A0F1}" dt="2023-09-29T15:54:45.223" v="523"/>
          <pc:sldLayoutMkLst>
            <pc:docMk/>
            <pc:sldMasterMk cId="4033719433" sldId="2147483720"/>
            <pc:sldLayoutMk cId="985242056" sldId="2147483728"/>
          </pc:sldLayoutMkLst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985242056" sldId="2147483728"/>
              <ac:spMk id="2" creationId="{00000000-0000-0000-0000-000000000000}"/>
            </ac:spMkLst>
          </pc:spChg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985242056" sldId="2147483728"/>
              <ac:spMk id="3" creationId="{00000000-0000-0000-0000-000000000000}"/>
            </ac:spMkLst>
          </pc:spChg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985242056" sldId="2147483728"/>
              <ac:spMk id="4" creationId="{00000000-0000-0000-0000-000000000000}"/>
            </ac:spMkLst>
          </pc:spChg>
        </pc:sldLayoutChg>
        <pc:sldLayoutChg chg="modSp">
          <pc:chgData name="Igudesman, Daria" userId="8ae08701-45ed-449c-a1ee-539f157c68ca" providerId="ADAL" clId="{E792F027-F17D-4624-80F5-D08FE1A0A0F1}" dt="2023-09-29T15:54:45.223" v="523"/>
          <pc:sldLayoutMkLst>
            <pc:docMk/>
            <pc:sldMasterMk cId="4033719433" sldId="2147483720"/>
            <pc:sldLayoutMk cId="2094742877" sldId="2147483729"/>
          </pc:sldLayoutMkLst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2094742877" sldId="2147483729"/>
              <ac:spMk id="2" creationId="{00000000-0000-0000-0000-000000000000}"/>
            </ac:spMkLst>
          </pc:spChg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2094742877" sldId="2147483729"/>
              <ac:spMk id="3" creationId="{00000000-0000-0000-0000-000000000000}"/>
            </ac:spMkLst>
          </pc:spChg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2094742877" sldId="2147483729"/>
              <ac:spMk id="4" creationId="{00000000-0000-0000-0000-000000000000}"/>
            </ac:spMkLst>
          </pc:spChg>
        </pc:sldLayoutChg>
        <pc:sldLayoutChg chg="modSp">
          <pc:chgData name="Igudesman, Daria" userId="8ae08701-45ed-449c-a1ee-539f157c68ca" providerId="ADAL" clId="{E792F027-F17D-4624-80F5-D08FE1A0A0F1}" dt="2023-09-29T15:54:45.223" v="523"/>
          <pc:sldLayoutMkLst>
            <pc:docMk/>
            <pc:sldMasterMk cId="4033719433" sldId="2147483720"/>
            <pc:sldLayoutMk cId="75533637" sldId="2147483731"/>
          </pc:sldLayoutMkLst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75533637" sldId="2147483731"/>
              <ac:spMk id="2" creationId="{00000000-0000-0000-0000-000000000000}"/>
            </ac:spMkLst>
          </pc:spChg>
          <pc:spChg chg="mod">
            <ac:chgData name="Igudesman, Daria" userId="8ae08701-45ed-449c-a1ee-539f157c68ca" providerId="ADAL" clId="{E792F027-F17D-4624-80F5-D08FE1A0A0F1}" dt="2023-09-29T15:54:45.223" v="523"/>
            <ac:spMkLst>
              <pc:docMk/>
              <pc:sldMasterMk cId="4033719433" sldId="2147483720"/>
              <pc:sldLayoutMk cId="75533637" sldId="2147483731"/>
              <ac:spMk id="3" creationId="{00000000-0000-0000-0000-000000000000}"/>
            </ac:spMkLst>
          </pc:spChg>
        </pc:sldLayoutChg>
      </pc:sldMasterChg>
    </pc:docChg>
  </pc:docChgLst>
  <pc:docChgLst>
    <pc:chgData name="Mucinski, Justine" userId="2c03fd17-7195-4ea0-94f8-d886f3058fbb" providerId="ADAL" clId="{3E956EAB-EE86-4CCF-8666-1AB2206F159A}"/>
    <pc:docChg chg="modSld">
      <pc:chgData name="Mucinski, Justine" userId="2c03fd17-7195-4ea0-94f8-d886f3058fbb" providerId="ADAL" clId="{3E956EAB-EE86-4CCF-8666-1AB2206F159A}" dt="2023-10-05T20:16:25.776" v="6" actId="1036"/>
      <pc:docMkLst>
        <pc:docMk/>
      </pc:docMkLst>
      <pc:sldChg chg="modSp mod">
        <pc:chgData name="Mucinski, Justine" userId="2c03fd17-7195-4ea0-94f8-d886f3058fbb" providerId="ADAL" clId="{3E956EAB-EE86-4CCF-8666-1AB2206F159A}" dt="2023-10-05T20:16:25.776" v="6" actId="1036"/>
        <pc:sldMkLst>
          <pc:docMk/>
          <pc:sldMk cId="1922018481" sldId="259"/>
        </pc:sldMkLst>
        <pc:spChg chg="mod">
          <ac:chgData name="Mucinski, Justine" userId="2c03fd17-7195-4ea0-94f8-d886f3058fbb" providerId="ADAL" clId="{3E956EAB-EE86-4CCF-8666-1AB2206F159A}" dt="2023-10-05T20:16:25.776" v="6" actId="1036"/>
          <ac:spMkLst>
            <pc:docMk/>
            <pc:sldMk cId="1922018481" sldId="259"/>
            <ac:spMk id="108" creationId="{481650F8-C064-7CFF-0196-A3E4892A25A3}"/>
          </ac:spMkLst>
        </pc:spChg>
        <pc:spChg chg="mod">
          <ac:chgData name="Mucinski, Justine" userId="2c03fd17-7195-4ea0-94f8-d886f3058fbb" providerId="ADAL" clId="{3E956EAB-EE86-4CCF-8666-1AB2206F159A}" dt="2023-10-05T20:16:01.254" v="0" actId="14100"/>
          <ac:spMkLst>
            <pc:docMk/>
            <pc:sldMk cId="1922018481" sldId="259"/>
            <ac:spMk id="162" creationId="{8458D39F-0580-771E-ABD9-351A9CDB2F93}"/>
          </ac:spMkLst>
        </pc:spChg>
        <pc:spChg chg="mod">
          <ac:chgData name="Mucinski, Justine" userId="2c03fd17-7195-4ea0-94f8-d886f3058fbb" providerId="ADAL" clId="{3E956EAB-EE86-4CCF-8666-1AB2206F159A}" dt="2023-10-05T20:16:06.226" v="2" actId="1076"/>
          <ac:spMkLst>
            <pc:docMk/>
            <pc:sldMk cId="1922018481" sldId="259"/>
            <ac:spMk id="164" creationId="{604185F5-B710-D47F-1F98-C691B4CD40BA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59B894-7086-4E6A-8046-12EFF296E675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23888" y="1143000"/>
            <a:ext cx="5610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E879A4-5C8F-4711-8780-DE03AAA7C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9185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11827" rtl="0" eaLnBrk="1" latinLnBrk="0" hangingPunct="1">
      <a:defRPr sz="934" kern="1200">
        <a:solidFill>
          <a:schemeClr val="tx1"/>
        </a:solidFill>
        <a:latin typeface="+mn-lt"/>
        <a:ea typeface="+mn-ea"/>
        <a:cs typeface="+mn-cs"/>
      </a:defRPr>
    </a:lvl1pPr>
    <a:lvl2pPr marL="355914" algn="l" defTabSz="711827" rtl="0" eaLnBrk="1" latinLnBrk="0" hangingPunct="1">
      <a:defRPr sz="934" kern="1200">
        <a:solidFill>
          <a:schemeClr val="tx1"/>
        </a:solidFill>
        <a:latin typeface="+mn-lt"/>
        <a:ea typeface="+mn-ea"/>
        <a:cs typeface="+mn-cs"/>
      </a:defRPr>
    </a:lvl2pPr>
    <a:lvl3pPr marL="711827" algn="l" defTabSz="711827" rtl="0" eaLnBrk="1" latinLnBrk="0" hangingPunct="1">
      <a:defRPr sz="934" kern="1200">
        <a:solidFill>
          <a:schemeClr val="tx1"/>
        </a:solidFill>
        <a:latin typeface="+mn-lt"/>
        <a:ea typeface="+mn-ea"/>
        <a:cs typeface="+mn-cs"/>
      </a:defRPr>
    </a:lvl3pPr>
    <a:lvl4pPr marL="1067740" algn="l" defTabSz="711827" rtl="0" eaLnBrk="1" latinLnBrk="0" hangingPunct="1">
      <a:defRPr sz="934" kern="1200">
        <a:solidFill>
          <a:schemeClr val="tx1"/>
        </a:solidFill>
        <a:latin typeface="+mn-lt"/>
        <a:ea typeface="+mn-ea"/>
        <a:cs typeface="+mn-cs"/>
      </a:defRPr>
    </a:lvl4pPr>
    <a:lvl5pPr marL="1423657" algn="l" defTabSz="711827" rtl="0" eaLnBrk="1" latinLnBrk="0" hangingPunct="1">
      <a:defRPr sz="934" kern="1200">
        <a:solidFill>
          <a:schemeClr val="tx1"/>
        </a:solidFill>
        <a:latin typeface="+mn-lt"/>
        <a:ea typeface="+mn-ea"/>
        <a:cs typeface="+mn-cs"/>
      </a:defRPr>
    </a:lvl5pPr>
    <a:lvl6pPr marL="1779573" algn="l" defTabSz="711827" rtl="0" eaLnBrk="1" latinLnBrk="0" hangingPunct="1">
      <a:defRPr sz="934" kern="1200">
        <a:solidFill>
          <a:schemeClr val="tx1"/>
        </a:solidFill>
        <a:latin typeface="+mn-lt"/>
        <a:ea typeface="+mn-ea"/>
        <a:cs typeface="+mn-cs"/>
      </a:defRPr>
    </a:lvl6pPr>
    <a:lvl7pPr marL="2135488" algn="l" defTabSz="711827" rtl="0" eaLnBrk="1" latinLnBrk="0" hangingPunct="1">
      <a:defRPr sz="934" kern="1200">
        <a:solidFill>
          <a:schemeClr val="tx1"/>
        </a:solidFill>
        <a:latin typeface="+mn-lt"/>
        <a:ea typeface="+mn-ea"/>
        <a:cs typeface="+mn-cs"/>
      </a:defRPr>
    </a:lvl7pPr>
    <a:lvl8pPr marL="2491402" algn="l" defTabSz="711827" rtl="0" eaLnBrk="1" latinLnBrk="0" hangingPunct="1">
      <a:defRPr sz="934" kern="1200">
        <a:solidFill>
          <a:schemeClr val="tx1"/>
        </a:solidFill>
        <a:latin typeface="+mn-lt"/>
        <a:ea typeface="+mn-ea"/>
        <a:cs typeface="+mn-cs"/>
      </a:defRPr>
    </a:lvl8pPr>
    <a:lvl9pPr marL="2847319" algn="l" defTabSz="711827" rtl="0" eaLnBrk="1" latinLnBrk="0" hangingPunct="1">
      <a:defRPr sz="93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23888" y="1143000"/>
            <a:ext cx="56102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BA3D24-D994-784C-A99B-C1025E2342C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5905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823066"/>
            <a:ext cx="6858000" cy="1750907"/>
          </a:xfrm>
        </p:spPr>
        <p:txBody>
          <a:bodyPr anchor="b"/>
          <a:lstStyle>
            <a:lvl1pPr algn="ctr">
              <a:defRPr sz="4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2641495"/>
            <a:ext cx="6858000" cy="1214225"/>
          </a:xfrm>
        </p:spPr>
        <p:txBody>
          <a:bodyPr/>
          <a:lstStyle>
            <a:lvl1pPr marL="0" indent="0" algn="ctr">
              <a:buNone/>
              <a:defRPr sz="1760"/>
            </a:lvl1pPr>
            <a:lvl2pPr marL="335265" indent="0" algn="ctr">
              <a:buNone/>
              <a:defRPr sz="1467"/>
            </a:lvl2pPr>
            <a:lvl3pPr marL="670530" indent="0" algn="ctr">
              <a:buNone/>
              <a:defRPr sz="1320"/>
            </a:lvl3pPr>
            <a:lvl4pPr marL="1005794" indent="0" algn="ctr">
              <a:buNone/>
              <a:defRPr sz="1173"/>
            </a:lvl4pPr>
            <a:lvl5pPr marL="1341059" indent="0" algn="ctr">
              <a:buNone/>
              <a:defRPr sz="1173"/>
            </a:lvl5pPr>
            <a:lvl6pPr marL="1676324" indent="0" algn="ctr">
              <a:buNone/>
              <a:defRPr sz="1173"/>
            </a:lvl6pPr>
            <a:lvl7pPr marL="2011589" indent="0" algn="ctr">
              <a:buNone/>
              <a:defRPr sz="1173"/>
            </a:lvl7pPr>
            <a:lvl8pPr marL="2346853" indent="0" algn="ctr">
              <a:buNone/>
              <a:defRPr sz="1173"/>
            </a:lvl8pPr>
            <a:lvl9pPr marL="2682118" indent="0" algn="ctr">
              <a:buNone/>
              <a:defRPr sz="117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E7745-F452-42B3-BDB5-75BA717D9D5E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1E0C3-8911-4006-9D78-2947A40A1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578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E7745-F452-42B3-BDB5-75BA717D9D5E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1E0C3-8911-4006-9D78-2947A40A1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995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267758"/>
            <a:ext cx="1971675" cy="42620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267758"/>
            <a:ext cx="5800725" cy="426201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E7745-F452-42B3-BDB5-75BA717D9D5E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1E0C3-8911-4006-9D78-2947A40A1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5690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E7745-F452-42B3-BDB5-75BA717D9D5E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1E0C3-8911-4006-9D78-2947A40A1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8286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253808"/>
            <a:ext cx="7886700" cy="2092007"/>
          </a:xfrm>
        </p:spPr>
        <p:txBody>
          <a:bodyPr anchor="b"/>
          <a:lstStyle>
            <a:lvl1pPr>
              <a:defRPr sz="4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365607"/>
            <a:ext cx="7886700" cy="1100137"/>
          </a:xfrm>
        </p:spPr>
        <p:txBody>
          <a:bodyPr/>
          <a:lstStyle>
            <a:lvl1pPr marL="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1pPr>
            <a:lvl2pPr marL="335265" indent="0">
              <a:buNone/>
              <a:defRPr sz="1467">
                <a:solidFill>
                  <a:schemeClr val="tx1">
                    <a:tint val="75000"/>
                  </a:schemeClr>
                </a:solidFill>
              </a:defRPr>
            </a:lvl2pPr>
            <a:lvl3pPr marL="67053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3pPr>
            <a:lvl4pPr marL="1005794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4pPr>
            <a:lvl5pPr marL="1341059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5pPr>
            <a:lvl6pPr marL="1676324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6pPr>
            <a:lvl7pPr marL="2011589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7pPr>
            <a:lvl8pPr marL="2346853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8pPr>
            <a:lvl9pPr marL="2682118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E7745-F452-42B3-BDB5-75BA717D9D5E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1E0C3-8911-4006-9D78-2947A40A1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715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338792"/>
            <a:ext cx="3886200" cy="319098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338792"/>
            <a:ext cx="3886200" cy="319098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E7745-F452-42B3-BDB5-75BA717D9D5E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1E0C3-8911-4006-9D78-2947A40A1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85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67758"/>
            <a:ext cx="7886700" cy="97208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232853"/>
            <a:ext cx="3868340" cy="604202"/>
          </a:xfrm>
        </p:spPr>
        <p:txBody>
          <a:bodyPr anchor="b"/>
          <a:lstStyle>
            <a:lvl1pPr marL="0" indent="0">
              <a:buNone/>
              <a:defRPr sz="1760" b="1"/>
            </a:lvl1pPr>
            <a:lvl2pPr marL="335265" indent="0">
              <a:buNone/>
              <a:defRPr sz="1467" b="1"/>
            </a:lvl2pPr>
            <a:lvl3pPr marL="670530" indent="0">
              <a:buNone/>
              <a:defRPr sz="1320" b="1"/>
            </a:lvl3pPr>
            <a:lvl4pPr marL="1005794" indent="0">
              <a:buNone/>
              <a:defRPr sz="1173" b="1"/>
            </a:lvl4pPr>
            <a:lvl5pPr marL="1341059" indent="0">
              <a:buNone/>
              <a:defRPr sz="1173" b="1"/>
            </a:lvl5pPr>
            <a:lvl6pPr marL="1676324" indent="0">
              <a:buNone/>
              <a:defRPr sz="1173" b="1"/>
            </a:lvl6pPr>
            <a:lvl7pPr marL="2011589" indent="0">
              <a:buNone/>
              <a:defRPr sz="1173" b="1"/>
            </a:lvl7pPr>
            <a:lvl8pPr marL="2346853" indent="0">
              <a:buNone/>
              <a:defRPr sz="1173" b="1"/>
            </a:lvl8pPr>
            <a:lvl9pPr marL="2682118" indent="0">
              <a:buNone/>
              <a:defRPr sz="117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837055"/>
            <a:ext cx="3868340" cy="270203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232853"/>
            <a:ext cx="3887391" cy="604202"/>
          </a:xfrm>
        </p:spPr>
        <p:txBody>
          <a:bodyPr anchor="b"/>
          <a:lstStyle>
            <a:lvl1pPr marL="0" indent="0">
              <a:buNone/>
              <a:defRPr sz="1760" b="1"/>
            </a:lvl1pPr>
            <a:lvl2pPr marL="335265" indent="0">
              <a:buNone/>
              <a:defRPr sz="1467" b="1"/>
            </a:lvl2pPr>
            <a:lvl3pPr marL="670530" indent="0">
              <a:buNone/>
              <a:defRPr sz="1320" b="1"/>
            </a:lvl3pPr>
            <a:lvl4pPr marL="1005794" indent="0">
              <a:buNone/>
              <a:defRPr sz="1173" b="1"/>
            </a:lvl4pPr>
            <a:lvl5pPr marL="1341059" indent="0">
              <a:buNone/>
              <a:defRPr sz="1173" b="1"/>
            </a:lvl5pPr>
            <a:lvl6pPr marL="1676324" indent="0">
              <a:buNone/>
              <a:defRPr sz="1173" b="1"/>
            </a:lvl6pPr>
            <a:lvl7pPr marL="2011589" indent="0">
              <a:buNone/>
              <a:defRPr sz="1173" b="1"/>
            </a:lvl7pPr>
            <a:lvl8pPr marL="2346853" indent="0">
              <a:buNone/>
              <a:defRPr sz="1173" b="1"/>
            </a:lvl8pPr>
            <a:lvl9pPr marL="2682118" indent="0">
              <a:buNone/>
              <a:defRPr sz="117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837055"/>
            <a:ext cx="3887391" cy="270203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E7745-F452-42B3-BDB5-75BA717D9D5E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1E0C3-8911-4006-9D78-2947A40A1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7442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E7745-F452-42B3-BDB5-75BA717D9D5E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1E0C3-8911-4006-9D78-2947A40A1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199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E7745-F452-42B3-BDB5-75BA717D9D5E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1E0C3-8911-4006-9D78-2947A40A1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303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35280"/>
            <a:ext cx="2949178" cy="1173480"/>
          </a:xfrm>
        </p:spPr>
        <p:txBody>
          <a:bodyPr anchor="b"/>
          <a:lstStyle>
            <a:lvl1pPr>
              <a:defRPr sz="23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724112"/>
            <a:ext cx="4629150" cy="3573992"/>
          </a:xfrm>
        </p:spPr>
        <p:txBody>
          <a:bodyPr/>
          <a:lstStyle>
            <a:lvl1pPr>
              <a:defRPr sz="2347"/>
            </a:lvl1pPr>
            <a:lvl2pPr>
              <a:defRPr sz="2053"/>
            </a:lvl2pPr>
            <a:lvl3pPr>
              <a:defRPr sz="1760"/>
            </a:lvl3pPr>
            <a:lvl4pPr>
              <a:defRPr sz="1467"/>
            </a:lvl4pPr>
            <a:lvl5pPr>
              <a:defRPr sz="1467"/>
            </a:lvl5pPr>
            <a:lvl6pPr>
              <a:defRPr sz="1467"/>
            </a:lvl6pPr>
            <a:lvl7pPr>
              <a:defRPr sz="1467"/>
            </a:lvl7pPr>
            <a:lvl8pPr>
              <a:defRPr sz="1467"/>
            </a:lvl8pPr>
            <a:lvl9pPr>
              <a:defRPr sz="14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08760"/>
            <a:ext cx="2949178" cy="2795165"/>
          </a:xfrm>
        </p:spPr>
        <p:txBody>
          <a:bodyPr/>
          <a:lstStyle>
            <a:lvl1pPr marL="0" indent="0">
              <a:buNone/>
              <a:defRPr sz="1173"/>
            </a:lvl1pPr>
            <a:lvl2pPr marL="335265" indent="0">
              <a:buNone/>
              <a:defRPr sz="1027"/>
            </a:lvl2pPr>
            <a:lvl3pPr marL="670530" indent="0">
              <a:buNone/>
              <a:defRPr sz="880"/>
            </a:lvl3pPr>
            <a:lvl4pPr marL="1005794" indent="0">
              <a:buNone/>
              <a:defRPr sz="733"/>
            </a:lvl4pPr>
            <a:lvl5pPr marL="1341059" indent="0">
              <a:buNone/>
              <a:defRPr sz="733"/>
            </a:lvl5pPr>
            <a:lvl6pPr marL="1676324" indent="0">
              <a:buNone/>
              <a:defRPr sz="733"/>
            </a:lvl6pPr>
            <a:lvl7pPr marL="2011589" indent="0">
              <a:buNone/>
              <a:defRPr sz="733"/>
            </a:lvl7pPr>
            <a:lvl8pPr marL="2346853" indent="0">
              <a:buNone/>
              <a:defRPr sz="733"/>
            </a:lvl8pPr>
            <a:lvl9pPr marL="2682118" indent="0">
              <a:buNone/>
              <a:defRPr sz="7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E7745-F452-42B3-BDB5-75BA717D9D5E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1E0C3-8911-4006-9D78-2947A40A1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4408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35280"/>
            <a:ext cx="2949178" cy="1173480"/>
          </a:xfrm>
        </p:spPr>
        <p:txBody>
          <a:bodyPr anchor="b"/>
          <a:lstStyle>
            <a:lvl1pPr>
              <a:defRPr sz="23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724112"/>
            <a:ext cx="4629150" cy="3573992"/>
          </a:xfrm>
        </p:spPr>
        <p:txBody>
          <a:bodyPr anchor="t"/>
          <a:lstStyle>
            <a:lvl1pPr marL="0" indent="0">
              <a:buNone/>
              <a:defRPr sz="2347"/>
            </a:lvl1pPr>
            <a:lvl2pPr marL="335265" indent="0">
              <a:buNone/>
              <a:defRPr sz="2053"/>
            </a:lvl2pPr>
            <a:lvl3pPr marL="670530" indent="0">
              <a:buNone/>
              <a:defRPr sz="1760"/>
            </a:lvl3pPr>
            <a:lvl4pPr marL="1005794" indent="0">
              <a:buNone/>
              <a:defRPr sz="1467"/>
            </a:lvl4pPr>
            <a:lvl5pPr marL="1341059" indent="0">
              <a:buNone/>
              <a:defRPr sz="1467"/>
            </a:lvl5pPr>
            <a:lvl6pPr marL="1676324" indent="0">
              <a:buNone/>
              <a:defRPr sz="1467"/>
            </a:lvl6pPr>
            <a:lvl7pPr marL="2011589" indent="0">
              <a:buNone/>
              <a:defRPr sz="1467"/>
            </a:lvl7pPr>
            <a:lvl8pPr marL="2346853" indent="0">
              <a:buNone/>
              <a:defRPr sz="1467"/>
            </a:lvl8pPr>
            <a:lvl9pPr marL="2682118" indent="0">
              <a:buNone/>
              <a:defRPr sz="14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08760"/>
            <a:ext cx="2949178" cy="2795165"/>
          </a:xfrm>
        </p:spPr>
        <p:txBody>
          <a:bodyPr/>
          <a:lstStyle>
            <a:lvl1pPr marL="0" indent="0">
              <a:buNone/>
              <a:defRPr sz="1173"/>
            </a:lvl1pPr>
            <a:lvl2pPr marL="335265" indent="0">
              <a:buNone/>
              <a:defRPr sz="1027"/>
            </a:lvl2pPr>
            <a:lvl3pPr marL="670530" indent="0">
              <a:buNone/>
              <a:defRPr sz="880"/>
            </a:lvl3pPr>
            <a:lvl4pPr marL="1005794" indent="0">
              <a:buNone/>
              <a:defRPr sz="733"/>
            </a:lvl4pPr>
            <a:lvl5pPr marL="1341059" indent="0">
              <a:buNone/>
              <a:defRPr sz="733"/>
            </a:lvl5pPr>
            <a:lvl6pPr marL="1676324" indent="0">
              <a:buNone/>
              <a:defRPr sz="733"/>
            </a:lvl6pPr>
            <a:lvl7pPr marL="2011589" indent="0">
              <a:buNone/>
              <a:defRPr sz="733"/>
            </a:lvl7pPr>
            <a:lvl8pPr marL="2346853" indent="0">
              <a:buNone/>
              <a:defRPr sz="733"/>
            </a:lvl8pPr>
            <a:lvl9pPr marL="2682118" indent="0">
              <a:buNone/>
              <a:defRPr sz="7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E7745-F452-42B3-BDB5-75BA717D9D5E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51E0C3-8911-4006-9D78-2947A40A1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5055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267758"/>
            <a:ext cx="7886700" cy="97208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338792"/>
            <a:ext cx="7886700" cy="319098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4661324"/>
            <a:ext cx="2057400" cy="2677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BE7745-F452-42B3-BDB5-75BA717D9D5E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4661324"/>
            <a:ext cx="3086100" cy="2677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4661324"/>
            <a:ext cx="2057400" cy="2677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51E0C3-8911-4006-9D78-2947A40A1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795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70530" rtl="0" eaLnBrk="1" latinLnBrk="0" hangingPunct="1">
        <a:lnSpc>
          <a:spcPct val="90000"/>
        </a:lnSpc>
        <a:spcBef>
          <a:spcPct val="0"/>
        </a:spcBef>
        <a:buNone/>
        <a:defRPr sz="322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7632" indent="-167632" algn="l" defTabSz="67053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053" kern="1200">
          <a:solidFill>
            <a:schemeClr val="tx1"/>
          </a:solidFill>
          <a:latin typeface="+mn-lt"/>
          <a:ea typeface="+mn-ea"/>
          <a:cs typeface="+mn-cs"/>
        </a:defRPr>
      </a:lvl1pPr>
      <a:lvl2pPr marL="502897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760" kern="1200">
          <a:solidFill>
            <a:schemeClr val="tx1"/>
          </a:solidFill>
          <a:latin typeface="+mn-lt"/>
          <a:ea typeface="+mn-ea"/>
          <a:cs typeface="+mn-cs"/>
        </a:defRPr>
      </a:lvl2pPr>
      <a:lvl3pPr marL="838162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467" kern="1200">
          <a:solidFill>
            <a:schemeClr val="tx1"/>
          </a:solidFill>
          <a:latin typeface="+mn-lt"/>
          <a:ea typeface="+mn-ea"/>
          <a:cs typeface="+mn-cs"/>
        </a:defRPr>
      </a:lvl3pPr>
      <a:lvl4pPr marL="1173427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4pPr>
      <a:lvl5pPr marL="1508691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5pPr>
      <a:lvl6pPr marL="1843956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6pPr>
      <a:lvl7pPr marL="2179221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7pPr>
      <a:lvl8pPr marL="2514486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8pPr>
      <a:lvl9pPr marL="2849750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1pPr>
      <a:lvl2pPr marL="335265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2pPr>
      <a:lvl3pPr marL="670530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3pPr>
      <a:lvl4pPr marL="1005794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4pPr>
      <a:lvl5pPr marL="1341059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5pPr>
      <a:lvl6pPr marL="1676324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6pPr>
      <a:lvl7pPr marL="2011589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7pPr>
      <a:lvl8pPr marL="2346853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8pPr>
      <a:lvl9pPr marL="2682118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9.png"/><Relationship Id="rId18" Type="http://schemas.openxmlformats.org/officeDocument/2006/relationships/image" Target="../media/image12.png"/><Relationship Id="rId3" Type="http://schemas.openxmlformats.org/officeDocument/2006/relationships/image" Target="../media/image1.png"/><Relationship Id="rId21" Type="http://schemas.microsoft.com/office/2007/relationships/hdphoto" Target="../media/hdphoto6.wdp"/><Relationship Id="rId7" Type="http://schemas.openxmlformats.org/officeDocument/2006/relationships/image" Target="../media/image4.png"/><Relationship Id="rId12" Type="http://schemas.openxmlformats.org/officeDocument/2006/relationships/image" Target="../media/image8.png"/><Relationship Id="rId17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6" Type="http://schemas.microsoft.com/office/2007/relationships/hdphoto" Target="../media/hdphoto4.wdp"/><Relationship Id="rId20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11" Type="http://schemas.openxmlformats.org/officeDocument/2006/relationships/image" Target="../media/image7.png"/><Relationship Id="rId5" Type="http://schemas.openxmlformats.org/officeDocument/2006/relationships/image" Target="../media/image3.png"/><Relationship Id="rId15" Type="http://schemas.openxmlformats.org/officeDocument/2006/relationships/image" Target="../media/image10.png"/><Relationship Id="rId23" Type="http://schemas.microsoft.com/office/2007/relationships/hdphoto" Target="../media/hdphoto7.wdp"/><Relationship Id="rId10" Type="http://schemas.openxmlformats.org/officeDocument/2006/relationships/image" Target="../media/image6.png"/><Relationship Id="rId19" Type="http://schemas.microsoft.com/office/2007/relationships/hdphoto" Target="../media/hdphoto5.wdp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microsoft.com/office/2007/relationships/hdphoto" Target="../media/hdphoto3.wdp"/><Relationship Id="rId22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F68E2C5-CDAB-C3DD-5BE1-71CCF1E84967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 rot="10800000">
            <a:off x="0" y="700504"/>
            <a:ext cx="9143998" cy="3966081"/>
          </a:xfrm>
          <a:prstGeom prst="rect">
            <a:avLst/>
          </a:prstGeom>
        </p:spPr>
      </p:pic>
      <p:grpSp>
        <p:nvGrpSpPr>
          <p:cNvPr id="12" name="Group 11">
            <a:extLst>
              <a:ext uri="{FF2B5EF4-FFF2-40B4-BE49-F238E27FC236}">
                <a16:creationId xmlns:a16="http://schemas.microsoft.com/office/drawing/2014/main" id="{910E7BF5-C35B-EE00-0FDF-B123BC280175}"/>
              </a:ext>
            </a:extLst>
          </p:cNvPr>
          <p:cNvGrpSpPr/>
          <p:nvPr/>
        </p:nvGrpSpPr>
        <p:grpSpPr>
          <a:xfrm>
            <a:off x="4111163" y="805420"/>
            <a:ext cx="1477486" cy="1056417"/>
            <a:chOff x="3908626" y="1151572"/>
            <a:chExt cx="1477486" cy="1056417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7547195E-A0C9-AC58-AB7E-580A95357F56}"/>
                </a:ext>
              </a:extLst>
            </p:cNvPr>
            <p:cNvGrpSpPr/>
            <p:nvPr/>
          </p:nvGrpSpPr>
          <p:grpSpPr>
            <a:xfrm>
              <a:off x="3908626" y="1184287"/>
              <a:ext cx="1477486" cy="1014818"/>
              <a:chOff x="3908626" y="1184287"/>
              <a:chExt cx="1477486" cy="1014818"/>
            </a:xfrm>
          </p:grpSpPr>
          <p:sp>
            <p:nvSpPr>
              <p:cNvPr id="177" name="Isosceles Triangle 176">
                <a:extLst>
                  <a:ext uri="{FF2B5EF4-FFF2-40B4-BE49-F238E27FC236}">
                    <a16:creationId xmlns:a16="http://schemas.microsoft.com/office/drawing/2014/main" id="{4F51A89D-A0AE-346B-09AD-1153F0C76EFC}"/>
                  </a:ext>
                </a:extLst>
              </p:cNvPr>
              <p:cNvSpPr/>
              <p:nvPr/>
            </p:nvSpPr>
            <p:spPr>
              <a:xfrm rot="14816818">
                <a:off x="4043944" y="1703505"/>
                <a:ext cx="172838" cy="443474"/>
              </a:xfrm>
              <a:prstGeom prst="triangle">
                <a:avLst/>
              </a:prstGeom>
              <a:solidFill>
                <a:srgbClr val="FFABA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93" name="Rectangle: Rounded Corners 192">
                <a:extLst>
                  <a:ext uri="{FF2B5EF4-FFF2-40B4-BE49-F238E27FC236}">
                    <a16:creationId xmlns:a16="http://schemas.microsoft.com/office/drawing/2014/main" id="{35DE8228-52B3-B589-103C-83B639A49E38}"/>
                  </a:ext>
                </a:extLst>
              </p:cNvPr>
              <p:cNvSpPr/>
              <p:nvPr/>
            </p:nvSpPr>
            <p:spPr>
              <a:xfrm>
                <a:off x="4275181" y="1184287"/>
                <a:ext cx="1110931" cy="1014818"/>
              </a:xfrm>
              <a:prstGeom prst="roundRect">
                <a:avLst/>
              </a:prstGeom>
              <a:solidFill>
                <a:srgbClr val="FFEBE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20F69FF0-1B9C-2786-2CEA-29CBC93117FA}"/>
                </a:ext>
              </a:extLst>
            </p:cNvPr>
            <p:cNvSpPr txBox="1"/>
            <p:nvPr/>
          </p:nvSpPr>
          <p:spPr>
            <a:xfrm>
              <a:off x="4288349" y="1151572"/>
              <a:ext cx="109049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Muscle Fat Infiltration</a:t>
              </a:r>
            </a:p>
          </p:txBody>
        </p:sp>
        <p:pic>
          <p:nvPicPr>
            <p:cNvPr id="195" name="Picture 194" descr="A pink and yellow brain&#10;&#10;Description automatically generated with low confidence">
              <a:extLst>
                <a:ext uri="{FF2B5EF4-FFF2-40B4-BE49-F238E27FC236}">
                  <a16:creationId xmlns:a16="http://schemas.microsoft.com/office/drawing/2014/main" id="{6077D78C-6415-EF9B-AB12-D4162C0D64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73" t="21619" r="29362" b="16080"/>
            <a:stretch/>
          </p:blipFill>
          <p:spPr>
            <a:xfrm>
              <a:off x="4416854" y="1562083"/>
              <a:ext cx="764636" cy="645906"/>
            </a:xfrm>
            <a:prstGeom prst="rect">
              <a:avLst/>
            </a:prstGeom>
          </p:spPr>
        </p:pic>
      </p:grpSp>
      <p:sp>
        <p:nvSpPr>
          <p:cNvPr id="9" name="TextBox 8"/>
          <p:cNvSpPr txBox="1"/>
          <p:nvPr/>
        </p:nvSpPr>
        <p:spPr>
          <a:xfrm>
            <a:off x="224257" y="18048"/>
            <a:ext cx="86711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</a:rPr>
              <a:t>Associations of Skeletal Muscle Mass, Muscle Fat, Mitochondrial Energetics, and Cardiorespiratory Fitness with Liver Fat Among Older Adult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74A93AB4-2BF1-73B6-0D97-4005CD52A6E4}"/>
              </a:ext>
            </a:extLst>
          </p:cNvPr>
          <p:cNvGrpSpPr/>
          <p:nvPr/>
        </p:nvGrpSpPr>
        <p:grpSpPr>
          <a:xfrm>
            <a:off x="6411121" y="1475280"/>
            <a:ext cx="2261619" cy="1879605"/>
            <a:chOff x="8123169" y="1299972"/>
            <a:chExt cx="1749121" cy="1706859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BE94CE84-E757-332D-F013-39D7716D43A0}"/>
                </a:ext>
              </a:extLst>
            </p:cNvPr>
            <p:cNvGrpSpPr/>
            <p:nvPr/>
          </p:nvGrpSpPr>
          <p:grpSpPr>
            <a:xfrm>
              <a:off x="8479737" y="1980523"/>
              <a:ext cx="1035230" cy="280626"/>
              <a:chOff x="8825053" y="2782650"/>
              <a:chExt cx="838166" cy="240276"/>
            </a:xfrm>
          </p:grpSpPr>
          <p:sp>
            <p:nvSpPr>
              <p:cNvPr id="104" name="Rectangle: Rounded Corners 103">
                <a:extLst>
                  <a:ext uri="{FF2B5EF4-FFF2-40B4-BE49-F238E27FC236}">
                    <a16:creationId xmlns:a16="http://schemas.microsoft.com/office/drawing/2014/main" id="{9DA2BD1B-7155-D7D4-F1EB-EAF343D1BD44}"/>
                  </a:ext>
                </a:extLst>
              </p:cNvPr>
              <p:cNvSpPr/>
              <p:nvPr/>
            </p:nvSpPr>
            <p:spPr>
              <a:xfrm>
                <a:off x="8825053" y="2785182"/>
                <a:ext cx="838166" cy="237744"/>
              </a:xfrm>
              <a:prstGeom prst="roundRect">
                <a:avLst/>
              </a:prstGeom>
              <a:solidFill>
                <a:srgbClr val="FFEBE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solidFill>
                    <a:schemeClr val="tx1"/>
                  </a:solidFill>
                </a:endParaRP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A47261E7-3E88-C978-98B8-56DDEC35443A}"/>
                  </a:ext>
                </a:extLst>
              </p:cNvPr>
              <p:cNvSpPr txBox="1"/>
              <p:nvPr/>
            </p:nvSpPr>
            <p:spPr>
              <a:xfrm>
                <a:off x="8825053" y="2782650"/>
                <a:ext cx="838166" cy="23930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Positive</a:t>
                </a:r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EB169E5D-6B11-94FD-6732-8DF971778CD5}"/>
                </a:ext>
              </a:extLst>
            </p:cNvPr>
            <p:cNvGrpSpPr/>
            <p:nvPr/>
          </p:nvGrpSpPr>
          <p:grpSpPr>
            <a:xfrm>
              <a:off x="8444557" y="2356834"/>
              <a:ext cx="1145737" cy="294500"/>
              <a:chOff x="8486036" y="3080599"/>
              <a:chExt cx="947324" cy="237744"/>
            </a:xfrm>
            <a:solidFill>
              <a:srgbClr val="E2F0D9"/>
            </a:solidFill>
          </p:grpSpPr>
          <p:sp>
            <p:nvSpPr>
              <p:cNvPr id="107" name="Rectangle: Rounded Corners 106">
                <a:extLst>
                  <a:ext uri="{FF2B5EF4-FFF2-40B4-BE49-F238E27FC236}">
                    <a16:creationId xmlns:a16="http://schemas.microsoft.com/office/drawing/2014/main" id="{3A963CD4-23FF-D1D6-E9EE-D9AEF76B0B48}"/>
                  </a:ext>
                </a:extLst>
              </p:cNvPr>
              <p:cNvSpPr/>
              <p:nvPr/>
            </p:nvSpPr>
            <p:spPr>
              <a:xfrm>
                <a:off x="8515121" y="3080599"/>
                <a:ext cx="855955" cy="237744"/>
              </a:xfrm>
              <a:prstGeom prst="round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solidFill>
                    <a:schemeClr val="tx1"/>
                  </a:solidFill>
                </a:endParaRP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481650F8-C064-7CFF-0196-A3E4892A25A3}"/>
                  </a:ext>
                </a:extLst>
              </p:cNvPr>
              <p:cNvSpPr txBox="1"/>
              <p:nvPr/>
            </p:nvSpPr>
            <p:spPr>
              <a:xfrm>
                <a:off x="8486036" y="3087087"/>
                <a:ext cx="947324" cy="22562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Negative</a:t>
                </a:r>
              </a:p>
            </p:txBody>
          </p:sp>
        </p:grp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EF29DC0F-6DA6-24B4-A55D-85590C95C3AC}"/>
                </a:ext>
              </a:extLst>
            </p:cNvPr>
            <p:cNvGrpSpPr/>
            <p:nvPr/>
          </p:nvGrpSpPr>
          <p:grpSpPr>
            <a:xfrm>
              <a:off x="8479737" y="2727000"/>
              <a:ext cx="1035232" cy="279831"/>
              <a:chOff x="8743085" y="3366093"/>
              <a:chExt cx="838168" cy="219865"/>
            </a:xfrm>
          </p:grpSpPr>
          <p:sp>
            <p:nvSpPr>
              <p:cNvPr id="166" name="Rectangle: Rounded Corners 165">
                <a:extLst>
                  <a:ext uri="{FF2B5EF4-FFF2-40B4-BE49-F238E27FC236}">
                    <a16:creationId xmlns:a16="http://schemas.microsoft.com/office/drawing/2014/main" id="{77E0000F-9218-7ABE-A68A-EBE1C9578E3C}"/>
                  </a:ext>
                </a:extLst>
              </p:cNvPr>
              <p:cNvSpPr/>
              <p:nvPr/>
            </p:nvSpPr>
            <p:spPr>
              <a:xfrm>
                <a:off x="8743085" y="3388104"/>
                <a:ext cx="838168" cy="197854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solidFill>
                    <a:schemeClr val="tx1"/>
                  </a:solidFill>
                </a:endParaRPr>
              </a:p>
            </p:txBody>
          </p:sp>
          <p:sp>
            <p:nvSpPr>
              <p:cNvPr id="167" name="TextBox 166">
                <a:extLst>
                  <a:ext uri="{FF2B5EF4-FFF2-40B4-BE49-F238E27FC236}">
                    <a16:creationId xmlns:a16="http://schemas.microsoft.com/office/drawing/2014/main" id="{57C6B827-FEDA-8557-9446-96A4291586D5}"/>
                  </a:ext>
                </a:extLst>
              </p:cNvPr>
              <p:cNvSpPr txBox="1"/>
              <p:nvPr/>
            </p:nvSpPr>
            <p:spPr>
              <a:xfrm>
                <a:off x="8804077" y="3366093"/>
                <a:ext cx="686704" cy="21959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Null</a:t>
                </a:r>
              </a:p>
            </p:txBody>
          </p:sp>
        </p:grpSp>
        <p:sp>
          <p:nvSpPr>
            <p:cNvPr id="192" name="Rectangle: Rounded Corners 191">
              <a:extLst>
                <a:ext uri="{FF2B5EF4-FFF2-40B4-BE49-F238E27FC236}">
                  <a16:creationId xmlns:a16="http://schemas.microsoft.com/office/drawing/2014/main" id="{6B3BEFFE-A5FC-C3AF-CCE4-B31BF1E562BE}"/>
                </a:ext>
              </a:extLst>
            </p:cNvPr>
            <p:cNvSpPr/>
            <p:nvPr/>
          </p:nvSpPr>
          <p:spPr>
            <a:xfrm>
              <a:off x="8179627" y="1322121"/>
              <a:ext cx="1625879" cy="447892"/>
            </a:xfrm>
            <a:prstGeom prst="roundRect">
              <a:avLst/>
            </a:prstGeom>
            <a:solidFill>
              <a:schemeClr val="bg1"/>
            </a:solidFill>
            <a:ln w="57150">
              <a:solidFill>
                <a:srgbClr val="DAE3F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904B4849-B1D6-05D6-2D80-8709A70F18B5}"/>
                </a:ext>
              </a:extLst>
            </p:cNvPr>
            <p:cNvSpPr txBox="1"/>
            <p:nvPr/>
          </p:nvSpPr>
          <p:spPr>
            <a:xfrm>
              <a:off x="8123169" y="1299972"/>
              <a:ext cx="1749121" cy="4751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Direction of Association N=378 Older Adults </a:t>
              </a:r>
            </a:p>
          </p:txBody>
        </p:sp>
      </p:grpSp>
      <p:sp>
        <p:nvSpPr>
          <p:cNvPr id="111" name="Isosceles Triangle 110">
            <a:extLst>
              <a:ext uri="{FF2B5EF4-FFF2-40B4-BE49-F238E27FC236}">
                <a16:creationId xmlns:a16="http://schemas.microsoft.com/office/drawing/2014/main" id="{E09EE04A-FB33-853C-0423-8D96C544EF06}"/>
              </a:ext>
            </a:extLst>
          </p:cNvPr>
          <p:cNvSpPr/>
          <p:nvPr/>
        </p:nvSpPr>
        <p:spPr>
          <a:xfrm>
            <a:off x="3109888" y="2834826"/>
            <a:ext cx="167527" cy="745420"/>
          </a:xfrm>
          <a:prstGeom prst="triangle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grpSp>
        <p:nvGrpSpPr>
          <p:cNvPr id="112" name="Group 111">
            <a:extLst>
              <a:ext uri="{FF2B5EF4-FFF2-40B4-BE49-F238E27FC236}">
                <a16:creationId xmlns:a16="http://schemas.microsoft.com/office/drawing/2014/main" id="{832D8B2E-D2BB-EC1C-DE40-DCDB7FC84AD4}"/>
              </a:ext>
            </a:extLst>
          </p:cNvPr>
          <p:cNvGrpSpPr/>
          <p:nvPr/>
        </p:nvGrpSpPr>
        <p:grpSpPr>
          <a:xfrm>
            <a:off x="2351511" y="3329338"/>
            <a:ext cx="1851800" cy="1250668"/>
            <a:chOff x="1909061" y="2582043"/>
            <a:chExt cx="2021508" cy="1323330"/>
          </a:xfrm>
        </p:grpSpPr>
        <p:sp>
          <p:nvSpPr>
            <p:cNvPr id="113" name="Rectangle: Rounded Corners 112">
              <a:extLst>
                <a:ext uri="{FF2B5EF4-FFF2-40B4-BE49-F238E27FC236}">
                  <a16:creationId xmlns:a16="http://schemas.microsoft.com/office/drawing/2014/main" id="{0021E7A6-77F7-E271-E550-63FB67CE447A}"/>
                </a:ext>
              </a:extLst>
            </p:cNvPr>
            <p:cNvSpPr/>
            <p:nvPr/>
          </p:nvSpPr>
          <p:spPr>
            <a:xfrm>
              <a:off x="1994369" y="2582043"/>
              <a:ext cx="1763312" cy="1323329"/>
            </a:xfrm>
            <a:prstGeom prst="roundRect">
              <a:avLst/>
            </a:prstGeom>
            <a:solidFill>
              <a:srgbClr val="E2F0D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grpSp>
          <p:nvGrpSpPr>
            <p:cNvPr id="114" name="Group 113">
              <a:extLst>
                <a:ext uri="{FF2B5EF4-FFF2-40B4-BE49-F238E27FC236}">
                  <a16:creationId xmlns:a16="http://schemas.microsoft.com/office/drawing/2014/main" id="{780C2F0D-1D9C-E73A-72DB-B468AE58AB59}"/>
                </a:ext>
              </a:extLst>
            </p:cNvPr>
            <p:cNvGrpSpPr/>
            <p:nvPr/>
          </p:nvGrpSpPr>
          <p:grpSpPr>
            <a:xfrm>
              <a:off x="1909061" y="2646560"/>
              <a:ext cx="2021508" cy="1258813"/>
              <a:chOff x="1445648" y="2500450"/>
              <a:chExt cx="2021508" cy="1258813"/>
            </a:xfrm>
          </p:grpSpPr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889F2975-05DE-3433-6F43-12429EFF9BF0}"/>
                  </a:ext>
                </a:extLst>
              </p:cNvPr>
              <p:cNvSpPr txBox="1"/>
              <p:nvPr/>
            </p:nvSpPr>
            <p:spPr>
              <a:xfrm>
                <a:off x="1445648" y="3205645"/>
                <a:ext cx="2021508" cy="5536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Maximal Skeletal Muscle OXPHOS</a:t>
                </a:r>
                <a:r>
                  <a:rPr lang="en-US" sz="14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16" name="Picture 115">
                <a:extLst>
                  <a:ext uri="{FF2B5EF4-FFF2-40B4-BE49-F238E27FC236}">
                    <a16:creationId xmlns:a16="http://schemas.microsoft.com/office/drawing/2014/main" id="{0C2DA943-5E64-31AE-355D-EEB82A63444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ackgroundRemoval t="9140" b="90323" l="3599" r="93830">
                            <a14:foregroundMark x1="23136" y1="18817" x2="13368" y2="83333"/>
                            <a14:foregroundMark x1="13368" y1="83333" x2="86118" y2="72581"/>
                            <a14:foregroundMark x1="86118" y1="72581" x2="64010" y2="14516"/>
                            <a14:foregroundMark x1="64010" y1="14516" x2="30077" y2="11828"/>
                            <a14:foregroundMark x1="30077" y1="11828" x2="16195" y2="23118"/>
                            <a14:foregroundMark x1="8483" y1="41398" x2="11825" y2="80645"/>
                            <a14:foregroundMark x1="9254" y1="80108" x2="6941" y2="47312"/>
                            <a14:foregroundMark x1="16195" y1="89247" x2="25450" y2="90323"/>
                            <a14:foregroundMark x1="20566" y1="54301" x2="53728" y2="39785"/>
                            <a14:foregroundMark x1="30077" y1="62903" x2="60154" y2="48925"/>
                            <a14:foregroundMark x1="60154" y1="48925" x2="60154" y2="48925"/>
                            <a14:foregroundMark x1="55270" y1="65591" x2="77635" y2="77419"/>
                            <a14:foregroundMark x1="59897" y1="44624" x2="79434" y2="68280"/>
                            <a14:foregroundMark x1="56041" y1="27419" x2="72237" y2="44086"/>
                            <a14:foregroundMark x1="27249" y1="31720" x2="56041" y2="30645"/>
                            <a14:foregroundMark x1="30334" y1="23656" x2="33933" y2="20968"/>
                            <a14:foregroundMark x1="88432" y1="35484" x2="94087" y2="55376"/>
                            <a14:foregroundMark x1="78663" y1="35484" x2="88946" y2="60215"/>
                            <a14:foregroundMark x1="3599" y1="55376" x2="4370" y2="62366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661400" y="2500450"/>
                <a:ext cx="1556500" cy="744239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17" name="Picture 116">
                <a:extLst>
                  <a:ext uri="{FF2B5EF4-FFF2-40B4-BE49-F238E27FC236}">
                    <a16:creationId xmlns:a16="http://schemas.microsoft.com/office/drawing/2014/main" id="{F1A54A08-BB7C-2366-5E85-C1D3FDD6667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alphaModFix/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ackgroundRemoval t="8642" b="66255" l="1745" r="17047">
                            <a14:foregroundMark x1="3624" y1="11523" x2="3087" y2="17284"/>
                            <a14:foregroundMark x1="3221" y1="15226" x2="3221" y2="21811"/>
                            <a14:foregroundMark x1="4430" y1="11111" x2="11812" y2="8642"/>
                            <a14:foregroundMark x1="11812" y1="8642" x2="12215" y2="8642"/>
                            <a14:foregroundMark x1="4564" y1="62551" x2="11946" y2="63786"/>
                            <a14:foregroundMark x1="11946" y1="63786" x2="12349" y2="63786"/>
                            <a14:foregroundMark x1="11812" y1="65844" x2="6711" y2="66255"/>
                          </a14:backgroundRemoval>
                        </a14:imgEffect>
                      </a14:imgLayer>
                    </a14:imgProps>
                  </a:ext>
                </a:extLst>
              </a:blip>
              <a:srcRect t="4058" r="81038" b="29681"/>
              <a:stretch/>
            </p:blipFill>
            <p:spPr>
              <a:xfrm rot="20804921">
                <a:off x="1880743" y="2886629"/>
                <a:ext cx="247419" cy="282010"/>
              </a:xfrm>
              <a:prstGeom prst="rect">
                <a:avLst/>
              </a:prstGeom>
            </p:spPr>
          </p:pic>
          <p:pic>
            <p:nvPicPr>
              <p:cNvPr id="118" name="Picture 117">
                <a:extLst>
                  <a:ext uri="{FF2B5EF4-FFF2-40B4-BE49-F238E27FC236}">
                    <a16:creationId xmlns:a16="http://schemas.microsoft.com/office/drawing/2014/main" id="{DC9B4335-E192-5651-D1F8-5D1D77AF817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ackgroundRemoval t="20165" b="54733" l="23893" r="37315">
                            <a14:foregroundMark x1="25369" y1="22634" x2="24832" y2="23457"/>
                            <a14:foregroundMark x1="24295" y1="26337" x2="24698" y2="48148"/>
                            <a14:foregroundMark x1="24698" y1="48148" x2="25369" y2="51440"/>
                            <a14:foregroundMark x1="24564" y1="47737" x2="23893" y2="34568"/>
                            <a14:foregroundMark x1="26443" y1="22634" x2="33691" y2="20576"/>
                            <a14:foregroundMark x1="33691" y1="20576" x2="37047" y2="39095"/>
                            <a14:foregroundMark x1="37047" y1="39095" x2="32483" y2="54733"/>
                            <a14:foregroundMark x1="32483" y1="54733" x2="26040" y2="52675"/>
                            <a14:foregroundMark x1="27651" y1="21399" x2="29396" y2="21399"/>
                            <a14:foregroundMark x1="29799" y1="20165" x2="31409" y2="20165"/>
                            <a14:foregroundMark x1="34899" y1="21399" x2="36644" y2="24691"/>
                            <a14:foregroundMark x1="36242" y1="25103" x2="37315" y2="33333"/>
                          </a14:backgroundRemoval>
                        </a14:imgEffect>
                      </a14:imgLayer>
                    </a14:imgProps>
                  </a:ext>
                </a:extLst>
              </a:blip>
              <a:srcRect l="23211" t="17854" r="61578" b="42505"/>
              <a:stretch/>
            </p:blipFill>
            <p:spPr>
              <a:xfrm rot="20490946">
                <a:off x="2096177" y="2950753"/>
                <a:ext cx="198478" cy="168713"/>
              </a:xfrm>
              <a:prstGeom prst="rect">
                <a:avLst/>
              </a:prstGeom>
            </p:spPr>
          </p:pic>
          <p:pic>
            <p:nvPicPr>
              <p:cNvPr id="119" name="Picture 118">
                <a:extLst>
                  <a:ext uri="{FF2B5EF4-FFF2-40B4-BE49-F238E27FC236}">
                    <a16:creationId xmlns:a16="http://schemas.microsoft.com/office/drawing/2014/main" id="{4D839F16-0A01-73C5-4C24-ED70CA6AEBD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ackgroundRemoval t="6996" b="65021" l="42819" r="52349">
                            <a14:foregroundMark x1="44295" y1="11111" x2="43490" y2="18519"/>
                            <a14:foregroundMark x1="44295" y1="9877" x2="50336" y2="9465"/>
                            <a14:foregroundMark x1="46980" y1="7407" x2="48322" y2="7407"/>
                            <a14:foregroundMark x1="50738" y1="9877" x2="51409" y2="16049"/>
                            <a14:foregroundMark x1="51678" y1="14815" x2="52349" y2="30864"/>
                            <a14:foregroundMark x1="52483" y1="27160" x2="52215" y2="44033"/>
                            <a14:foregroundMark x1="52215" y1="45267" x2="51007" y2="60082"/>
                            <a14:foregroundMark x1="51007" y1="59671" x2="46711" y2="65021"/>
                            <a14:foregroundMark x1="46174" y1="64609" x2="44027" y2="58436"/>
                          </a14:backgroundRemoval>
                        </a14:imgEffect>
                      </a14:imgLayer>
                    </a14:imgProps>
                  </a:ext>
                </a:extLst>
              </a:blip>
              <a:srcRect l="41973" t="4520" r="46169" b="32486"/>
              <a:stretch/>
            </p:blipFill>
            <p:spPr>
              <a:xfrm rot="21231918">
                <a:off x="2294655" y="2821761"/>
                <a:ext cx="154722" cy="268102"/>
              </a:xfrm>
              <a:prstGeom prst="rect">
                <a:avLst/>
              </a:prstGeom>
            </p:spPr>
          </p:pic>
          <p:pic>
            <p:nvPicPr>
              <p:cNvPr id="120" name="Picture 119">
                <a:extLst>
                  <a:ext uri="{FF2B5EF4-FFF2-40B4-BE49-F238E27FC236}">
                    <a16:creationId xmlns:a16="http://schemas.microsoft.com/office/drawing/2014/main" id="{93C314DA-8638-063B-CEBB-09CA4DAD19F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ackgroundRemoval t="46914" b="79424" l="58926" r="73960">
                            <a14:foregroundMark x1="59329" y1="52263" x2="61477" y2="49794"/>
                            <a14:foregroundMark x1="62416" y1="48560" x2="65369" y2="48148"/>
                            <a14:foregroundMark x1="64966" y1="46914" x2="67651" y2="46914"/>
                            <a14:foregroundMark x1="68591" y1="47325" x2="70738" y2="48560"/>
                            <a14:foregroundMark x1="71812" y1="49383" x2="73423" y2="54321"/>
                            <a14:foregroundMark x1="73960" y1="60905" x2="73154" y2="66667"/>
                            <a14:foregroundMark x1="73960" y1="63786" x2="71946" y2="71605"/>
                            <a14:foregroundMark x1="71812" y1="72840" x2="69396" y2="77366"/>
                            <a14:foregroundMark x1="68322" y1="78601" x2="64295" y2="78601"/>
                            <a14:foregroundMark x1="63624" y1="77366" x2="61342" y2="72016"/>
                            <a14:foregroundMark x1="60671" y1="71605" x2="59195" y2="66667"/>
                          </a14:backgroundRemoval>
                        </a14:imgEffect>
                      </a14:imgLayer>
                    </a14:imgProps>
                  </a:ext>
                </a:extLst>
              </a:blip>
              <a:srcRect l="57384" t="44327" r="24795" b="15786"/>
              <a:stretch/>
            </p:blipFill>
            <p:spPr>
              <a:xfrm rot="863091">
                <a:off x="2432506" y="2917095"/>
                <a:ext cx="268631" cy="196110"/>
              </a:xfrm>
              <a:prstGeom prst="rect">
                <a:avLst/>
              </a:prstGeom>
            </p:spPr>
          </p:pic>
          <p:pic>
            <p:nvPicPr>
              <p:cNvPr id="121" name="Picture 120">
                <a:extLst>
                  <a:ext uri="{FF2B5EF4-FFF2-40B4-BE49-F238E27FC236}">
                    <a16:creationId xmlns:a16="http://schemas.microsoft.com/office/drawing/2014/main" id="{816FA891-6459-00F4-6AFD-F198A6DDAB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ackgroundRemoval t="13992" b="76955" l="78658" r="95839">
                            <a14:foregroundMark x1="79060" y1="19753" x2="79866" y2="31687"/>
                            <a14:foregroundMark x1="79329" y1="18519" x2="80403" y2="17284"/>
                            <a14:foregroundMark x1="80940" y1="16049" x2="84564" y2="18107"/>
                            <a14:foregroundMark x1="91544" y1="14403" x2="95839" y2="21811"/>
                            <a14:foregroundMark x1="93691" y1="71605" x2="87383" y2="76132"/>
                            <a14:foregroundMark x1="78658" y1="23868" x2="79732" y2="32922"/>
                            <a14:foregroundMark x1="86174" y1="76955" x2="87651" y2="76955"/>
                          </a14:backgroundRemoval>
                        </a14:imgEffect>
                      </a14:imgLayer>
                    </a14:imgProps>
                  </a:ext>
                </a:extLst>
              </a:blip>
              <a:srcRect l="77855" t="10795" r="2730" b="19326"/>
              <a:stretch/>
            </p:blipFill>
            <p:spPr>
              <a:xfrm rot="984660">
                <a:off x="2682497" y="2878931"/>
                <a:ext cx="253342" cy="297401"/>
              </a:xfrm>
              <a:prstGeom prst="rect">
                <a:avLst/>
              </a:prstGeom>
            </p:spPr>
          </p:pic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4B7970E5-7323-8538-AE32-DBB67F98C343}"/>
                  </a:ext>
                </a:extLst>
              </p:cNvPr>
              <p:cNvSpPr txBox="1"/>
              <p:nvPr/>
            </p:nvSpPr>
            <p:spPr>
              <a:xfrm rot="20757109">
                <a:off x="1894740" y="2948736"/>
                <a:ext cx="211730" cy="1791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D6BC4DE0-D7EE-888C-3254-34F6FBC2B189}"/>
                  </a:ext>
                </a:extLst>
              </p:cNvPr>
              <p:cNvSpPr txBox="1"/>
              <p:nvPr/>
            </p:nvSpPr>
            <p:spPr>
              <a:xfrm rot="20362207">
                <a:off x="2073411" y="2935392"/>
                <a:ext cx="262816" cy="1791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II</a:t>
                </a:r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DAFEC0BE-B6CD-4AEB-1E12-D7D8D0DBC993}"/>
                  </a:ext>
                </a:extLst>
              </p:cNvPr>
              <p:cNvSpPr txBox="1"/>
              <p:nvPr/>
            </p:nvSpPr>
            <p:spPr>
              <a:xfrm rot="21383248">
                <a:off x="2241313" y="2868343"/>
                <a:ext cx="262816" cy="1791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III</a:t>
                </a: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BC227F3F-0D38-A434-42F6-D7B9CA1F82F3}"/>
                  </a:ext>
                </a:extLst>
              </p:cNvPr>
              <p:cNvSpPr txBox="1"/>
              <p:nvPr/>
            </p:nvSpPr>
            <p:spPr>
              <a:xfrm rot="959376">
                <a:off x="2352341" y="2930565"/>
                <a:ext cx="442087" cy="1465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3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to</a:t>
                </a:r>
                <a:r>
                  <a:rPr lang="en-US" sz="3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</a:t>
                </a: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5FACF7F6-ECF9-C015-7C40-88180965D983}"/>
                  </a:ext>
                </a:extLst>
              </p:cNvPr>
              <p:cNvSpPr txBox="1"/>
              <p:nvPr/>
            </p:nvSpPr>
            <p:spPr>
              <a:xfrm rot="723523">
                <a:off x="2681314" y="2955024"/>
                <a:ext cx="290366" cy="1791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IV</a:t>
                </a:r>
              </a:p>
            </p:txBody>
          </p:sp>
        </p:grp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D9218F8A-CD56-7766-0E40-923A66E57B6B}"/>
              </a:ext>
            </a:extLst>
          </p:cNvPr>
          <p:cNvGrpSpPr/>
          <p:nvPr/>
        </p:nvGrpSpPr>
        <p:grpSpPr>
          <a:xfrm>
            <a:off x="3734450" y="2140259"/>
            <a:ext cx="1861985" cy="1521431"/>
            <a:chOff x="3307383" y="2395990"/>
            <a:chExt cx="1861985" cy="1521431"/>
          </a:xfrm>
        </p:grpSpPr>
        <p:sp>
          <p:nvSpPr>
            <p:cNvPr id="128" name="Isosceles Triangle 127">
              <a:extLst>
                <a:ext uri="{FF2B5EF4-FFF2-40B4-BE49-F238E27FC236}">
                  <a16:creationId xmlns:a16="http://schemas.microsoft.com/office/drawing/2014/main" id="{619D83FF-0D4D-2327-9F60-F6490A69573B}"/>
                </a:ext>
              </a:extLst>
            </p:cNvPr>
            <p:cNvSpPr/>
            <p:nvPr/>
          </p:nvSpPr>
          <p:spPr>
            <a:xfrm rot="17610993">
              <a:off x="3676697" y="2410178"/>
              <a:ext cx="173869" cy="912497"/>
            </a:xfrm>
            <a:prstGeom prst="triangle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grpSp>
          <p:nvGrpSpPr>
            <p:cNvPr id="129" name="Group 128">
              <a:extLst>
                <a:ext uri="{FF2B5EF4-FFF2-40B4-BE49-F238E27FC236}">
                  <a16:creationId xmlns:a16="http://schemas.microsoft.com/office/drawing/2014/main" id="{16FB32BF-3AE1-A397-0D0A-26560515A106}"/>
                </a:ext>
              </a:extLst>
            </p:cNvPr>
            <p:cNvGrpSpPr/>
            <p:nvPr/>
          </p:nvGrpSpPr>
          <p:grpSpPr>
            <a:xfrm>
              <a:off x="4078874" y="2395990"/>
              <a:ext cx="1090494" cy="1521431"/>
              <a:chOff x="4126992" y="598177"/>
              <a:chExt cx="1331837" cy="1893437"/>
            </a:xfrm>
          </p:grpSpPr>
          <p:sp>
            <p:nvSpPr>
              <p:cNvPr id="130" name="Rectangle: Rounded Corners 129">
                <a:extLst>
                  <a:ext uri="{FF2B5EF4-FFF2-40B4-BE49-F238E27FC236}">
                    <a16:creationId xmlns:a16="http://schemas.microsoft.com/office/drawing/2014/main" id="{813C144E-36D0-34B7-2E83-676711D2F926}"/>
                  </a:ext>
                </a:extLst>
              </p:cNvPr>
              <p:cNvSpPr/>
              <p:nvPr/>
            </p:nvSpPr>
            <p:spPr>
              <a:xfrm>
                <a:off x="4126992" y="598177"/>
                <a:ext cx="1331837" cy="1893437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131" name="Group 130">
                <a:extLst>
                  <a:ext uri="{FF2B5EF4-FFF2-40B4-BE49-F238E27FC236}">
                    <a16:creationId xmlns:a16="http://schemas.microsoft.com/office/drawing/2014/main" id="{83F5AC2A-A206-7C78-CD60-812B8D7C000C}"/>
                  </a:ext>
                </a:extLst>
              </p:cNvPr>
              <p:cNvGrpSpPr/>
              <p:nvPr/>
            </p:nvGrpSpPr>
            <p:grpSpPr>
              <a:xfrm>
                <a:off x="4155460" y="598178"/>
                <a:ext cx="1279635" cy="1850402"/>
                <a:chOff x="356064" y="1775193"/>
                <a:chExt cx="1279635" cy="1850402"/>
              </a:xfrm>
            </p:grpSpPr>
            <p:sp>
              <p:nvSpPr>
                <p:cNvPr id="135" name="TextBox 134">
                  <a:extLst>
                    <a:ext uri="{FF2B5EF4-FFF2-40B4-BE49-F238E27FC236}">
                      <a16:creationId xmlns:a16="http://schemas.microsoft.com/office/drawing/2014/main" id="{F56A0894-6700-5498-B86B-AD0DBD9CBE28}"/>
                    </a:ext>
                  </a:extLst>
                </p:cNvPr>
                <p:cNvSpPr txBox="1"/>
                <p:nvPr/>
              </p:nvSpPr>
              <p:spPr>
                <a:xfrm>
                  <a:off x="364155" y="3242563"/>
                  <a:ext cx="1271544" cy="3830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TP Max</a:t>
                  </a:r>
                </a:p>
              </p:txBody>
            </p:sp>
            <p:grpSp>
              <p:nvGrpSpPr>
                <p:cNvPr id="136" name="Group 135">
                  <a:extLst>
                    <a:ext uri="{FF2B5EF4-FFF2-40B4-BE49-F238E27FC236}">
                      <a16:creationId xmlns:a16="http://schemas.microsoft.com/office/drawing/2014/main" id="{C7B2F699-5D54-821C-D25C-28B770AF6D9A}"/>
                    </a:ext>
                  </a:extLst>
                </p:cNvPr>
                <p:cNvGrpSpPr/>
                <p:nvPr/>
              </p:nvGrpSpPr>
              <p:grpSpPr>
                <a:xfrm>
                  <a:off x="356064" y="1775193"/>
                  <a:ext cx="1132573" cy="1545300"/>
                  <a:chOff x="356064" y="1775193"/>
                  <a:chExt cx="1132573" cy="1545300"/>
                </a:xfrm>
              </p:grpSpPr>
              <p:pic>
                <p:nvPicPr>
                  <p:cNvPr id="137" name="Picture 136">
                    <a:extLst>
                      <a:ext uri="{FF2B5EF4-FFF2-40B4-BE49-F238E27FC236}">
                        <a16:creationId xmlns:a16="http://schemas.microsoft.com/office/drawing/2014/main" id="{6E149A0C-D399-973A-BE0E-370F8B512A8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3">
                    <a:extLst>
                      <a:ext uri="{BEBA8EAE-BF5A-486C-A8C5-ECC9F3942E4B}">
                        <a14:imgProps xmlns:a14="http://schemas.microsoft.com/office/drawing/2010/main">
                          <a14:imgLayer r:embed="rId14">
                            <a14:imgEffect>
                              <a14:backgroundRemoval t="25205" b="63011" l="9112" r="87472">
                                <a14:foregroundMark x1="9339" y1="42553" x2="9339" y2="42881"/>
                                <a14:foregroundMark x1="12301" y1="42717" x2="12301" y2="42717"/>
                                <a14:foregroundMark x1="18679" y1="41899" x2="18679" y2="41899"/>
                                <a14:foregroundMark x1="21640" y1="42717" x2="21640" y2="42717"/>
                                <a14:foregroundMark x1="27107" y1="42553" x2="27107" y2="42553"/>
                                <a14:foregroundMark x1="29613" y1="42553" x2="29613" y2="42553"/>
                                <a14:foregroundMark x1="33941" y1="41899" x2="33941" y2="41899"/>
                                <a14:foregroundMark x1="63781" y1="42390" x2="63781" y2="42390"/>
                                <a14:foregroundMark x1="69248" y1="42553" x2="69248" y2="42553"/>
                                <a14:foregroundMark x1="72893" y1="42553" x2="72893" y2="42553"/>
                                <a14:foregroundMark x1="76993" y1="42553" x2="76993" y2="42553"/>
                                <a14:foregroundMark x1="80638" y1="42226" x2="80638" y2="42226"/>
                                <a14:foregroundMark x1="84738" y1="42226" x2="84738" y2="42226"/>
                                <a14:foregroundMark x1="87472" y1="42226" x2="87472" y2="42226"/>
                                <a14:foregroundMark x1="41002" y1="60556" x2="59226" y2="60720"/>
                                <a14:foregroundMark x1="48747" y1="26023" x2="48747" y2="26023"/>
                                <a14:foregroundMark x1="48519" y1="25368" x2="48747" y2="26678"/>
                                <a14:foregroundMark x1="48519" y1="63011" x2="48519" y2="63011"/>
                                <a14:backgroundMark x1="44419" y1="64812" x2="46014" y2="64648"/>
                              </a14:backgroundRemoval>
                            </a14:imgEffect>
                          </a14:imgLayer>
                        </a14:imgProps>
                      </a:ext>
                    </a:extLst>
                  </a:blip>
                  <a:srcRect l="5714" t="21573" r="8070" b="35761"/>
                  <a:stretch/>
                </p:blipFill>
                <p:spPr>
                  <a:xfrm>
                    <a:off x="540544" y="2128837"/>
                    <a:ext cx="939842" cy="647341"/>
                  </a:xfrm>
                  <a:prstGeom prst="rect">
                    <a:avLst/>
                  </a:prstGeom>
                </p:spPr>
              </p:pic>
              <p:grpSp>
                <p:nvGrpSpPr>
                  <p:cNvPr id="138" name="Group 137">
                    <a:extLst>
                      <a:ext uri="{FF2B5EF4-FFF2-40B4-BE49-F238E27FC236}">
                        <a16:creationId xmlns:a16="http://schemas.microsoft.com/office/drawing/2014/main" id="{6904F9C6-546F-65C1-676E-9632CE88E135}"/>
                      </a:ext>
                    </a:extLst>
                  </p:cNvPr>
                  <p:cNvGrpSpPr/>
                  <p:nvPr/>
                </p:nvGrpSpPr>
                <p:grpSpPr>
                  <a:xfrm>
                    <a:off x="1097396" y="2876860"/>
                    <a:ext cx="391241" cy="210667"/>
                    <a:chOff x="1361076" y="3009655"/>
                    <a:chExt cx="391241" cy="210667"/>
                  </a:xfrm>
                </p:grpSpPr>
                <p:sp>
                  <p:nvSpPr>
                    <p:cNvPr id="163" name="Star: 12 Points 37">
                      <a:extLst>
                        <a:ext uri="{FF2B5EF4-FFF2-40B4-BE49-F238E27FC236}">
                          <a16:creationId xmlns:a16="http://schemas.microsoft.com/office/drawing/2014/main" id="{A666FC61-2ED1-CBD5-2598-F9163F07AC5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404583" y="3014225"/>
                      <a:ext cx="293486" cy="188556"/>
                    </a:xfrm>
                    <a:custGeom>
                      <a:avLst/>
                      <a:gdLst>
                        <a:gd name="connsiteX0" fmla="*/ 0 w 234134"/>
                        <a:gd name="connsiteY0" fmla="*/ 83874 h 167747"/>
                        <a:gd name="connsiteX1" fmla="*/ 32258 w 234134"/>
                        <a:gd name="connsiteY1" fmla="*/ 67592 h 167747"/>
                        <a:gd name="connsiteX2" fmla="*/ 15684 w 234134"/>
                        <a:gd name="connsiteY2" fmla="*/ 41937 h 167747"/>
                        <a:gd name="connsiteX3" fmla="*/ 54983 w 234134"/>
                        <a:gd name="connsiteY3" fmla="*/ 39393 h 167747"/>
                        <a:gd name="connsiteX4" fmla="*/ 58534 w 234134"/>
                        <a:gd name="connsiteY4" fmla="*/ 11237 h 167747"/>
                        <a:gd name="connsiteX5" fmla="*/ 94343 w 234134"/>
                        <a:gd name="connsiteY5" fmla="*/ 23112 h 167747"/>
                        <a:gd name="connsiteX6" fmla="*/ 117067 w 234134"/>
                        <a:gd name="connsiteY6" fmla="*/ 0 h 167747"/>
                        <a:gd name="connsiteX7" fmla="*/ 139791 w 234134"/>
                        <a:gd name="connsiteY7" fmla="*/ 23112 h 167747"/>
                        <a:gd name="connsiteX8" fmla="*/ 175601 w 234134"/>
                        <a:gd name="connsiteY8" fmla="*/ 11237 h 167747"/>
                        <a:gd name="connsiteX9" fmla="*/ 179151 w 234134"/>
                        <a:gd name="connsiteY9" fmla="*/ 39393 h 167747"/>
                        <a:gd name="connsiteX10" fmla="*/ 218450 w 234134"/>
                        <a:gd name="connsiteY10" fmla="*/ 41937 h 167747"/>
                        <a:gd name="connsiteX11" fmla="*/ 201876 w 234134"/>
                        <a:gd name="connsiteY11" fmla="*/ 67592 h 167747"/>
                        <a:gd name="connsiteX12" fmla="*/ 234134 w 234134"/>
                        <a:gd name="connsiteY12" fmla="*/ 83874 h 167747"/>
                        <a:gd name="connsiteX13" fmla="*/ 201876 w 234134"/>
                        <a:gd name="connsiteY13" fmla="*/ 100155 h 167747"/>
                        <a:gd name="connsiteX14" fmla="*/ 218450 w 234134"/>
                        <a:gd name="connsiteY14" fmla="*/ 125810 h 167747"/>
                        <a:gd name="connsiteX15" fmla="*/ 179151 w 234134"/>
                        <a:gd name="connsiteY15" fmla="*/ 128354 h 167747"/>
                        <a:gd name="connsiteX16" fmla="*/ 175601 w 234134"/>
                        <a:gd name="connsiteY16" fmla="*/ 156510 h 167747"/>
                        <a:gd name="connsiteX17" fmla="*/ 139791 w 234134"/>
                        <a:gd name="connsiteY17" fmla="*/ 144635 h 167747"/>
                        <a:gd name="connsiteX18" fmla="*/ 117067 w 234134"/>
                        <a:gd name="connsiteY18" fmla="*/ 167747 h 167747"/>
                        <a:gd name="connsiteX19" fmla="*/ 94343 w 234134"/>
                        <a:gd name="connsiteY19" fmla="*/ 144635 h 167747"/>
                        <a:gd name="connsiteX20" fmla="*/ 58534 w 234134"/>
                        <a:gd name="connsiteY20" fmla="*/ 156510 h 167747"/>
                        <a:gd name="connsiteX21" fmla="*/ 54983 w 234134"/>
                        <a:gd name="connsiteY21" fmla="*/ 128354 h 167747"/>
                        <a:gd name="connsiteX22" fmla="*/ 15684 w 234134"/>
                        <a:gd name="connsiteY22" fmla="*/ 125810 h 167747"/>
                        <a:gd name="connsiteX23" fmla="*/ 32258 w 234134"/>
                        <a:gd name="connsiteY23" fmla="*/ 100155 h 167747"/>
                        <a:gd name="connsiteX24" fmla="*/ 0 w 234134"/>
                        <a:gd name="connsiteY24" fmla="*/ 83874 h 167747"/>
                        <a:gd name="connsiteX0" fmla="*/ 0 w 234134"/>
                        <a:gd name="connsiteY0" fmla="*/ 136931 h 220804"/>
                        <a:gd name="connsiteX1" fmla="*/ 32258 w 234134"/>
                        <a:gd name="connsiteY1" fmla="*/ 120649 h 220804"/>
                        <a:gd name="connsiteX2" fmla="*/ 15684 w 234134"/>
                        <a:gd name="connsiteY2" fmla="*/ 94994 h 220804"/>
                        <a:gd name="connsiteX3" fmla="*/ 54983 w 234134"/>
                        <a:gd name="connsiteY3" fmla="*/ 92450 h 220804"/>
                        <a:gd name="connsiteX4" fmla="*/ 22815 w 234134"/>
                        <a:gd name="connsiteY4" fmla="*/ 0 h 220804"/>
                        <a:gd name="connsiteX5" fmla="*/ 94343 w 234134"/>
                        <a:gd name="connsiteY5" fmla="*/ 76169 h 220804"/>
                        <a:gd name="connsiteX6" fmla="*/ 117067 w 234134"/>
                        <a:gd name="connsiteY6" fmla="*/ 53057 h 220804"/>
                        <a:gd name="connsiteX7" fmla="*/ 139791 w 234134"/>
                        <a:gd name="connsiteY7" fmla="*/ 76169 h 220804"/>
                        <a:gd name="connsiteX8" fmla="*/ 175601 w 234134"/>
                        <a:gd name="connsiteY8" fmla="*/ 64294 h 220804"/>
                        <a:gd name="connsiteX9" fmla="*/ 179151 w 234134"/>
                        <a:gd name="connsiteY9" fmla="*/ 92450 h 220804"/>
                        <a:gd name="connsiteX10" fmla="*/ 218450 w 234134"/>
                        <a:gd name="connsiteY10" fmla="*/ 94994 h 220804"/>
                        <a:gd name="connsiteX11" fmla="*/ 201876 w 234134"/>
                        <a:gd name="connsiteY11" fmla="*/ 120649 h 220804"/>
                        <a:gd name="connsiteX12" fmla="*/ 234134 w 234134"/>
                        <a:gd name="connsiteY12" fmla="*/ 136931 h 220804"/>
                        <a:gd name="connsiteX13" fmla="*/ 201876 w 234134"/>
                        <a:gd name="connsiteY13" fmla="*/ 153212 h 220804"/>
                        <a:gd name="connsiteX14" fmla="*/ 218450 w 234134"/>
                        <a:gd name="connsiteY14" fmla="*/ 178867 h 220804"/>
                        <a:gd name="connsiteX15" fmla="*/ 179151 w 234134"/>
                        <a:gd name="connsiteY15" fmla="*/ 181411 h 220804"/>
                        <a:gd name="connsiteX16" fmla="*/ 175601 w 234134"/>
                        <a:gd name="connsiteY16" fmla="*/ 209567 h 220804"/>
                        <a:gd name="connsiteX17" fmla="*/ 139791 w 234134"/>
                        <a:gd name="connsiteY17" fmla="*/ 197692 h 220804"/>
                        <a:gd name="connsiteX18" fmla="*/ 117067 w 234134"/>
                        <a:gd name="connsiteY18" fmla="*/ 220804 h 220804"/>
                        <a:gd name="connsiteX19" fmla="*/ 94343 w 234134"/>
                        <a:gd name="connsiteY19" fmla="*/ 197692 h 220804"/>
                        <a:gd name="connsiteX20" fmla="*/ 58534 w 234134"/>
                        <a:gd name="connsiteY20" fmla="*/ 209567 h 220804"/>
                        <a:gd name="connsiteX21" fmla="*/ 54983 w 234134"/>
                        <a:gd name="connsiteY21" fmla="*/ 181411 h 220804"/>
                        <a:gd name="connsiteX22" fmla="*/ 15684 w 234134"/>
                        <a:gd name="connsiteY22" fmla="*/ 178867 h 220804"/>
                        <a:gd name="connsiteX23" fmla="*/ 32258 w 234134"/>
                        <a:gd name="connsiteY23" fmla="*/ 153212 h 220804"/>
                        <a:gd name="connsiteX24" fmla="*/ 0 w 234134"/>
                        <a:gd name="connsiteY24" fmla="*/ 136931 h 220804"/>
                        <a:gd name="connsiteX0" fmla="*/ 0 w 234134"/>
                        <a:gd name="connsiteY0" fmla="*/ 101212 h 185085"/>
                        <a:gd name="connsiteX1" fmla="*/ 32258 w 234134"/>
                        <a:gd name="connsiteY1" fmla="*/ 84930 h 185085"/>
                        <a:gd name="connsiteX2" fmla="*/ 15684 w 234134"/>
                        <a:gd name="connsiteY2" fmla="*/ 59275 h 185085"/>
                        <a:gd name="connsiteX3" fmla="*/ 54983 w 234134"/>
                        <a:gd name="connsiteY3" fmla="*/ 56731 h 185085"/>
                        <a:gd name="connsiteX4" fmla="*/ 41865 w 234134"/>
                        <a:gd name="connsiteY4" fmla="*/ 0 h 185085"/>
                        <a:gd name="connsiteX5" fmla="*/ 94343 w 234134"/>
                        <a:gd name="connsiteY5" fmla="*/ 40450 h 185085"/>
                        <a:gd name="connsiteX6" fmla="*/ 117067 w 234134"/>
                        <a:gd name="connsiteY6" fmla="*/ 17338 h 185085"/>
                        <a:gd name="connsiteX7" fmla="*/ 139791 w 234134"/>
                        <a:gd name="connsiteY7" fmla="*/ 40450 h 185085"/>
                        <a:gd name="connsiteX8" fmla="*/ 175601 w 234134"/>
                        <a:gd name="connsiteY8" fmla="*/ 28575 h 185085"/>
                        <a:gd name="connsiteX9" fmla="*/ 179151 w 234134"/>
                        <a:gd name="connsiteY9" fmla="*/ 56731 h 185085"/>
                        <a:gd name="connsiteX10" fmla="*/ 218450 w 234134"/>
                        <a:gd name="connsiteY10" fmla="*/ 59275 h 185085"/>
                        <a:gd name="connsiteX11" fmla="*/ 201876 w 234134"/>
                        <a:gd name="connsiteY11" fmla="*/ 84930 h 185085"/>
                        <a:gd name="connsiteX12" fmla="*/ 234134 w 234134"/>
                        <a:gd name="connsiteY12" fmla="*/ 101212 h 185085"/>
                        <a:gd name="connsiteX13" fmla="*/ 201876 w 234134"/>
                        <a:gd name="connsiteY13" fmla="*/ 117493 h 185085"/>
                        <a:gd name="connsiteX14" fmla="*/ 218450 w 234134"/>
                        <a:gd name="connsiteY14" fmla="*/ 143148 h 185085"/>
                        <a:gd name="connsiteX15" fmla="*/ 179151 w 234134"/>
                        <a:gd name="connsiteY15" fmla="*/ 145692 h 185085"/>
                        <a:gd name="connsiteX16" fmla="*/ 175601 w 234134"/>
                        <a:gd name="connsiteY16" fmla="*/ 173848 h 185085"/>
                        <a:gd name="connsiteX17" fmla="*/ 139791 w 234134"/>
                        <a:gd name="connsiteY17" fmla="*/ 161973 h 185085"/>
                        <a:gd name="connsiteX18" fmla="*/ 117067 w 234134"/>
                        <a:gd name="connsiteY18" fmla="*/ 185085 h 185085"/>
                        <a:gd name="connsiteX19" fmla="*/ 94343 w 234134"/>
                        <a:gd name="connsiteY19" fmla="*/ 161973 h 185085"/>
                        <a:gd name="connsiteX20" fmla="*/ 58534 w 234134"/>
                        <a:gd name="connsiteY20" fmla="*/ 173848 h 185085"/>
                        <a:gd name="connsiteX21" fmla="*/ 54983 w 234134"/>
                        <a:gd name="connsiteY21" fmla="*/ 145692 h 185085"/>
                        <a:gd name="connsiteX22" fmla="*/ 15684 w 234134"/>
                        <a:gd name="connsiteY22" fmla="*/ 143148 h 185085"/>
                        <a:gd name="connsiteX23" fmla="*/ 32258 w 234134"/>
                        <a:gd name="connsiteY23" fmla="*/ 117493 h 185085"/>
                        <a:gd name="connsiteX24" fmla="*/ 0 w 234134"/>
                        <a:gd name="connsiteY24" fmla="*/ 101212 h 185085"/>
                        <a:gd name="connsiteX0" fmla="*/ 0 w 234134"/>
                        <a:gd name="connsiteY0" fmla="*/ 101212 h 209567"/>
                        <a:gd name="connsiteX1" fmla="*/ 32258 w 234134"/>
                        <a:gd name="connsiteY1" fmla="*/ 84930 h 209567"/>
                        <a:gd name="connsiteX2" fmla="*/ 15684 w 234134"/>
                        <a:gd name="connsiteY2" fmla="*/ 59275 h 209567"/>
                        <a:gd name="connsiteX3" fmla="*/ 54983 w 234134"/>
                        <a:gd name="connsiteY3" fmla="*/ 56731 h 209567"/>
                        <a:gd name="connsiteX4" fmla="*/ 41865 w 234134"/>
                        <a:gd name="connsiteY4" fmla="*/ 0 h 209567"/>
                        <a:gd name="connsiteX5" fmla="*/ 94343 w 234134"/>
                        <a:gd name="connsiteY5" fmla="*/ 40450 h 209567"/>
                        <a:gd name="connsiteX6" fmla="*/ 117067 w 234134"/>
                        <a:gd name="connsiteY6" fmla="*/ 17338 h 209567"/>
                        <a:gd name="connsiteX7" fmla="*/ 139791 w 234134"/>
                        <a:gd name="connsiteY7" fmla="*/ 40450 h 209567"/>
                        <a:gd name="connsiteX8" fmla="*/ 175601 w 234134"/>
                        <a:gd name="connsiteY8" fmla="*/ 28575 h 209567"/>
                        <a:gd name="connsiteX9" fmla="*/ 179151 w 234134"/>
                        <a:gd name="connsiteY9" fmla="*/ 56731 h 209567"/>
                        <a:gd name="connsiteX10" fmla="*/ 218450 w 234134"/>
                        <a:gd name="connsiteY10" fmla="*/ 59275 h 209567"/>
                        <a:gd name="connsiteX11" fmla="*/ 201876 w 234134"/>
                        <a:gd name="connsiteY11" fmla="*/ 84930 h 209567"/>
                        <a:gd name="connsiteX12" fmla="*/ 234134 w 234134"/>
                        <a:gd name="connsiteY12" fmla="*/ 101212 h 209567"/>
                        <a:gd name="connsiteX13" fmla="*/ 201876 w 234134"/>
                        <a:gd name="connsiteY13" fmla="*/ 117493 h 209567"/>
                        <a:gd name="connsiteX14" fmla="*/ 218450 w 234134"/>
                        <a:gd name="connsiteY14" fmla="*/ 143148 h 209567"/>
                        <a:gd name="connsiteX15" fmla="*/ 179151 w 234134"/>
                        <a:gd name="connsiteY15" fmla="*/ 145692 h 209567"/>
                        <a:gd name="connsiteX16" fmla="*/ 175601 w 234134"/>
                        <a:gd name="connsiteY16" fmla="*/ 173848 h 209567"/>
                        <a:gd name="connsiteX17" fmla="*/ 139791 w 234134"/>
                        <a:gd name="connsiteY17" fmla="*/ 161973 h 209567"/>
                        <a:gd name="connsiteX18" fmla="*/ 117067 w 234134"/>
                        <a:gd name="connsiteY18" fmla="*/ 185085 h 209567"/>
                        <a:gd name="connsiteX19" fmla="*/ 94343 w 234134"/>
                        <a:gd name="connsiteY19" fmla="*/ 161973 h 209567"/>
                        <a:gd name="connsiteX20" fmla="*/ 39484 w 234134"/>
                        <a:gd name="connsiteY20" fmla="*/ 209567 h 209567"/>
                        <a:gd name="connsiteX21" fmla="*/ 54983 w 234134"/>
                        <a:gd name="connsiteY21" fmla="*/ 145692 h 209567"/>
                        <a:gd name="connsiteX22" fmla="*/ 15684 w 234134"/>
                        <a:gd name="connsiteY22" fmla="*/ 143148 h 209567"/>
                        <a:gd name="connsiteX23" fmla="*/ 32258 w 234134"/>
                        <a:gd name="connsiteY23" fmla="*/ 117493 h 209567"/>
                        <a:gd name="connsiteX24" fmla="*/ 0 w 234134"/>
                        <a:gd name="connsiteY24" fmla="*/ 101212 h 209567"/>
                        <a:gd name="connsiteX0" fmla="*/ 0 w 250803"/>
                        <a:gd name="connsiteY0" fmla="*/ 101212 h 209567"/>
                        <a:gd name="connsiteX1" fmla="*/ 32258 w 250803"/>
                        <a:gd name="connsiteY1" fmla="*/ 84930 h 209567"/>
                        <a:gd name="connsiteX2" fmla="*/ 15684 w 250803"/>
                        <a:gd name="connsiteY2" fmla="*/ 59275 h 209567"/>
                        <a:gd name="connsiteX3" fmla="*/ 54983 w 250803"/>
                        <a:gd name="connsiteY3" fmla="*/ 56731 h 209567"/>
                        <a:gd name="connsiteX4" fmla="*/ 41865 w 250803"/>
                        <a:gd name="connsiteY4" fmla="*/ 0 h 209567"/>
                        <a:gd name="connsiteX5" fmla="*/ 94343 w 250803"/>
                        <a:gd name="connsiteY5" fmla="*/ 40450 h 209567"/>
                        <a:gd name="connsiteX6" fmla="*/ 117067 w 250803"/>
                        <a:gd name="connsiteY6" fmla="*/ 17338 h 209567"/>
                        <a:gd name="connsiteX7" fmla="*/ 139791 w 250803"/>
                        <a:gd name="connsiteY7" fmla="*/ 40450 h 209567"/>
                        <a:gd name="connsiteX8" fmla="*/ 175601 w 250803"/>
                        <a:gd name="connsiteY8" fmla="*/ 28575 h 209567"/>
                        <a:gd name="connsiteX9" fmla="*/ 179151 w 250803"/>
                        <a:gd name="connsiteY9" fmla="*/ 56731 h 209567"/>
                        <a:gd name="connsiteX10" fmla="*/ 218450 w 250803"/>
                        <a:gd name="connsiteY10" fmla="*/ 59275 h 209567"/>
                        <a:gd name="connsiteX11" fmla="*/ 201876 w 250803"/>
                        <a:gd name="connsiteY11" fmla="*/ 84930 h 209567"/>
                        <a:gd name="connsiteX12" fmla="*/ 250803 w 250803"/>
                        <a:gd name="connsiteY12" fmla="*/ 96449 h 209567"/>
                        <a:gd name="connsiteX13" fmla="*/ 201876 w 250803"/>
                        <a:gd name="connsiteY13" fmla="*/ 117493 h 209567"/>
                        <a:gd name="connsiteX14" fmla="*/ 218450 w 250803"/>
                        <a:gd name="connsiteY14" fmla="*/ 143148 h 209567"/>
                        <a:gd name="connsiteX15" fmla="*/ 179151 w 250803"/>
                        <a:gd name="connsiteY15" fmla="*/ 145692 h 209567"/>
                        <a:gd name="connsiteX16" fmla="*/ 175601 w 250803"/>
                        <a:gd name="connsiteY16" fmla="*/ 173848 h 209567"/>
                        <a:gd name="connsiteX17" fmla="*/ 139791 w 250803"/>
                        <a:gd name="connsiteY17" fmla="*/ 161973 h 209567"/>
                        <a:gd name="connsiteX18" fmla="*/ 117067 w 250803"/>
                        <a:gd name="connsiteY18" fmla="*/ 185085 h 209567"/>
                        <a:gd name="connsiteX19" fmla="*/ 94343 w 250803"/>
                        <a:gd name="connsiteY19" fmla="*/ 161973 h 209567"/>
                        <a:gd name="connsiteX20" fmla="*/ 39484 w 250803"/>
                        <a:gd name="connsiteY20" fmla="*/ 209567 h 209567"/>
                        <a:gd name="connsiteX21" fmla="*/ 54983 w 250803"/>
                        <a:gd name="connsiteY21" fmla="*/ 145692 h 209567"/>
                        <a:gd name="connsiteX22" fmla="*/ 15684 w 250803"/>
                        <a:gd name="connsiteY22" fmla="*/ 143148 h 209567"/>
                        <a:gd name="connsiteX23" fmla="*/ 32258 w 250803"/>
                        <a:gd name="connsiteY23" fmla="*/ 117493 h 209567"/>
                        <a:gd name="connsiteX24" fmla="*/ 0 w 250803"/>
                        <a:gd name="connsiteY24" fmla="*/ 101212 h 209567"/>
                        <a:gd name="connsiteX0" fmla="*/ 0 w 250803"/>
                        <a:gd name="connsiteY0" fmla="*/ 101212 h 209567"/>
                        <a:gd name="connsiteX1" fmla="*/ 32258 w 250803"/>
                        <a:gd name="connsiteY1" fmla="*/ 84930 h 209567"/>
                        <a:gd name="connsiteX2" fmla="*/ 15684 w 250803"/>
                        <a:gd name="connsiteY2" fmla="*/ 59275 h 209567"/>
                        <a:gd name="connsiteX3" fmla="*/ 54983 w 250803"/>
                        <a:gd name="connsiteY3" fmla="*/ 56731 h 209567"/>
                        <a:gd name="connsiteX4" fmla="*/ 41865 w 250803"/>
                        <a:gd name="connsiteY4" fmla="*/ 0 h 209567"/>
                        <a:gd name="connsiteX5" fmla="*/ 94343 w 250803"/>
                        <a:gd name="connsiteY5" fmla="*/ 40450 h 209567"/>
                        <a:gd name="connsiteX6" fmla="*/ 117067 w 250803"/>
                        <a:gd name="connsiteY6" fmla="*/ 17338 h 209567"/>
                        <a:gd name="connsiteX7" fmla="*/ 139791 w 250803"/>
                        <a:gd name="connsiteY7" fmla="*/ 40450 h 209567"/>
                        <a:gd name="connsiteX8" fmla="*/ 166076 w 250803"/>
                        <a:gd name="connsiteY8" fmla="*/ 16669 h 209567"/>
                        <a:gd name="connsiteX9" fmla="*/ 179151 w 250803"/>
                        <a:gd name="connsiteY9" fmla="*/ 56731 h 209567"/>
                        <a:gd name="connsiteX10" fmla="*/ 218450 w 250803"/>
                        <a:gd name="connsiteY10" fmla="*/ 59275 h 209567"/>
                        <a:gd name="connsiteX11" fmla="*/ 201876 w 250803"/>
                        <a:gd name="connsiteY11" fmla="*/ 84930 h 209567"/>
                        <a:gd name="connsiteX12" fmla="*/ 250803 w 250803"/>
                        <a:gd name="connsiteY12" fmla="*/ 96449 h 209567"/>
                        <a:gd name="connsiteX13" fmla="*/ 201876 w 250803"/>
                        <a:gd name="connsiteY13" fmla="*/ 117493 h 209567"/>
                        <a:gd name="connsiteX14" fmla="*/ 218450 w 250803"/>
                        <a:gd name="connsiteY14" fmla="*/ 143148 h 209567"/>
                        <a:gd name="connsiteX15" fmla="*/ 179151 w 250803"/>
                        <a:gd name="connsiteY15" fmla="*/ 145692 h 209567"/>
                        <a:gd name="connsiteX16" fmla="*/ 175601 w 250803"/>
                        <a:gd name="connsiteY16" fmla="*/ 173848 h 209567"/>
                        <a:gd name="connsiteX17" fmla="*/ 139791 w 250803"/>
                        <a:gd name="connsiteY17" fmla="*/ 161973 h 209567"/>
                        <a:gd name="connsiteX18" fmla="*/ 117067 w 250803"/>
                        <a:gd name="connsiteY18" fmla="*/ 185085 h 209567"/>
                        <a:gd name="connsiteX19" fmla="*/ 94343 w 250803"/>
                        <a:gd name="connsiteY19" fmla="*/ 161973 h 209567"/>
                        <a:gd name="connsiteX20" fmla="*/ 39484 w 250803"/>
                        <a:gd name="connsiteY20" fmla="*/ 209567 h 209567"/>
                        <a:gd name="connsiteX21" fmla="*/ 54983 w 250803"/>
                        <a:gd name="connsiteY21" fmla="*/ 145692 h 209567"/>
                        <a:gd name="connsiteX22" fmla="*/ 15684 w 250803"/>
                        <a:gd name="connsiteY22" fmla="*/ 143148 h 209567"/>
                        <a:gd name="connsiteX23" fmla="*/ 32258 w 250803"/>
                        <a:gd name="connsiteY23" fmla="*/ 117493 h 209567"/>
                        <a:gd name="connsiteX24" fmla="*/ 0 w 250803"/>
                        <a:gd name="connsiteY24" fmla="*/ 101212 h 209567"/>
                        <a:gd name="connsiteX0" fmla="*/ 0 w 250803"/>
                        <a:gd name="connsiteY0" fmla="*/ 101212 h 209567"/>
                        <a:gd name="connsiteX1" fmla="*/ 32258 w 250803"/>
                        <a:gd name="connsiteY1" fmla="*/ 84930 h 209567"/>
                        <a:gd name="connsiteX2" fmla="*/ 15684 w 250803"/>
                        <a:gd name="connsiteY2" fmla="*/ 59275 h 209567"/>
                        <a:gd name="connsiteX3" fmla="*/ 54983 w 250803"/>
                        <a:gd name="connsiteY3" fmla="*/ 56731 h 209567"/>
                        <a:gd name="connsiteX4" fmla="*/ 41865 w 250803"/>
                        <a:gd name="connsiteY4" fmla="*/ 0 h 209567"/>
                        <a:gd name="connsiteX5" fmla="*/ 94343 w 250803"/>
                        <a:gd name="connsiteY5" fmla="*/ 40450 h 209567"/>
                        <a:gd name="connsiteX6" fmla="*/ 117067 w 250803"/>
                        <a:gd name="connsiteY6" fmla="*/ 17338 h 209567"/>
                        <a:gd name="connsiteX7" fmla="*/ 139791 w 250803"/>
                        <a:gd name="connsiteY7" fmla="*/ 40450 h 209567"/>
                        <a:gd name="connsiteX8" fmla="*/ 166076 w 250803"/>
                        <a:gd name="connsiteY8" fmla="*/ 16669 h 209567"/>
                        <a:gd name="connsiteX9" fmla="*/ 179151 w 250803"/>
                        <a:gd name="connsiteY9" fmla="*/ 56731 h 209567"/>
                        <a:gd name="connsiteX10" fmla="*/ 218450 w 250803"/>
                        <a:gd name="connsiteY10" fmla="*/ 59275 h 209567"/>
                        <a:gd name="connsiteX11" fmla="*/ 201876 w 250803"/>
                        <a:gd name="connsiteY11" fmla="*/ 84930 h 209567"/>
                        <a:gd name="connsiteX12" fmla="*/ 250803 w 250803"/>
                        <a:gd name="connsiteY12" fmla="*/ 96449 h 209567"/>
                        <a:gd name="connsiteX13" fmla="*/ 201876 w 250803"/>
                        <a:gd name="connsiteY13" fmla="*/ 117493 h 209567"/>
                        <a:gd name="connsiteX14" fmla="*/ 218450 w 250803"/>
                        <a:gd name="connsiteY14" fmla="*/ 143148 h 209567"/>
                        <a:gd name="connsiteX15" fmla="*/ 179151 w 250803"/>
                        <a:gd name="connsiteY15" fmla="*/ 145692 h 209567"/>
                        <a:gd name="connsiteX16" fmla="*/ 158933 w 250803"/>
                        <a:gd name="connsiteY16" fmla="*/ 188136 h 209567"/>
                        <a:gd name="connsiteX17" fmla="*/ 139791 w 250803"/>
                        <a:gd name="connsiteY17" fmla="*/ 161973 h 209567"/>
                        <a:gd name="connsiteX18" fmla="*/ 117067 w 250803"/>
                        <a:gd name="connsiteY18" fmla="*/ 185085 h 209567"/>
                        <a:gd name="connsiteX19" fmla="*/ 94343 w 250803"/>
                        <a:gd name="connsiteY19" fmla="*/ 161973 h 209567"/>
                        <a:gd name="connsiteX20" fmla="*/ 39484 w 250803"/>
                        <a:gd name="connsiteY20" fmla="*/ 209567 h 209567"/>
                        <a:gd name="connsiteX21" fmla="*/ 54983 w 250803"/>
                        <a:gd name="connsiteY21" fmla="*/ 145692 h 209567"/>
                        <a:gd name="connsiteX22" fmla="*/ 15684 w 250803"/>
                        <a:gd name="connsiteY22" fmla="*/ 143148 h 209567"/>
                        <a:gd name="connsiteX23" fmla="*/ 32258 w 250803"/>
                        <a:gd name="connsiteY23" fmla="*/ 117493 h 209567"/>
                        <a:gd name="connsiteX24" fmla="*/ 0 w 250803"/>
                        <a:gd name="connsiteY24" fmla="*/ 101212 h 209567"/>
                        <a:gd name="connsiteX0" fmla="*/ 0 w 257946"/>
                        <a:gd name="connsiteY0" fmla="*/ 127406 h 209567"/>
                        <a:gd name="connsiteX1" fmla="*/ 39401 w 257946"/>
                        <a:gd name="connsiteY1" fmla="*/ 84930 h 209567"/>
                        <a:gd name="connsiteX2" fmla="*/ 22827 w 257946"/>
                        <a:gd name="connsiteY2" fmla="*/ 59275 h 209567"/>
                        <a:gd name="connsiteX3" fmla="*/ 62126 w 257946"/>
                        <a:gd name="connsiteY3" fmla="*/ 56731 h 209567"/>
                        <a:gd name="connsiteX4" fmla="*/ 49008 w 257946"/>
                        <a:gd name="connsiteY4" fmla="*/ 0 h 209567"/>
                        <a:gd name="connsiteX5" fmla="*/ 101486 w 257946"/>
                        <a:gd name="connsiteY5" fmla="*/ 40450 h 209567"/>
                        <a:gd name="connsiteX6" fmla="*/ 124210 w 257946"/>
                        <a:gd name="connsiteY6" fmla="*/ 17338 h 209567"/>
                        <a:gd name="connsiteX7" fmla="*/ 146934 w 257946"/>
                        <a:gd name="connsiteY7" fmla="*/ 40450 h 209567"/>
                        <a:gd name="connsiteX8" fmla="*/ 173219 w 257946"/>
                        <a:gd name="connsiteY8" fmla="*/ 16669 h 209567"/>
                        <a:gd name="connsiteX9" fmla="*/ 186294 w 257946"/>
                        <a:gd name="connsiteY9" fmla="*/ 56731 h 209567"/>
                        <a:gd name="connsiteX10" fmla="*/ 225593 w 257946"/>
                        <a:gd name="connsiteY10" fmla="*/ 59275 h 209567"/>
                        <a:gd name="connsiteX11" fmla="*/ 209019 w 257946"/>
                        <a:gd name="connsiteY11" fmla="*/ 84930 h 209567"/>
                        <a:gd name="connsiteX12" fmla="*/ 257946 w 257946"/>
                        <a:gd name="connsiteY12" fmla="*/ 96449 h 209567"/>
                        <a:gd name="connsiteX13" fmla="*/ 209019 w 257946"/>
                        <a:gd name="connsiteY13" fmla="*/ 117493 h 209567"/>
                        <a:gd name="connsiteX14" fmla="*/ 225593 w 257946"/>
                        <a:gd name="connsiteY14" fmla="*/ 143148 h 209567"/>
                        <a:gd name="connsiteX15" fmla="*/ 186294 w 257946"/>
                        <a:gd name="connsiteY15" fmla="*/ 145692 h 209567"/>
                        <a:gd name="connsiteX16" fmla="*/ 166076 w 257946"/>
                        <a:gd name="connsiteY16" fmla="*/ 188136 h 209567"/>
                        <a:gd name="connsiteX17" fmla="*/ 146934 w 257946"/>
                        <a:gd name="connsiteY17" fmla="*/ 161973 h 209567"/>
                        <a:gd name="connsiteX18" fmla="*/ 124210 w 257946"/>
                        <a:gd name="connsiteY18" fmla="*/ 185085 h 209567"/>
                        <a:gd name="connsiteX19" fmla="*/ 101486 w 257946"/>
                        <a:gd name="connsiteY19" fmla="*/ 161973 h 209567"/>
                        <a:gd name="connsiteX20" fmla="*/ 46627 w 257946"/>
                        <a:gd name="connsiteY20" fmla="*/ 209567 h 209567"/>
                        <a:gd name="connsiteX21" fmla="*/ 62126 w 257946"/>
                        <a:gd name="connsiteY21" fmla="*/ 145692 h 209567"/>
                        <a:gd name="connsiteX22" fmla="*/ 22827 w 257946"/>
                        <a:gd name="connsiteY22" fmla="*/ 143148 h 209567"/>
                        <a:gd name="connsiteX23" fmla="*/ 39401 w 257946"/>
                        <a:gd name="connsiteY23" fmla="*/ 117493 h 209567"/>
                        <a:gd name="connsiteX24" fmla="*/ 0 w 257946"/>
                        <a:gd name="connsiteY24" fmla="*/ 127406 h 209567"/>
                        <a:gd name="connsiteX0" fmla="*/ 0 w 257946"/>
                        <a:gd name="connsiteY0" fmla="*/ 127406 h 209567"/>
                        <a:gd name="connsiteX1" fmla="*/ 39401 w 257946"/>
                        <a:gd name="connsiteY1" fmla="*/ 84930 h 209567"/>
                        <a:gd name="connsiteX2" fmla="*/ 22827 w 257946"/>
                        <a:gd name="connsiteY2" fmla="*/ 59275 h 209567"/>
                        <a:gd name="connsiteX3" fmla="*/ 62126 w 257946"/>
                        <a:gd name="connsiteY3" fmla="*/ 56731 h 209567"/>
                        <a:gd name="connsiteX4" fmla="*/ 49008 w 257946"/>
                        <a:gd name="connsiteY4" fmla="*/ 0 h 209567"/>
                        <a:gd name="connsiteX5" fmla="*/ 101486 w 257946"/>
                        <a:gd name="connsiteY5" fmla="*/ 40450 h 209567"/>
                        <a:gd name="connsiteX6" fmla="*/ 124210 w 257946"/>
                        <a:gd name="connsiteY6" fmla="*/ 17338 h 209567"/>
                        <a:gd name="connsiteX7" fmla="*/ 146934 w 257946"/>
                        <a:gd name="connsiteY7" fmla="*/ 40450 h 209567"/>
                        <a:gd name="connsiteX8" fmla="*/ 211319 w 257946"/>
                        <a:gd name="connsiteY8" fmla="*/ 16669 h 209567"/>
                        <a:gd name="connsiteX9" fmla="*/ 186294 w 257946"/>
                        <a:gd name="connsiteY9" fmla="*/ 56731 h 209567"/>
                        <a:gd name="connsiteX10" fmla="*/ 225593 w 257946"/>
                        <a:gd name="connsiteY10" fmla="*/ 59275 h 209567"/>
                        <a:gd name="connsiteX11" fmla="*/ 209019 w 257946"/>
                        <a:gd name="connsiteY11" fmla="*/ 84930 h 209567"/>
                        <a:gd name="connsiteX12" fmla="*/ 257946 w 257946"/>
                        <a:gd name="connsiteY12" fmla="*/ 96449 h 209567"/>
                        <a:gd name="connsiteX13" fmla="*/ 209019 w 257946"/>
                        <a:gd name="connsiteY13" fmla="*/ 117493 h 209567"/>
                        <a:gd name="connsiteX14" fmla="*/ 225593 w 257946"/>
                        <a:gd name="connsiteY14" fmla="*/ 143148 h 209567"/>
                        <a:gd name="connsiteX15" fmla="*/ 186294 w 257946"/>
                        <a:gd name="connsiteY15" fmla="*/ 145692 h 209567"/>
                        <a:gd name="connsiteX16" fmla="*/ 166076 w 257946"/>
                        <a:gd name="connsiteY16" fmla="*/ 188136 h 209567"/>
                        <a:gd name="connsiteX17" fmla="*/ 146934 w 257946"/>
                        <a:gd name="connsiteY17" fmla="*/ 161973 h 209567"/>
                        <a:gd name="connsiteX18" fmla="*/ 124210 w 257946"/>
                        <a:gd name="connsiteY18" fmla="*/ 185085 h 209567"/>
                        <a:gd name="connsiteX19" fmla="*/ 101486 w 257946"/>
                        <a:gd name="connsiteY19" fmla="*/ 161973 h 209567"/>
                        <a:gd name="connsiteX20" fmla="*/ 46627 w 257946"/>
                        <a:gd name="connsiteY20" fmla="*/ 209567 h 209567"/>
                        <a:gd name="connsiteX21" fmla="*/ 62126 w 257946"/>
                        <a:gd name="connsiteY21" fmla="*/ 145692 h 209567"/>
                        <a:gd name="connsiteX22" fmla="*/ 22827 w 257946"/>
                        <a:gd name="connsiteY22" fmla="*/ 143148 h 209567"/>
                        <a:gd name="connsiteX23" fmla="*/ 39401 w 257946"/>
                        <a:gd name="connsiteY23" fmla="*/ 117493 h 209567"/>
                        <a:gd name="connsiteX24" fmla="*/ 0 w 257946"/>
                        <a:gd name="connsiteY24" fmla="*/ 127406 h 209567"/>
                        <a:gd name="connsiteX0" fmla="*/ 0 w 257946"/>
                        <a:gd name="connsiteY0" fmla="*/ 127406 h 188136"/>
                        <a:gd name="connsiteX1" fmla="*/ 39401 w 257946"/>
                        <a:gd name="connsiteY1" fmla="*/ 84930 h 188136"/>
                        <a:gd name="connsiteX2" fmla="*/ 22827 w 257946"/>
                        <a:gd name="connsiteY2" fmla="*/ 59275 h 188136"/>
                        <a:gd name="connsiteX3" fmla="*/ 62126 w 257946"/>
                        <a:gd name="connsiteY3" fmla="*/ 56731 h 188136"/>
                        <a:gd name="connsiteX4" fmla="*/ 49008 w 257946"/>
                        <a:gd name="connsiteY4" fmla="*/ 0 h 188136"/>
                        <a:gd name="connsiteX5" fmla="*/ 101486 w 257946"/>
                        <a:gd name="connsiteY5" fmla="*/ 40450 h 188136"/>
                        <a:gd name="connsiteX6" fmla="*/ 124210 w 257946"/>
                        <a:gd name="connsiteY6" fmla="*/ 17338 h 188136"/>
                        <a:gd name="connsiteX7" fmla="*/ 146934 w 257946"/>
                        <a:gd name="connsiteY7" fmla="*/ 40450 h 188136"/>
                        <a:gd name="connsiteX8" fmla="*/ 211319 w 257946"/>
                        <a:gd name="connsiteY8" fmla="*/ 16669 h 188136"/>
                        <a:gd name="connsiteX9" fmla="*/ 186294 w 257946"/>
                        <a:gd name="connsiteY9" fmla="*/ 56731 h 188136"/>
                        <a:gd name="connsiteX10" fmla="*/ 225593 w 257946"/>
                        <a:gd name="connsiteY10" fmla="*/ 59275 h 188136"/>
                        <a:gd name="connsiteX11" fmla="*/ 209019 w 257946"/>
                        <a:gd name="connsiteY11" fmla="*/ 84930 h 188136"/>
                        <a:gd name="connsiteX12" fmla="*/ 257946 w 257946"/>
                        <a:gd name="connsiteY12" fmla="*/ 96449 h 188136"/>
                        <a:gd name="connsiteX13" fmla="*/ 209019 w 257946"/>
                        <a:gd name="connsiteY13" fmla="*/ 117493 h 188136"/>
                        <a:gd name="connsiteX14" fmla="*/ 225593 w 257946"/>
                        <a:gd name="connsiteY14" fmla="*/ 143148 h 188136"/>
                        <a:gd name="connsiteX15" fmla="*/ 186294 w 257946"/>
                        <a:gd name="connsiteY15" fmla="*/ 145692 h 188136"/>
                        <a:gd name="connsiteX16" fmla="*/ 166076 w 257946"/>
                        <a:gd name="connsiteY16" fmla="*/ 188136 h 188136"/>
                        <a:gd name="connsiteX17" fmla="*/ 146934 w 257946"/>
                        <a:gd name="connsiteY17" fmla="*/ 161973 h 188136"/>
                        <a:gd name="connsiteX18" fmla="*/ 124210 w 257946"/>
                        <a:gd name="connsiteY18" fmla="*/ 185085 h 188136"/>
                        <a:gd name="connsiteX19" fmla="*/ 101486 w 257946"/>
                        <a:gd name="connsiteY19" fmla="*/ 161973 h 188136"/>
                        <a:gd name="connsiteX20" fmla="*/ 58533 w 257946"/>
                        <a:gd name="connsiteY20" fmla="*/ 180992 h 188136"/>
                        <a:gd name="connsiteX21" fmla="*/ 62126 w 257946"/>
                        <a:gd name="connsiteY21" fmla="*/ 145692 h 188136"/>
                        <a:gd name="connsiteX22" fmla="*/ 22827 w 257946"/>
                        <a:gd name="connsiteY22" fmla="*/ 143148 h 188136"/>
                        <a:gd name="connsiteX23" fmla="*/ 39401 w 257946"/>
                        <a:gd name="connsiteY23" fmla="*/ 117493 h 188136"/>
                        <a:gd name="connsiteX24" fmla="*/ 0 w 257946"/>
                        <a:gd name="connsiteY24" fmla="*/ 127406 h 188136"/>
                        <a:gd name="connsiteX0" fmla="*/ 0 w 257946"/>
                        <a:gd name="connsiteY0" fmla="*/ 127406 h 197661"/>
                        <a:gd name="connsiteX1" fmla="*/ 39401 w 257946"/>
                        <a:gd name="connsiteY1" fmla="*/ 84930 h 197661"/>
                        <a:gd name="connsiteX2" fmla="*/ 22827 w 257946"/>
                        <a:gd name="connsiteY2" fmla="*/ 59275 h 197661"/>
                        <a:gd name="connsiteX3" fmla="*/ 62126 w 257946"/>
                        <a:gd name="connsiteY3" fmla="*/ 56731 h 197661"/>
                        <a:gd name="connsiteX4" fmla="*/ 49008 w 257946"/>
                        <a:gd name="connsiteY4" fmla="*/ 0 h 197661"/>
                        <a:gd name="connsiteX5" fmla="*/ 101486 w 257946"/>
                        <a:gd name="connsiteY5" fmla="*/ 40450 h 197661"/>
                        <a:gd name="connsiteX6" fmla="*/ 124210 w 257946"/>
                        <a:gd name="connsiteY6" fmla="*/ 17338 h 197661"/>
                        <a:gd name="connsiteX7" fmla="*/ 146934 w 257946"/>
                        <a:gd name="connsiteY7" fmla="*/ 40450 h 197661"/>
                        <a:gd name="connsiteX8" fmla="*/ 211319 w 257946"/>
                        <a:gd name="connsiteY8" fmla="*/ 16669 h 197661"/>
                        <a:gd name="connsiteX9" fmla="*/ 186294 w 257946"/>
                        <a:gd name="connsiteY9" fmla="*/ 56731 h 197661"/>
                        <a:gd name="connsiteX10" fmla="*/ 225593 w 257946"/>
                        <a:gd name="connsiteY10" fmla="*/ 59275 h 197661"/>
                        <a:gd name="connsiteX11" fmla="*/ 209019 w 257946"/>
                        <a:gd name="connsiteY11" fmla="*/ 84930 h 197661"/>
                        <a:gd name="connsiteX12" fmla="*/ 257946 w 257946"/>
                        <a:gd name="connsiteY12" fmla="*/ 96449 h 197661"/>
                        <a:gd name="connsiteX13" fmla="*/ 209019 w 257946"/>
                        <a:gd name="connsiteY13" fmla="*/ 117493 h 197661"/>
                        <a:gd name="connsiteX14" fmla="*/ 225593 w 257946"/>
                        <a:gd name="connsiteY14" fmla="*/ 143148 h 197661"/>
                        <a:gd name="connsiteX15" fmla="*/ 186294 w 257946"/>
                        <a:gd name="connsiteY15" fmla="*/ 145692 h 197661"/>
                        <a:gd name="connsiteX16" fmla="*/ 166076 w 257946"/>
                        <a:gd name="connsiteY16" fmla="*/ 188136 h 197661"/>
                        <a:gd name="connsiteX17" fmla="*/ 146934 w 257946"/>
                        <a:gd name="connsiteY17" fmla="*/ 161973 h 197661"/>
                        <a:gd name="connsiteX18" fmla="*/ 124210 w 257946"/>
                        <a:gd name="connsiteY18" fmla="*/ 185085 h 197661"/>
                        <a:gd name="connsiteX19" fmla="*/ 101486 w 257946"/>
                        <a:gd name="connsiteY19" fmla="*/ 161973 h 197661"/>
                        <a:gd name="connsiteX20" fmla="*/ 49008 w 257946"/>
                        <a:gd name="connsiteY20" fmla="*/ 197661 h 197661"/>
                        <a:gd name="connsiteX21" fmla="*/ 62126 w 257946"/>
                        <a:gd name="connsiteY21" fmla="*/ 145692 h 197661"/>
                        <a:gd name="connsiteX22" fmla="*/ 22827 w 257946"/>
                        <a:gd name="connsiteY22" fmla="*/ 143148 h 197661"/>
                        <a:gd name="connsiteX23" fmla="*/ 39401 w 257946"/>
                        <a:gd name="connsiteY23" fmla="*/ 117493 h 197661"/>
                        <a:gd name="connsiteX24" fmla="*/ 0 w 257946"/>
                        <a:gd name="connsiteY24" fmla="*/ 127406 h 197661"/>
                        <a:gd name="connsiteX0" fmla="*/ 0 w 267471"/>
                        <a:gd name="connsiteY0" fmla="*/ 108356 h 197661"/>
                        <a:gd name="connsiteX1" fmla="*/ 48926 w 267471"/>
                        <a:gd name="connsiteY1" fmla="*/ 84930 h 197661"/>
                        <a:gd name="connsiteX2" fmla="*/ 32352 w 267471"/>
                        <a:gd name="connsiteY2" fmla="*/ 59275 h 197661"/>
                        <a:gd name="connsiteX3" fmla="*/ 71651 w 267471"/>
                        <a:gd name="connsiteY3" fmla="*/ 56731 h 197661"/>
                        <a:gd name="connsiteX4" fmla="*/ 58533 w 267471"/>
                        <a:gd name="connsiteY4" fmla="*/ 0 h 197661"/>
                        <a:gd name="connsiteX5" fmla="*/ 111011 w 267471"/>
                        <a:gd name="connsiteY5" fmla="*/ 40450 h 197661"/>
                        <a:gd name="connsiteX6" fmla="*/ 133735 w 267471"/>
                        <a:gd name="connsiteY6" fmla="*/ 17338 h 197661"/>
                        <a:gd name="connsiteX7" fmla="*/ 156459 w 267471"/>
                        <a:gd name="connsiteY7" fmla="*/ 40450 h 197661"/>
                        <a:gd name="connsiteX8" fmla="*/ 220844 w 267471"/>
                        <a:gd name="connsiteY8" fmla="*/ 16669 h 197661"/>
                        <a:gd name="connsiteX9" fmla="*/ 195819 w 267471"/>
                        <a:gd name="connsiteY9" fmla="*/ 56731 h 197661"/>
                        <a:gd name="connsiteX10" fmla="*/ 235118 w 267471"/>
                        <a:gd name="connsiteY10" fmla="*/ 59275 h 197661"/>
                        <a:gd name="connsiteX11" fmla="*/ 218544 w 267471"/>
                        <a:gd name="connsiteY11" fmla="*/ 84930 h 197661"/>
                        <a:gd name="connsiteX12" fmla="*/ 267471 w 267471"/>
                        <a:gd name="connsiteY12" fmla="*/ 96449 h 197661"/>
                        <a:gd name="connsiteX13" fmla="*/ 218544 w 267471"/>
                        <a:gd name="connsiteY13" fmla="*/ 117493 h 197661"/>
                        <a:gd name="connsiteX14" fmla="*/ 235118 w 267471"/>
                        <a:gd name="connsiteY14" fmla="*/ 143148 h 197661"/>
                        <a:gd name="connsiteX15" fmla="*/ 195819 w 267471"/>
                        <a:gd name="connsiteY15" fmla="*/ 145692 h 197661"/>
                        <a:gd name="connsiteX16" fmla="*/ 175601 w 267471"/>
                        <a:gd name="connsiteY16" fmla="*/ 188136 h 197661"/>
                        <a:gd name="connsiteX17" fmla="*/ 156459 w 267471"/>
                        <a:gd name="connsiteY17" fmla="*/ 161973 h 197661"/>
                        <a:gd name="connsiteX18" fmla="*/ 133735 w 267471"/>
                        <a:gd name="connsiteY18" fmla="*/ 185085 h 197661"/>
                        <a:gd name="connsiteX19" fmla="*/ 111011 w 267471"/>
                        <a:gd name="connsiteY19" fmla="*/ 161973 h 197661"/>
                        <a:gd name="connsiteX20" fmla="*/ 58533 w 267471"/>
                        <a:gd name="connsiteY20" fmla="*/ 197661 h 197661"/>
                        <a:gd name="connsiteX21" fmla="*/ 71651 w 267471"/>
                        <a:gd name="connsiteY21" fmla="*/ 145692 h 197661"/>
                        <a:gd name="connsiteX22" fmla="*/ 32352 w 267471"/>
                        <a:gd name="connsiteY22" fmla="*/ 143148 h 197661"/>
                        <a:gd name="connsiteX23" fmla="*/ 48926 w 267471"/>
                        <a:gd name="connsiteY23" fmla="*/ 117493 h 197661"/>
                        <a:gd name="connsiteX24" fmla="*/ 0 w 267471"/>
                        <a:gd name="connsiteY24" fmla="*/ 108356 h 197661"/>
                        <a:gd name="connsiteX0" fmla="*/ 0 w 267471"/>
                        <a:gd name="connsiteY0" fmla="*/ 108356 h 197661"/>
                        <a:gd name="connsiteX1" fmla="*/ 48926 w 267471"/>
                        <a:gd name="connsiteY1" fmla="*/ 84930 h 197661"/>
                        <a:gd name="connsiteX2" fmla="*/ 32352 w 267471"/>
                        <a:gd name="connsiteY2" fmla="*/ 59275 h 197661"/>
                        <a:gd name="connsiteX3" fmla="*/ 71651 w 267471"/>
                        <a:gd name="connsiteY3" fmla="*/ 56731 h 197661"/>
                        <a:gd name="connsiteX4" fmla="*/ 58533 w 267471"/>
                        <a:gd name="connsiteY4" fmla="*/ 0 h 197661"/>
                        <a:gd name="connsiteX5" fmla="*/ 111011 w 267471"/>
                        <a:gd name="connsiteY5" fmla="*/ 40450 h 197661"/>
                        <a:gd name="connsiteX6" fmla="*/ 133735 w 267471"/>
                        <a:gd name="connsiteY6" fmla="*/ 17338 h 197661"/>
                        <a:gd name="connsiteX7" fmla="*/ 156459 w 267471"/>
                        <a:gd name="connsiteY7" fmla="*/ 40450 h 197661"/>
                        <a:gd name="connsiteX8" fmla="*/ 220844 w 267471"/>
                        <a:gd name="connsiteY8" fmla="*/ 16669 h 197661"/>
                        <a:gd name="connsiteX9" fmla="*/ 195819 w 267471"/>
                        <a:gd name="connsiteY9" fmla="*/ 56731 h 197661"/>
                        <a:gd name="connsiteX10" fmla="*/ 235118 w 267471"/>
                        <a:gd name="connsiteY10" fmla="*/ 59275 h 197661"/>
                        <a:gd name="connsiteX11" fmla="*/ 218544 w 267471"/>
                        <a:gd name="connsiteY11" fmla="*/ 84930 h 197661"/>
                        <a:gd name="connsiteX12" fmla="*/ 267471 w 267471"/>
                        <a:gd name="connsiteY12" fmla="*/ 96449 h 197661"/>
                        <a:gd name="connsiteX13" fmla="*/ 218544 w 267471"/>
                        <a:gd name="connsiteY13" fmla="*/ 117493 h 197661"/>
                        <a:gd name="connsiteX14" fmla="*/ 235118 w 267471"/>
                        <a:gd name="connsiteY14" fmla="*/ 143148 h 197661"/>
                        <a:gd name="connsiteX15" fmla="*/ 195819 w 267471"/>
                        <a:gd name="connsiteY15" fmla="*/ 145692 h 197661"/>
                        <a:gd name="connsiteX16" fmla="*/ 175601 w 267471"/>
                        <a:gd name="connsiteY16" fmla="*/ 173848 h 197661"/>
                        <a:gd name="connsiteX17" fmla="*/ 156459 w 267471"/>
                        <a:gd name="connsiteY17" fmla="*/ 161973 h 197661"/>
                        <a:gd name="connsiteX18" fmla="*/ 133735 w 267471"/>
                        <a:gd name="connsiteY18" fmla="*/ 185085 h 197661"/>
                        <a:gd name="connsiteX19" fmla="*/ 111011 w 267471"/>
                        <a:gd name="connsiteY19" fmla="*/ 161973 h 197661"/>
                        <a:gd name="connsiteX20" fmla="*/ 58533 w 267471"/>
                        <a:gd name="connsiteY20" fmla="*/ 197661 h 197661"/>
                        <a:gd name="connsiteX21" fmla="*/ 71651 w 267471"/>
                        <a:gd name="connsiteY21" fmla="*/ 145692 h 197661"/>
                        <a:gd name="connsiteX22" fmla="*/ 32352 w 267471"/>
                        <a:gd name="connsiteY22" fmla="*/ 143148 h 197661"/>
                        <a:gd name="connsiteX23" fmla="*/ 48926 w 267471"/>
                        <a:gd name="connsiteY23" fmla="*/ 117493 h 197661"/>
                        <a:gd name="connsiteX24" fmla="*/ 0 w 267471"/>
                        <a:gd name="connsiteY24" fmla="*/ 108356 h 197661"/>
                        <a:gd name="connsiteX0" fmla="*/ 0 w 267471"/>
                        <a:gd name="connsiteY0" fmla="*/ 108356 h 197661"/>
                        <a:gd name="connsiteX1" fmla="*/ 48926 w 267471"/>
                        <a:gd name="connsiteY1" fmla="*/ 84930 h 197661"/>
                        <a:gd name="connsiteX2" fmla="*/ 32352 w 267471"/>
                        <a:gd name="connsiteY2" fmla="*/ 59275 h 197661"/>
                        <a:gd name="connsiteX3" fmla="*/ 71651 w 267471"/>
                        <a:gd name="connsiteY3" fmla="*/ 56731 h 197661"/>
                        <a:gd name="connsiteX4" fmla="*/ 58533 w 267471"/>
                        <a:gd name="connsiteY4" fmla="*/ 0 h 197661"/>
                        <a:gd name="connsiteX5" fmla="*/ 111011 w 267471"/>
                        <a:gd name="connsiteY5" fmla="*/ 40450 h 197661"/>
                        <a:gd name="connsiteX6" fmla="*/ 133735 w 267471"/>
                        <a:gd name="connsiteY6" fmla="*/ 17338 h 197661"/>
                        <a:gd name="connsiteX7" fmla="*/ 156459 w 267471"/>
                        <a:gd name="connsiteY7" fmla="*/ 40450 h 197661"/>
                        <a:gd name="connsiteX8" fmla="*/ 220844 w 267471"/>
                        <a:gd name="connsiteY8" fmla="*/ 16669 h 197661"/>
                        <a:gd name="connsiteX9" fmla="*/ 195819 w 267471"/>
                        <a:gd name="connsiteY9" fmla="*/ 56731 h 197661"/>
                        <a:gd name="connsiteX10" fmla="*/ 235118 w 267471"/>
                        <a:gd name="connsiteY10" fmla="*/ 59275 h 197661"/>
                        <a:gd name="connsiteX11" fmla="*/ 218544 w 267471"/>
                        <a:gd name="connsiteY11" fmla="*/ 84930 h 197661"/>
                        <a:gd name="connsiteX12" fmla="*/ 267471 w 267471"/>
                        <a:gd name="connsiteY12" fmla="*/ 96449 h 197661"/>
                        <a:gd name="connsiteX13" fmla="*/ 218544 w 267471"/>
                        <a:gd name="connsiteY13" fmla="*/ 117493 h 197661"/>
                        <a:gd name="connsiteX14" fmla="*/ 235118 w 267471"/>
                        <a:gd name="connsiteY14" fmla="*/ 143148 h 197661"/>
                        <a:gd name="connsiteX15" fmla="*/ 195819 w 267471"/>
                        <a:gd name="connsiteY15" fmla="*/ 145692 h 197661"/>
                        <a:gd name="connsiteX16" fmla="*/ 180363 w 267471"/>
                        <a:gd name="connsiteY16" fmla="*/ 180991 h 197661"/>
                        <a:gd name="connsiteX17" fmla="*/ 156459 w 267471"/>
                        <a:gd name="connsiteY17" fmla="*/ 161973 h 197661"/>
                        <a:gd name="connsiteX18" fmla="*/ 133735 w 267471"/>
                        <a:gd name="connsiteY18" fmla="*/ 185085 h 197661"/>
                        <a:gd name="connsiteX19" fmla="*/ 111011 w 267471"/>
                        <a:gd name="connsiteY19" fmla="*/ 161973 h 197661"/>
                        <a:gd name="connsiteX20" fmla="*/ 58533 w 267471"/>
                        <a:gd name="connsiteY20" fmla="*/ 197661 h 197661"/>
                        <a:gd name="connsiteX21" fmla="*/ 71651 w 267471"/>
                        <a:gd name="connsiteY21" fmla="*/ 145692 h 197661"/>
                        <a:gd name="connsiteX22" fmla="*/ 32352 w 267471"/>
                        <a:gd name="connsiteY22" fmla="*/ 143148 h 197661"/>
                        <a:gd name="connsiteX23" fmla="*/ 48926 w 267471"/>
                        <a:gd name="connsiteY23" fmla="*/ 117493 h 197661"/>
                        <a:gd name="connsiteX24" fmla="*/ 0 w 267471"/>
                        <a:gd name="connsiteY24" fmla="*/ 108356 h 197661"/>
                        <a:gd name="connsiteX0" fmla="*/ 0 w 267471"/>
                        <a:gd name="connsiteY0" fmla="*/ 108356 h 197661"/>
                        <a:gd name="connsiteX1" fmla="*/ 48926 w 267471"/>
                        <a:gd name="connsiteY1" fmla="*/ 84930 h 197661"/>
                        <a:gd name="connsiteX2" fmla="*/ 32352 w 267471"/>
                        <a:gd name="connsiteY2" fmla="*/ 59275 h 197661"/>
                        <a:gd name="connsiteX3" fmla="*/ 71651 w 267471"/>
                        <a:gd name="connsiteY3" fmla="*/ 56731 h 197661"/>
                        <a:gd name="connsiteX4" fmla="*/ 58533 w 267471"/>
                        <a:gd name="connsiteY4" fmla="*/ 0 h 197661"/>
                        <a:gd name="connsiteX5" fmla="*/ 111011 w 267471"/>
                        <a:gd name="connsiteY5" fmla="*/ 40450 h 197661"/>
                        <a:gd name="connsiteX6" fmla="*/ 133735 w 267471"/>
                        <a:gd name="connsiteY6" fmla="*/ 17338 h 197661"/>
                        <a:gd name="connsiteX7" fmla="*/ 156459 w 267471"/>
                        <a:gd name="connsiteY7" fmla="*/ 40450 h 197661"/>
                        <a:gd name="connsiteX8" fmla="*/ 220844 w 267471"/>
                        <a:gd name="connsiteY8" fmla="*/ 16669 h 197661"/>
                        <a:gd name="connsiteX9" fmla="*/ 195819 w 267471"/>
                        <a:gd name="connsiteY9" fmla="*/ 56731 h 197661"/>
                        <a:gd name="connsiteX10" fmla="*/ 235118 w 267471"/>
                        <a:gd name="connsiteY10" fmla="*/ 59275 h 197661"/>
                        <a:gd name="connsiteX11" fmla="*/ 218544 w 267471"/>
                        <a:gd name="connsiteY11" fmla="*/ 84930 h 197661"/>
                        <a:gd name="connsiteX12" fmla="*/ 267471 w 267471"/>
                        <a:gd name="connsiteY12" fmla="*/ 96449 h 197661"/>
                        <a:gd name="connsiteX13" fmla="*/ 218544 w 267471"/>
                        <a:gd name="connsiteY13" fmla="*/ 117493 h 197661"/>
                        <a:gd name="connsiteX14" fmla="*/ 235118 w 267471"/>
                        <a:gd name="connsiteY14" fmla="*/ 166960 h 197661"/>
                        <a:gd name="connsiteX15" fmla="*/ 195819 w 267471"/>
                        <a:gd name="connsiteY15" fmla="*/ 145692 h 197661"/>
                        <a:gd name="connsiteX16" fmla="*/ 180363 w 267471"/>
                        <a:gd name="connsiteY16" fmla="*/ 180991 h 197661"/>
                        <a:gd name="connsiteX17" fmla="*/ 156459 w 267471"/>
                        <a:gd name="connsiteY17" fmla="*/ 161973 h 197661"/>
                        <a:gd name="connsiteX18" fmla="*/ 133735 w 267471"/>
                        <a:gd name="connsiteY18" fmla="*/ 185085 h 197661"/>
                        <a:gd name="connsiteX19" fmla="*/ 111011 w 267471"/>
                        <a:gd name="connsiteY19" fmla="*/ 161973 h 197661"/>
                        <a:gd name="connsiteX20" fmla="*/ 58533 w 267471"/>
                        <a:gd name="connsiteY20" fmla="*/ 197661 h 197661"/>
                        <a:gd name="connsiteX21" fmla="*/ 71651 w 267471"/>
                        <a:gd name="connsiteY21" fmla="*/ 145692 h 197661"/>
                        <a:gd name="connsiteX22" fmla="*/ 32352 w 267471"/>
                        <a:gd name="connsiteY22" fmla="*/ 143148 h 197661"/>
                        <a:gd name="connsiteX23" fmla="*/ 48926 w 267471"/>
                        <a:gd name="connsiteY23" fmla="*/ 117493 h 197661"/>
                        <a:gd name="connsiteX24" fmla="*/ 0 w 267471"/>
                        <a:gd name="connsiteY24" fmla="*/ 108356 h 197661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</a:cxnLst>
                      <a:rect l="l" t="t" r="r" b="b"/>
                      <a:pathLst>
                        <a:path w="267471" h="197661">
                          <a:moveTo>
                            <a:pt x="0" y="108356"/>
                          </a:moveTo>
                          <a:lnTo>
                            <a:pt x="48926" y="84930"/>
                          </a:lnTo>
                          <a:lnTo>
                            <a:pt x="32352" y="59275"/>
                          </a:lnTo>
                          <a:lnTo>
                            <a:pt x="71651" y="56731"/>
                          </a:lnTo>
                          <a:lnTo>
                            <a:pt x="58533" y="0"/>
                          </a:lnTo>
                          <a:lnTo>
                            <a:pt x="111011" y="40450"/>
                          </a:lnTo>
                          <a:lnTo>
                            <a:pt x="133735" y="17338"/>
                          </a:lnTo>
                          <a:lnTo>
                            <a:pt x="156459" y="40450"/>
                          </a:lnTo>
                          <a:lnTo>
                            <a:pt x="220844" y="16669"/>
                          </a:lnTo>
                          <a:lnTo>
                            <a:pt x="195819" y="56731"/>
                          </a:lnTo>
                          <a:lnTo>
                            <a:pt x="235118" y="59275"/>
                          </a:lnTo>
                          <a:lnTo>
                            <a:pt x="218544" y="84930"/>
                          </a:lnTo>
                          <a:lnTo>
                            <a:pt x="267471" y="96449"/>
                          </a:lnTo>
                          <a:lnTo>
                            <a:pt x="218544" y="117493"/>
                          </a:lnTo>
                          <a:lnTo>
                            <a:pt x="235118" y="166960"/>
                          </a:lnTo>
                          <a:lnTo>
                            <a:pt x="195819" y="145692"/>
                          </a:lnTo>
                          <a:lnTo>
                            <a:pt x="180363" y="180991"/>
                          </a:lnTo>
                          <a:lnTo>
                            <a:pt x="156459" y="161973"/>
                          </a:lnTo>
                          <a:lnTo>
                            <a:pt x="133735" y="185085"/>
                          </a:lnTo>
                          <a:lnTo>
                            <a:pt x="111011" y="161973"/>
                          </a:lnTo>
                          <a:lnTo>
                            <a:pt x="58533" y="197661"/>
                          </a:lnTo>
                          <a:lnTo>
                            <a:pt x="71651" y="145692"/>
                          </a:lnTo>
                          <a:lnTo>
                            <a:pt x="32352" y="143148"/>
                          </a:lnTo>
                          <a:lnTo>
                            <a:pt x="48926" y="117493"/>
                          </a:lnTo>
                          <a:lnTo>
                            <a:pt x="0" y="108356"/>
                          </a:lnTo>
                          <a:close/>
                        </a:path>
                      </a:pathLst>
                    </a:custGeom>
                    <a:solidFill>
                      <a:schemeClr val="accent4">
                        <a:lumMod val="20000"/>
                        <a:lumOff val="80000"/>
                      </a:schemeClr>
                    </a:solidFill>
                    <a:ln w="9525">
                      <a:solidFill>
                        <a:schemeClr val="accent4">
                          <a:lumMod val="60000"/>
                          <a:lumOff val="4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164" name="TextBox 163">
                      <a:extLst>
                        <a:ext uri="{FF2B5EF4-FFF2-40B4-BE49-F238E27FC236}">
                          <a16:creationId xmlns:a16="http://schemas.microsoft.com/office/drawing/2014/main" id="{604185F5-B710-D47F-1F98-C691B4CD40B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61076" y="3009655"/>
                      <a:ext cx="391241" cy="21066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5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</a:t>
                      </a:r>
                    </a:p>
                  </p:txBody>
                </p:sp>
              </p:grpSp>
              <p:sp>
                <p:nvSpPr>
                  <p:cNvPr id="139" name="Rectangle: Rounded Corners 138">
                    <a:extLst>
                      <a:ext uri="{FF2B5EF4-FFF2-40B4-BE49-F238E27FC236}">
                        <a16:creationId xmlns:a16="http://schemas.microsoft.com/office/drawing/2014/main" id="{E80C353C-6B00-2A07-DE6A-133857118DD3}"/>
                      </a:ext>
                    </a:extLst>
                  </p:cNvPr>
                  <p:cNvSpPr/>
                  <p:nvPr/>
                </p:nvSpPr>
                <p:spPr>
                  <a:xfrm>
                    <a:off x="919163" y="2457449"/>
                    <a:ext cx="187875" cy="123784"/>
                  </a:xfrm>
                  <a:prstGeom prst="roundRect">
                    <a:avLst/>
                  </a:prstGeom>
                  <a:solidFill>
                    <a:srgbClr val="E0F4DA"/>
                  </a:solidFill>
                  <a:ln>
                    <a:solidFill>
                      <a:srgbClr val="E0F4DA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40" name="TextBox 139">
                    <a:extLst>
                      <a:ext uri="{FF2B5EF4-FFF2-40B4-BE49-F238E27FC236}">
                        <a16:creationId xmlns:a16="http://schemas.microsoft.com/office/drawing/2014/main" id="{10DCD9C6-B33F-1BF2-6414-9BCAD10847F9}"/>
                      </a:ext>
                    </a:extLst>
                  </p:cNvPr>
                  <p:cNvSpPr txBox="1"/>
                  <p:nvPr/>
                </p:nvSpPr>
                <p:spPr>
                  <a:xfrm>
                    <a:off x="763359" y="2484424"/>
                    <a:ext cx="500092" cy="22981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3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TP</a:t>
                    </a:r>
                  </a:p>
                  <a:p>
                    <a:pPr algn="ctr"/>
                    <a:r>
                      <a:rPr lang="en-US" sz="3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ynthase</a:t>
                    </a:r>
                  </a:p>
                </p:txBody>
              </p:sp>
              <p:grpSp>
                <p:nvGrpSpPr>
                  <p:cNvPr id="141" name="Group 140">
                    <a:extLst>
                      <a:ext uri="{FF2B5EF4-FFF2-40B4-BE49-F238E27FC236}">
                        <a16:creationId xmlns:a16="http://schemas.microsoft.com/office/drawing/2014/main" id="{79A462D0-825C-05CB-01B2-46540F6E5F2F}"/>
                      </a:ext>
                    </a:extLst>
                  </p:cNvPr>
                  <p:cNvGrpSpPr/>
                  <p:nvPr/>
                </p:nvGrpSpPr>
                <p:grpSpPr>
                  <a:xfrm>
                    <a:off x="356064" y="2882212"/>
                    <a:ext cx="398622" cy="210667"/>
                    <a:chOff x="1337738" y="2974005"/>
                    <a:chExt cx="398622" cy="210667"/>
                  </a:xfrm>
                </p:grpSpPr>
                <p:sp>
                  <p:nvSpPr>
                    <p:cNvPr id="161" name="Star: 12 Points 37">
                      <a:extLst>
                        <a:ext uri="{FF2B5EF4-FFF2-40B4-BE49-F238E27FC236}">
                          <a16:creationId xmlns:a16="http://schemas.microsoft.com/office/drawing/2014/main" id="{EED78570-895E-77DE-F9AF-D7F1A871EDD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404583" y="3014225"/>
                      <a:ext cx="230395" cy="122145"/>
                    </a:xfrm>
                    <a:prstGeom prst="roundRect">
                      <a:avLst>
                        <a:gd name="adj" fmla="val 50000"/>
                      </a:avLst>
                    </a:prstGeom>
                    <a:solidFill>
                      <a:schemeClr val="accent6">
                        <a:lumMod val="20000"/>
                        <a:lumOff val="80000"/>
                      </a:schemeClr>
                    </a:solidFill>
                    <a:ln w="9525">
                      <a:solidFill>
                        <a:schemeClr val="accent6">
                          <a:lumMod val="60000"/>
                          <a:lumOff val="4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162" name="TextBox 161">
                      <a:extLst>
                        <a:ext uri="{FF2B5EF4-FFF2-40B4-BE49-F238E27FC236}">
                          <a16:creationId xmlns:a16="http://schemas.microsoft.com/office/drawing/2014/main" id="{8458D39F-0580-771E-ABD9-351A9CDB2F9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37738" y="2974005"/>
                      <a:ext cx="398622" cy="21066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5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</a:t>
                      </a:r>
                    </a:p>
                  </p:txBody>
                </p:sp>
              </p:grpSp>
              <p:grpSp>
                <p:nvGrpSpPr>
                  <p:cNvPr id="142" name="Group 141">
                    <a:extLst>
                      <a:ext uri="{FF2B5EF4-FFF2-40B4-BE49-F238E27FC236}">
                        <a16:creationId xmlns:a16="http://schemas.microsoft.com/office/drawing/2014/main" id="{32767BB3-E6BD-809D-F404-63ABFA6F5E41}"/>
                      </a:ext>
                    </a:extLst>
                  </p:cNvPr>
                  <p:cNvGrpSpPr/>
                  <p:nvPr/>
                </p:nvGrpSpPr>
                <p:grpSpPr>
                  <a:xfrm>
                    <a:off x="697744" y="2882212"/>
                    <a:ext cx="191970" cy="210666"/>
                    <a:chOff x="1456693" y="2982816"/>
                    <a:chExt cx="191970" cy="210666"/>
                  </a:xfrm>
                </p:grpSpPr>
                <p:sp>
                  <p:nvSpPr>
                    <p:cNvPr id="159" name="Star: 12 Points 37">
                      <a:extLst>
                        <a:ext uri="{FF2B5EF4-FFF2-40B4-BE49-F238E27FC236}">
                          <a16:creationId xmlns:a16="http://schemas.microsoft.com/office/drawing/2014/main" id="{B3F94EBD-BB05-499D-D285-B26D8EA726B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03638" y="3014224"/>
                      <a:ext cx="137160" cy="137160"/>
                    </a:xfrm>
                    <a:prstGeom prst="ellipse">
                      <a:avLst/>
                    </a:prstGeom>
                    <a:solidFill>
                      <a:schemeClr val="accent5">
                        <a:lumMod val="20000"/>
                        <a:lumOff val="80000"/>
                      </a:schemeClr>
                    </a:solidFill>
                    <a:ln w="9525">
                      <a:solidFill>
                        <a:schemeClr val="accent5">
                          <a:lumMod val="60000"/>
                          <a:lumOff val="4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160" name="TextBox 159">
                      <a:extLst>
                        <a:ext uri="{FF2B5EF4-FFF2-40B4-BE49-F238E27FC236}">
                          <a16:creationId xmlns:a16="http://schemas.microsoft.com/office/drawing/2014/main" id="{71227CE8-101F-EF72-D5EC-01E46CCE572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56693" y="2982816"/>
                      <a:ext cx="191970" cy="210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5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</p:txBody>
                </p:sp>
              </p:grpSp>
              <p:sp>
                <p:nvSpPr>
                  <p:cNvPr id="143" name="TextBox 142">
                    <a:extLst>
                      <a:ext uri="{FF2B5EF4-FFF2-40B4-BE49-F238E27FC236}">
                        <a16:creationId xmlns:a16="http://schemas.microsoft.com/office/drawing/2014/main" id="{AE69DA14-746D-C283-1CB5-7F4FD2C5E3B1}"/>
                      </a:ext>
                    </a:extLst>
                  </p:cNvPr>
                  <p:cNvSpPr txBox="1"/>
                  <p:nvPr/>
                </p:nvSpPr>
                <p:spPr>
                  <a:xfrm>
                    <a:off x="581333" y="2882220"/>
                    <a:ext cx="228360" cy="21066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5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grpSp>
                <p:nvGrpSpPr>
                  <p:cNvPr id="144" name="Group 143">
                    <a:extLst>
                      <a:ext uri="{FF2B5EF4-FFF2-40B4-BE49-F238E27FC236}">
                        <a16:creationId xmlns:a16="http://schemas.microsoft.com/office/drawing/2014/main" id="{4F11672D-64F9-94DD-13E7-A0A9B6E04A4F}"/>
                      </a:ext>
                    </a:extLst>
                  </p:cNvPr>
                  <p:cNvGrpSpPr/>
                  <p:nvPr/>
                </p:nvGrpSpPr>
                <p:grpSpPr>
                  <a:xfrm>
                    <a:off x="784986" y="3109827"/>
                    <a:ext cx="315216" cy="210666"/>
                    <a:chOff x="1438105" y="2987699"/>
                    <a:chExt cx="315216" cy="210666"/>
                  </a:xfrm>
                </p:grpSpPr>
                <p:sp>
                  <p:nvSpPr>
                    <p:cNvPr id="157" name="Star: 12 Points 37">
                      <a:extLst>
                        <a:ext uri="{FF2B5EF4-FFF2-40B4-BE49-F238E27FC236}">
                          <a16:creationId xmlns:a16="http://schemas.microsoft.com/office/drawing/2014/main" id="{7B80E4CD-6657-90A5-791A-CE4C77DC444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03638" y="3014224"/>
                      <a:ext cx="137160" cy="137160"/>
                    </a:xfrm>
                    <a:prstGeom prst="ellipse">
                      <a:avLst/>
                    </a:prstGeom>
                    <a:solidFill>
                      <a:schemeClr val="bg2"/>
                    </a:solidFill>
                    <a:ln w="9525">
                      <a:solidFill>
                        <a:schemeClr val="bg2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158" name="TextBox 157">
                      <a:extLst>
                        <a:ext uri="{FF2B5EF4-FFF2-40B4-BE49-F238E27FC236}">
                          <a16:creationId xmlns:a16="http://schemas.microsoft.com/office/drawing/2014/main" id="{9D6A2A29-A358-2DBF-E953-DF485E2FCF4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38105" y="2987699"/>
                      <a:ext cx="315216" cy="210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5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r>
                        <a:rPr lang="en-US" sz="500" b="1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5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145" name="Group 144">
                    <a:extLst>
                      <a:ext uri="{FF2B5EF4-FFF2-40B4-BE49-F238E27FC236}">
                        <a16:creationId xmlns:a16="http://schemas.microsoft.com/office/drawing/2014/main" id="{7B2464FF-4209-8D72-F95D-87C876FD1A8D}"/>
                      </a:ext>
                    </a:extLst>
                  </p:cNvPr>
                  <p:cNvGrpSpPr/>
                  <p:nvPr/>
                </p:nvGrpSpPr>
                <p:grpSpPr>
                  <a:xfrm>
                    <a:off x="934394" y="3045667"/>
                    <a:ext cx="315216" cy="210666"/>
                    <a:chOff x="1438105" y="2987699"/>
                    <a:chExt cx="315216" cy="210666"/>
                  </a:xfrm>
                </p:grpSpPr>
                <p:sp>
                  <p:nvSpPr>
                    <p:cNvPr id="155" name="Star: 12 Points 37">
                      <a:extLst>
                        <a:ext uri="{FF2B5EF4-FFF2-40B4-BE49-F238E27FC236}">
                          <a16:creationId xmlns:a16="http://schemas.microsoft.com/office/drawing/2014/main" id="{A10ACE75-AC6F-802D-BDAC-1D00AEE1536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03638" y="3014224"/>
                      <a:ext cx="137160" cy="137160"/>
                    </a:xfrm>
                    <a:prstGeom prst="ellipse">
                      <a:avLst/>
                    </a:prstGeom>
                    <a:solidFill>
                      <a:schemeClr val="bg2"/>
                    </a:solidFill>
                    <a:ln w="9525">
                      <a:solidFill>
                        <a:schemeClr val="bg2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156" name="TextBox 155">
                      <a:extLst>
                        <a:ext uri="{FF2B5EF4-FFF2-40B4-BE49-F238E27FC236}">
                          <a16:creationId xmlns:a16="http://schemas.microsoft.com/office/drawing/2014/main" id="{CA8BDE01-6D94-13CD-6BA4-4C9EE8C5661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38105" y="2987699"/>
                      <a:ext cx="315216" cy="210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5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r>
                        <a:rPr lang="en-US" sz="500" b="1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5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146" name="Group 145">
                    <a:extLst>
                      <a:ext uri="{FF2B5EF4-FFF2-40B4-BE49-F238E27FC236}">
                        <a16:creationId xmlns:a16="http://schemas.microsoft.com/office/drawing/2014/main" id="{9713FC86-770A-D0D5-0908-7485F097FA96}"/>
                      </a:ext>
                    </a:extLst>
                  </p:cNvPr>
                  <p:cNvGrpSpPr/>
                  <p:nvPr/>
                </p:nvGrpSpPr>
                <p:grpSpPr>
                  <a:xfrm>
                    <a:off x="684711" y="1775193"/>
                    <a:ext cx="315216" cy="210666"/>
                    <a:chOff x="1438105" y="2987699"/>
                    <a:chExt cx="315216" cy="210666"/>
                  </a:xfrm>
                </p:grpSpPr>
                <p:sp>
                  <p:nvSpPr>
                    <p:cNvPr id="153" name="Star: 12 Points 37">
                      <a:extLst>
                        <a:ext uri="{FF2B5EF4-FFF2-40B4-BE49-F238E27FC236}">
                          <a16:creationId xmlns:a16="http://schemas.microsoft.com/office/drawing/2014/main" id="{4FCCC94B-6DAD-5ADB-54D2-EA9DD20B489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03638" y="3014224"/>
                      <a:ext cx="137160" cy="137160"/>
                    </a:xfrm>
                    <a:prstGeom prst="ellipse">
                      <a:avLst/>
                    </a:prstGeom>
                    <a:solidFill>
                      <a:schemeClr val="bg2"/>
                    </a:solidFill>
                    <a:ln w="9525">
                      <a:solidFill>
                        <a:schemeClr val="bg2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154" name="TextBox 153">
                      <a:extLst>
                        <a:ext uri="{FF2B5EF4-FFF2-40B4-BE49-F238E27FC236}">
                          <a16:creationId xmlns:a16="http://schemas.microsoft.com/office/drawing/2014/main" id="{343D4661-1506-F265-3E29-1CFA90287C9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38105" y="2987699"/>
                      <a:ext cx="315216" cy="210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5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r>
                        <a:rPr lang="en-US" sz="500" b="1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5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147" name="Group 146">
                    <a:extLst>
                      <a:ext uri="{FF2B5EF4-FFF2-40B4-BE49-F238E27FC236}">
                        <a16:creationId xmlns:a16="http://schemas.microsoft.com/office/drawing/2014/main" id="{F049F63A-19B9-24AE-7E78-5451B8B7A2E7}"/>
                      </a:ext>
                    </a:extLst>
                  </p:cNvPr>
                  <p:cNvGrpSpPr/>
                  <p:nvPr/>
                </p:nvGrpSpPr>
                <p:grpSpPr>
                  <a:xfrm>
                    <a:off x="872044" y="1936866"/>
                    <a:ext cx="315216" cy="210666"/>
                    <a:chOff x="1438105" y="2987699"/>
                    <a:chExt cx="315216" cy="210666"/>
                  </a:xfrm>
                </p:grpSpPr>
                <p:sp>
                  <p:nvSpPr>
                    <p:cNvPr id="151" name="Star: 12 Points 37">
                      <a:extLst>
                        <a:ext uri="{FF2B5EF4-FFF2-40B4-BE49-F238E27FC236}">
                          <a16:creationId xmlns:a16="http://schemas.microsoft.com/office/drawing/2014/main" id="{56BE045F-7C15-8452-1C5D-B4272AA8F35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03638" y="3014224"/>
                      <a:ext cx="137160" cy="137160"/>
                    </a:xfrm>
                    <a:prstGeom prst="ellipse">
                      <a:avLst/>
                    </a:prstGeom>
                    <a:solidFill>
                      <a:schemeClr val="bg2"/>
                    </a:solidFill>
                    <a:ln w="9525">
                      <a:solidFill>
                        <a:schemeClr val="bg2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152" name="TextBox 151">
                      <a:extLst>
                        <a:ext uri="{FF2B5EF4-FFF2-40B4-BE49-F238E27FC236}">
                          <a16:creationId xmlns:a16="http://schemas.microsoft.com/office/drawing/2014/main" id="{ED53E598-6B72-7C7B-91F3-7591B91062F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38105" y="2987699"/>
                      <a:ext cx="315216" cy="210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5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r>
                        <a:rPr lang="en-US" sz="5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5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148" name="Group 147">
                    <a:extLst>
                      <a:ext uri="{FF2B5EF4-FFF2-40B4-BE49-F238E27FC236}">
                        <a16:creationId xmlns:a16="http://schemas.microsoft.com/office/drawing/2014/main" id="{33127B13-17BD-0E33-812C-C25C1D2C7069}"/>
                      </a:ext>
                    </a:extLst>
                  </p:cNvPr>
                  <p:cNvGrpSpPr/>
                  <p:nvPr/>
                </p:nvGrpSpPr>
                <p:grpSpPr>
                  <a:xfrm>
                    <a:off x="1092002" y="1813153"/>
                    <a:ext cx="315216" cy="210666"/>
                    <a:chOff x="1438105" y="2987699"/>
                    <a:chExt cx="315216" cy="210666"/>
                  </a:xfrm>
                </p:grpSpPr>
                <p:sp>
                  <p:nvSpPr>
                    <p:cNvPr id="149" name="Star: 12 Points 37">
                      <a:extLst>
                        <a:ext uri="{FF2B5EF4-FFF2-40B4-BE49-F238E27FC236}">
                          <a16:creationId xmlns:a16="http://schemas.microsoft.com/office/drawing/2014/main" id="{9DDCB0F0-E3FC-912D-C9BD-E63680A4AC4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03638" y="3014224"/>
                      <a:ext cx="137160" cy="137160"/>
                    </a:xfrm>
                    <a:prstGeom prst="ellipse">
                      <a:avLst/>
                    </a:prstGeom>
                    <a:solidFill>
                      <a:schemeClr val="bg2"/>
                    </a:solidFill>
                    <a:ln w="9525">
                      <a:solidFill>
                        <a:schemeClr val="bg2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150" name="TextBox 149">
                      <a:extLst>
                        <a:ext uri="{FF2B5EF4-FFF2-40B4-BE49-F238E27FC236}">
                          <a16:creationId xmlns:a16="http://schemas.microsoft.com/office/drawing/2014/main" id="{CCCE3695-D787-98C9-5B41-453E8B8E994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38105" y="2987699"/>
                      <a:ext cx="315216" cy="210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5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r>
                        <a:rPr lang="en-US" sz="500" b="1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5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</p:grpSp>
          <p:grpSp>
            <p:nvGrpSpPr>
              <p:cNvPr id="132" name="Group 131">
                <a:extLst>
                  <a:ext uri="{FF2B5EF4-FFF2-40B4-BE49-F238E27FC236}">
                    <a16:creationId xmlns:a16="http://schemas.microsoft.com/office/drawing/2014/main" id="{33B38EE1-2244-6BC6-4269-536100B47475}"/>
                  </a:ext>
                </a:extLst>
              </p:cNvPr>
              <p:cNvGrpSpPr/>
              <p:nvPr/>
            </p:nvGrpSpPr>
            <p:grpSpPr>
              <a:xfrm>
                <a:off x="4548751" y="1593897"/>
                <a:ext cx="590180" cy="548339"/>
                <a:chOff x="2894492" y="1278218"/>
                <a:chExt cx="590180" cy="548339"/>
              </a:xfrm>
            </p:grpSpPr>
            <p:sp>
              <p:nvSpPr>
                <p:cNvPr id="133" name="Arc 132">
                  <a:extLst>
                    <a:ext uri="{FF2B5EF4-FFF2-40B4-BE49-F238E27FC236}">
                      <a16:creationId xmlns:a16="http://schemas.microsoft.com/office/drawing/2014/main" id="{C6548962-FC4F-9FB9-8DD0-F1F504BCB2D9}"/>
                    </a:ext>
                  </a:extLst>
                </p:cNvPr>
                <p:cNvSpPr/>
                <p:nvPr/>
              </p:nvSpPr>
              <p:spPr>
                <a:xfrm rot="18509439">
                  <a:off x="2921949" y="1263834"/>
                  <a:ext cx="535266" cy="590180"/>
                </a:xfrm>
                <a:prstGeom prst="arc">
                  <a:avLst>
                    <a:gd name="adj1" fmla="val 16275508"/>
                    <a:gd name="adj2" fmla="val 459101"/>
                  </a:avLst>
                </a:prstGeom>
                <a:ln w="12700">
                  <a:gradFill>
                    <a:gsLst>
                      <a:gs pos="0">
                        <a:schemeClr val="accent1">
                          <a:lumMod val="5000"/>
                          <a:lumOff val="95000"/>
                        </a:schemeClr>
                      </a:gs>
                      <a:gs pos="25000">
                        <a:schemeClr val="tx1"/>
                      </a:gs>
                      <a:gs pos="100000">
                        <a:schemeClr val="tx1"/>
                      </a:gs>
                    </a:gsLst>
                    <a:lin ang="5400000" scaled="1"/>
                  </a:gradFill>
                  <a:tailEnd type="triangle" w="sm" len="sm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134" name="Straight Connector 133">
                  <a:extLst>
                    <a:ext uri="{FF2B5EF4-FFF2-40B4-BE49-F238E27FC236}">
                      <a16:creationId xmlns:a16="http://schemas.microsoft.com/office/drawing/2014/main" id="{07FB5521-C05A-80F5-D01F-4F5149BB37E2}"/>
                    </a:ext>
                  </a:extLst>
                </p:cNvPr>
                <p:cNvCxnSpPr/>
                <p:nvPr/>
              </p:nvCxnSpPr>
              <p:spPr>
                <a:xfrm>
                  <a:off x="3161102" y="1278218"/>
                  <a:ext cx="0" cy="173235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605B47AF-C960-69AD-E104-6EAAD466D4C9}"/>
              </a:ext>
            </a:extLst>
          </p:cNvPr>
          <p:cNvGrpSpPr/>
          <p:nvPr/>
        </p:nvGrpSpPr>
        <p:grpSpPr>
          <a:xfrm>
            <a:off x="530384" y="2237623"/>
            <a:ext cx="2078966" cy="1508855"/>
            <a:chOff x="457604" y="3019305"/>
            <a:chExt cx="2078966" cy="1508855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854B3BCD-3772-48D7-26CE-EB8D630F1AEF}"/>
                </a:ext>
              </a:extLst>
            </p:cNvPr>
            <p:cNvGrpSpPr/>
            <p:nvPr/>
          </p:nvGrpSpPr>
          <p:grpSpPr>
            <a:xfrm>
              <a:off x="457604" y="3019305"/>
              <a:ext cx="2078966" cy="1508855"/>
              <a:chOff x="457604" y="3019305"/>
              <a:chExt cx="2078966" cy="1508855"/>
            </a:xfrm>
          </p:grpSpPr>
          <p:sp>
            <p:nvSpPr>
              <p:cNvPr id="169" name="Isosceles Triangle 168">
                <a:extLst>
                  <a:ext uri="{FF2B5EF4-FFF2-40B4-BE49-F238E27FC236}">
                    <a16:creationId xmlns:a16="http://schemas.microsoft.com/office/drawing/2014/main" id="{6BE1F158-A882-4BFA-F8B7-D931FCE879CA}"/>
                  </a:ext>
                </a:extLst>
              </p:cNvPr>
              <p:cNvSpPr/>
              <p:nvPr/>
            </p:nvSpPr>
            <p:spPr>
              <a:xfrm rot="3971308" flipH="1">
                <a:off x="1993711" y="2983455"/>
                <a:ext cx="173869" cy="911849"/>
              </a:xfrm>
              <a:prstGeom prst="triangl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170" name="Group 169">
                <a:extLst>
                  <a:ext uri="{FF2B5EF4-FFF2-40B4-BE49-F238E27FC236}">
                    <a16:creationId xmlns:a16="http://schemas.microsoft.com/office/drawing/2014/main" id="{028D3765-4ABD-80A0-C44E-A51731CD2BC7}"/>
                  </a:ext>
                </a:extLst>
              </p:cNvPr>
              <p:cNvGrpSpPr/>
              <p:nvPr/>
            </p:nvGrpSpPr>
            <p:grpSpPr>
              <a:xfrm>
                <a:off x="457604" y="3019305"/>
                <a:ext cx="1293407" cy="1508855"/>
                <a:chOff x="8478190" y="1077141"/>
                <a:chExt cx="1411941" cy="1596518"/>
              </a:xfrm>
              <a:solidFill>
                <a:schemeClr val="accent6">
                  <a:lumMod val="20000"/>
                  <a:lumOff val="80000"/>
                </a:schemeClr>
              </a:solidFill>
            </p:grpSpPr>
            <p:sp>
              <p:nvSpPr>
                <p:cNvPr id="175" name="Rectangle: Rounded Corners 174">
                  <a:extLst>
                    <a:ext uri="{FF2B5EF4-FFF2-40B4-BE49-F238E27FC236}">
                      <a16:creationId xmlns:a16="http://schemas.microsoft.com/office/drawing/2014/main" id="{82F66026-774D-B704-D977-A1FB8D650EB4}"/>
                    </a:ext>
                  </a:extLst>
                </p:cNvPr>
                <p:cNvSpPr/>
                <p:nvPr/>
              </p:nvSpPr>
              <p:spPr>
                <a:xfrm>
                  <a:off x="8478190" y="1077141"/>
                  <a:ext cx="1411941" cy="1596518"/>
                </a:xfrm>
                <a:prstGeom prst="roundRect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76" name="TextBox 175">
                  <a:extLst>
                    <a:ext uri="{FF2B5EF4-FFF2-40B4-BE49-F238E27FC236}">
                      <a16:creationId xmlns:a16="http://schemas.microsoft.com/office/drawing/2014/main" id="{A073806C-C4A7-2D52-D3EC-B26F305D9329}"/>
                    </a:ext>
                  </a:extLst>
                </p:cNvPr>
                <p:cNvSpPr txBox="1"/>
                <p:nvPr/>
              </p:nvSpPr>
              <p:spPr>
                <a:xfrm>
                  <a:off x="8579483" y="2315444"/>
                  <a:ext cx="1291798" cy="32565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O</a:t>
                  </a:r>
                  <a:r>
                    <a:rPr lang="en-US" sz="14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Peak</a:t>
                  </a:r>
                </a:p>
              </p:txBody>
            </p:sp>
          </p:grpSp>
        </p:grpSp>
        <p:grpSp>
          <p:nvGrpSpPr>
            <p:cNvPr id="171" name="Group 170">
              <a:extLst>
                <a:ext uri="{FF2B5EF4-FFF2-40B4-BE49-F238E27FC236}">
                  <a16:creationId xmlns:a16="http://schemas.microsoft.com/office/drawing/2014/main" id="{A184804E-31B4-9137-168E-02BFCF6D3C3E}"/>
                </a:ext>
              </a:extLst>
            </p:cNvPr>
            <p:cNvGrpSpPr/>
            <p:nvPr/>
          </p:nvGrpSpPr>
          <p:grpSpPr>
            <a:xfrm rot="21043724">
              <a:off x="879302" y="3039689"/>
              <a:ext cx="516404" cy="1044698"/>
              <a:chOff x="3795820" y="1875449"/>
              <a:chExt cx="634614" cy="1244387"/>
            </a:xfrm>
          </p:grpSpPr>
          <p:pic>
            <p:nvPicPr>
              <p:cNvPr id="173" name="Picture 172">
                <a:extLst>
                  <a:ext uri="{FF2B5EF4-FFF2-40B4-BE49-F238E27FC236}">
                    <a16:creationId xmlns:a16="http://schemas.microsoft.com/office/drawing/2014/main" id="{277CAFBC-4734-C4CE-A63B-600FE890BCD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ackgroundRemoval t="3348" b="97089" l="9967" r="89701">
                            <a14:foregroundMark x1="56146" y1="53386" x2="56146" y2="54876"/>
                            <a14:foregroundMark x1="56146" y1="49927" x2="56146" y2="51281"/>
                            <a14:foregroundMark x1="21262" y1="90102" x2="31561" y2="95924"/>
                            <a14:foregroundMark x1="31561" y1="95924" x2="42193" y2="96943"/>
                            <a14:backgroundMark x1="57143" y1="79622" x2="49502" y2="87627"/>
                            <a14:backgroundMark x1="56478" y1="77729" x2="55482" y2="83406"/>
                            <a14:backgroundMark x1="51163" y1="89811" x2="51163" y2="89811"/>
                            <a14:backgroundMark x1="48173" y1="90102" x2="48173" y2="90102"/>
                            <a14:backgroundMark x1="44518" y1="92140" x2="52824" y2="90539"/>
                            <a14:backgroundMark x1="46179" y1="89083" x2="53821" y2="83406"/>
                            <a14:backgroundMark x1="49502" y1="84862" x2="53821" y2="79039"/>
                            <a14:backgroundMark x1="58140" y1="78457" x2="54485" y2="78748"/>
                            <a14:backgroundMark x1="55482" y1="76419" x2="55482" y2="76419"/>
                            <a14:backgroundMark x1="90365" y1="80349" x2="91694" y2="80349"/>
                            <a14:backgroundMark x1="85714" y1="77147" x2="93355" y2="79039"/>
                            <a14:backgroundMark x1="56811" y1="91557" x2="67442" y2="95779"/>
                            <a14:backgroundMark x1="63787" y1="95488" x2="64784" y2="97234"/>
                            <a14:backgroundMark x1="55150" y1="77875" x2="55150" y2="77875"/>
                            <a14:backgroundMark x1="54153" y1="77584" x2="48837" y2="80349"/>
                            <a14:backgroundMark x1="49834" y1="79767" x2="45847" y2="85007"/>
                            <a14:backgroundMark x1="27575" y1="58952" x2="24917" y2="56332"/>
                            <a14:backgroundMark x1="29236" y1="59534" x2="29236" y2="60262"/>
                            <a14:backgroundMark x1="29236" y1="61135" x2="29236" y2="61135"/>
                            <a14:backgroundMark x1="30565" y1="62737" x2="30565" y2="62737"/>
                            <a14:backgroundMark x1="30565" y1="61281" x2="30565" y2="61281"/>
                            <a14:backgroundMark x1="29236" y1="59971" x2="30565" y2="57205"/>
                            <a14:backgroundMark x1="27907" y1="57205" x2="27243" y2="55604"/>
                            <a14:backgroundMark x1="27243" y1="55022" x2="26578" y2="53275"/>
                            <a14:backgroundMark x1="29236" y1="55750" x2="26578" y2="53421"/>
                            <a14:backgroundMark x1="24917" y1="54003" x2="25914" y2="51965"/>
                            <a14:backgroundMark x1="26578" y1="52547" x2="24917" y2="50801"/>
                            <a14:backgroundMark x1="25249" y1="51383" x2="23256" y2="49345"/>
                            <a14:backgroundMark x1="64120" y1="48617" x2="66113" y2="7860"/>
                            <a14:backgroundMark x1="66113" y1="7860" x2="48505" y2="28239"/>
                            <a14:backgroundMark x1="61794" y1="48035" x2="61794" y2="48035"/>
                            <a14:backgroundMark x1="62458" y1="50509" x2="62458" y2="52256"/>
                            <a14:backgroundMark x1="61130" y1="51092" x2="58472" y2="45415"/>
                            <a14:backgroundMark x1="62458" y1="51383" x2="59468" y2="51383"/>
                            <a14:backgroundMark x1="57475" y1="51674" x2="60465" y2="45269"/>
                            <a14:backgroundMark x1="60133" y1="51528" x2="59468" y2="53566"/>
                            <a14:backgroundMark x1="61130" y1="51092" x2="52824" y2="42940"/>
                            <a14:backgroundMark x1="59468" y1="46579" x2="44186" y2="40466"/>
                            <a14:backgroundMark x1="47841" y1="41339" x2="26578" y2="40757"/>
                            <a14:backgroundMark x1="29900" y1="40757" x2="16611" y2="41194"/>
                            <a14:backgroundMark x1="17940" y1="40175" x2="29236" y2="20670"/>
                            <a14:backgroundMark x1="65449" y1="40029" x2="81728" y2="43523"/>
                            <a14:backgroundMark x1="63787" y1="37991" x2="77741" y2="39592"/>
                            <a14:backgroundMark x1="65116" y1="35662" x2="67110" y2="39884"/>
                            <a14:backgroundMark x1="70764" y1="18049" x2="73754" y2="6987"/>
                            <a14:backgroundMark x1="77076" y1="11936" x2="79402" y2="4076"/>
                            <a14:backgroundMark x1="76744" y1="4221" x2="52492" y2="4221"/>
                            <a14:backgroundMark x1="72425" y1="6550" x2="66445" y2="8734"/>
                            <a14:backgroundMark x1="24252" y1="49491" x2="23256" y2="42067"/>
                          </a14:backgroundRemoval>
                        </a14:imgEffect>
                      </a14:imgLayer>
                    </a14:imgProps>
                  </a:ext>
                </a:extLst>
              </a:blip>
              <a:srcRect t="1" b="276"/>
              <a:stretch/>
            </p:blipFill>
            <p:spPr>
              <a:xfrm rot="20799953" flipH="1">
                <a:off x="3884995" y="1875449"/>
                <a:ext cx="545439" cy="1241461"/>
              </a:xfrm>
              <a:prstGeom prst="rect">
                <a:avLst/>
              </a:prstGeom>
            </p:spPr>
          </p:pic>
          <p:pic>
            <p:nvPicPr>
              <p:cNvPr id="174" name="Picture 173">
                <a:extLst>
                  <a:ext uri="{FF2B5EF4-FFF2-40B4-BE49-F238E27FC236}">
                    <a16:creationId xmlns:a16="http://schemas.microsoft.com/office/drawing/2014/main" id="{64D5C3D3-DEE3-D125-B1CB-063A9B00199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ackgroundRemoval t="3348" b="97089" l="9967" r="89701">
                            <a14:foregroundMark x1="67774" y1="3348" x2="71096" y2="6987"/>
                            <a14:foregroundMark x1="64120" y1="36390" x2="71429" y2="41048"/>
                            <a14:foregroundMark x1="56146" y1="49927" x2="56146" y2="54876"/>
                            <a14:foregroundMark x1="21262" y1="90102" x2="31561" y2="95924"/>
                            <a14:foregroundMark x1="31561" y1="95924" x2="42193" y2="96943"/>
                            <a14:backgroundMark x1="57143" y1="79622" x2="49502" y2="87627"/>
                            <a14:backgroundMark x1="56478" y1="77729" x2="55482" y2="83406"/>
                            <a14:backgroundMark x1="51163" y1="89811" x2="51163" y2="89811"/>
                            <a14:backgroundMark x1="48173" y1="90102" x2="48173" y2="90102"/>
                            <a14:backgroundMark x1="44518" y1="92140" x2="52824" y2="90539"/>
                            <a14:backgroundMark x1="46179" y1="89083" x2="53821" y2="83406"/>
                            <a14:backgroundMark x1="49502" y1="84862" x2="53821" y2="79039"/>
                            <a14:backgroundMark x1="58140" y1="78457" x2="54485" y2="78748"/>
                            <a14:backgroundMark x1="55482" y1="76419" x2="55482" y2="76419"/>
                            <a14:backgroundMark x1="90365" y1="80349" x2="91694" y2="80349"/>
                            <a14:backgroundMark x1="85714" y1="77147" x2="93355" y2="79039"/>
                            <a14:backgroundMark x1="56811" y1="91557" x2="67442" y2="95779"/>
                            <a14:backgroundMark x1="63787" y1="95488" x2="64784" y2="97234"/>
                            <a14:backgroundMark x1="55150" y1="77875" x2="55150" y2="77875"/>
                            <a14:backgroundMark x1="54153" y1="77584" x2="48837" y2="80349"/>
                            <a14:backgroundMark x1="49834" y1="79767" x2="45847" y2="85007"/>
                            <a14:backgroundMark x1="27575" y1="58952" x2="24917" y2="56332"/>
                            <a14:backgroundMark x1="29236" y1="59534" x2="29236" y2="60262"/>
                            <a14:backgroundMark x1="29236" y1="61135" x2="29236" y2="61135"/>
                            <a14:backgroundMark x1="30565" y1="62737" x2="30565" y2="62737"/>
                            <a14:backgroundMark x1="30565" y1="61281" x2="30565" y2="61281"/>
                            <a14:backgroundMark x1="29236" y1="59971" x2="30565" y2="57205"/>
                            <a14:backgroundMark x1="27907" y1="57205" x2="27243" y2="55604"/>
                            <a14:backgroundMark x1="27243" y1="55022" x2="26578" y2="53275"/>
                            <a14:backgroundMark x1="29236" y1="55750" x2="26578" y2="53421"/>
                            <a14:backgroundMark x1="24917" y1="54003" x2="25914" y2="51965"/>
                            <a14:backgroundMark x1="26578" y1="52547" x2="24917" y2="50801"/>
                            <a14:backgroundMark x1="25249" y1="51383" x2="23256" y2="49345"/>
                          </a14:backgroundRemoval>
                        </a14:imgEffect>
                      </a14:imgLayer>
                    </a14:imgProps>
                  </a:ext>
                </a:extLst>
              </a:blip>
              <a:srcRect t="1" b="276"/>
              <a:stretch/>
            </p:blipFill>
            <p:spPr>
              <a:xfrm rot="830650" flipH="1">
                <a:off x="3795820" y="1878373"/>
                <a:ext cx="545440" cy="1241463"/>
              </a:xfrm>
              <a:prstGeom prst="rect">
                <a:avLst/>
              </a:prstGeom>
            </p:spPr>
          </p:pic>
        </p:grpSp>
        <p:pic>
          <p:nvPicPr>
            <p:cNvPr id="172" name="Picture 2" descr="Cardio, equipment, gym, machine, running, treadmill, workout icon ...">
              <a:extLst>
                <a:ext uri="{FF2B5EF4-FFF2-40B4-BE49-F238E27FC236}">
                  <a16:creationId xmlns:a16="http://schemas.microsoft.com/office/drawing/2014/main" id="{B538AC54-07C3-E6A1-980C-B34CC063477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ackgroundRemoval t="9961" b="93945" l="781" r="97461">
                          <a14:foregroundMark x1="17086" y1="72266" x2="17117" y2="72612"/>
                          <a14:foregroundMark x1="16703" y1="67969" x2="16964" y2="70898"/>
                          <a14:foregroundMark x1="16589" y1="66701" x2="16598" y2="66797"/>
                          <a14:foregroundMark x1="16455" y1="65192" x2="16583" y2="66629"/>
                          <a14:foregroundMark x1="16283" y1="63265" x2="16300" y2="63458"/>
                          <a14:foregroundMark x1="16015" y1="60263" x2="16040" y2="60539"/>
                          <a14:foregroundMark x1="15723" y1="56998" x2="15858" y2="58501"/>
                          <a14:foregroundMark x1="15430" y1="53711" x2="15562" y2="55190"/>
                          <a14:foregroundMark x1="18606" y1="53501" x2="19085" y2="53221"/>
                          <a14:foregroundMark x1="68058" y1="46094" x2="68230" y2="46094"/>
                          <a14:foregroundMark x1="64684" y1="46094" x2="66300" y2="46094"/>
                          <a14:foregroundMark x1="61363" y1="46094" x2="62535" y2="46094"/>
                          <a14:foregroundMark x1="57318" y1="46094" x2="58629" y2="46094"/>
                          <a14:foregroundMark x1="56877" y1="46094" x2="57231" y2="46094"/>
                          <a14:foregroundMark x1="53996" y1="46094" x2="54776" y2="46094"/>
                          <a14:foregroundMark x1="75550" y1="40773" x2="83789" y2="29102"/>
                          <a14:foregroundMark x1="72070" y1="45703" x2="74665" y2="42027"/>
                          <a14:foregroundMark x1="76563" y1="45117" x2="83594" y2="62305"/>
                          <a14:foregroundMark x1="83594" y1="62305" x2="83594" y2="62695"/>
                          <a14:foregroundMark x1="86897" y1="82226" x2="87305" y2="83984"/>
                          <a14:foregroundMark x1="84998" y1="74041" x2="86882" y2="82159"/>
                          <a14:foregroundMark x1="81641" y1="59570" x2="84865" y2="73465"/>
                          <a14:foregroundMark x1="88477" y1="81836" x2="91602" y2="90234"/>
                          <a14:foregroundMark x1="6641" y1="89258" x2="61719" y2="89648"/>
                          <a14:foregroundMark x1="57886" y1="92966" x2="56292" y2="93117"/>
                          <a14:foregroundMark x1="66133" y1="92184" x2="60644" y2="92704"/>
                          <a14:foregroundMark x1="90820" y1="89844" x2="66148" y2="92182"/>
                          <a14:foregroundMark x1="89258" y1="90820" x2="97529" y2="86396"/>
                          <a14:foregroundMark x1="6351" y1="87568" x2="8108" y2="92137"/>
                          <a14:foregroundMark x1="2284" y1="90017" x2="1953" y2="91406"/>
                          <a14:foregroundMark x1="2867" y1="87568" x2="2538" y2="88952"/>
                          <a14:foregroundMark x1="16517" y1="75977" x2="16571" y2="78316"/>
                          <a14:foregroundMark x1="16433" y1="72266" x2="16473" y2="74023"/>
                          <a14:foregroundMark x1="45881" y1="47656" x2="46680" y2="47656"/>
                          <a14:foregroundMark x1="44460" y1="47656" x2="44823" y2="47656"/>
                          <a14:foregroundMark x1="42312" y1="47656" x2="42507" y2="47656"/>
                          <a14:foregroundMark x1="40234" y1="47656" x2="40945" y2="47656"/>
                          <a14:foregroundMark x1="47622" y1="47821" x2="48280" y2="47793"/>
                          <a14:foregroundMark x1="23205" y1="48211" x2="23438" y2="48047"/>
                          <a14:foregroundMark x1="16797" y1="52734" x2="23070" y2="48307"/>
                          <a14:foregroundMark x1="16406" y1="79883" x2="16797" y2="82813"/>
                          <a14:foregroundMark x1="781" y1="93750" x2="1563" y2="93945"/>
                          <a14:foregroundMark x1="35541" y1="47971" x2="36412" y2="48027"/>
                          <a14:foregroundMark x1="32932" y1="47802" x2="33104" y2="47813"/>
                          <a14:foregroundMark x1="51790" y1="47103" x2="53026" y2="47198"/>
                          <a14:foregroundMark x1="50233" y1="46983" x2="50859" y2="47031"/>
                          <a14:foregroundMark x1="48828" y1="46875" x2="49303" y2="46911"/>
                          <a14:foregroundMark x1="83398" y1="28516" x2="85547" y2="30859"/>
                          <a14:foregroundMark x1="86133" y1="28516" x2="84766" y2="27930"/>
                          <a14:foregroundMark x1="84766" y1="26953" x2="86719" y2="27734"/>
                          <a14:foregroundMark x1="84766" y1="26953" x2="85938" y2="27344"/>
                          <a14:foregroundMark x1="85352" y1="26563" x2="86523" y2="26953"/>
                          <a14:foregroundMark x1="25893" y1="47814" x2="26172" y2="49023"/>
                          <a14:foregroundMark x1="25586" y1="46484" x2="25710" y2="47019"/>
                          <a14:foregroundMark x1="33558" y1="48633" x2="33984" y2="48633"/>
                          <a14:foregroundMark x1="32313" y1="48633" x2="32582" y2="48633"/>
                          <a14:foregroundMark x1="29742" y1="48633" x2="31723" y2="48633"/>
                          <a14:foregroundMark x1="28381" y1="48633" x2="28814" y2="48633"/>
                          <a14:foregroundMark x1="26367" y1="48633" x2="27666" y2="48633"/>
                          <a14:backgroundMark x1="37500" y1="54297" x2="33594" y2="67188"/>
                          <a14:backgroundMark x1="38281" y1="55664" x2="35156" y2="70508"/>
                          <a14:backgroundMark x1="38672" y1="55859" x2="42188" y2="56250"/>
                          <a14:backgroundMark x1="38672" y1="52148" x2="52148" y2="51367"/>
                          <a14:backgroundMark x1="38281" y1="50781" x2="38281" y2="51953"/>
                          <a14:backgroundMark x1="52930" y1="51367" x2="59961" y2="60156"/>
                          <a14:backgroundMark x1="59961" y1="60156" x2="53320" y2="68750"/>
                          <a14:backgroundMark x1="53320" y1="68750" x2="50977" y2="58203"/>
                          <a14:backgroundMark x1="50977" y1="58203" x2="52344" y2="54688"/>
                          <a14:backgroundMark x1="52930" y1="50391" x2="58984" y2="55859"/>
                          <a14:backgroundMark x1="55859" y1="50781" x2="59375" y2="53125"/>
                          <a14:backgroundMark x1="60156" y1="51172" x2="70703" y2="66602"/>
                          <a14:backgroundMark x1="61719" y1="51953" x2="74609" y2="66211"/>
                          <a14:backgroundMark x1="74609" y1="66211" x2="74805" y2="66797"/>
                          <a14:backgroundMark x1="62500" y1="52148" x2="74219" y2="64453"/>
                          <a14:backgroundMark x1="62891" y1="50977" x2="72461" y2="57227"/>
                          <a14:backgroundMark x1="72461" y1="57227" x2="77148" y2="68750"/>
                          <a14:backgroundMark x1="77148" y1="68750" x2="76758" y2="81055"/>
                          <a14:backgroundMark x1="76758" y1="81055" x2="30859" y2="81836"/>
                          <a14:backgroundMark x1="30859" y1="81836" x2="20313" y2="74609"/>
                          <a14:backgroundMark x1="20313" y1="74609" x2="20508" y2="64648"/>
                          <a14:backgroundMark x1="20508" y1="64648" x2="24023" y2="53320"/>
                          <a14:backgroundMark x1="24023" y1="53320" x2="35352" y2="53125"/>
                          <a14:backgroundMark x1="35352" y1="53125" x2="41406" y2="53516"/>
                          <a14:backgroundMark x1="35352" y1="51563" x2="24609" y2="51563"/>
                          <a14:backgroundMark x1="27277" y1="51435" x2="20703" y2="53711"/>
                          <a14:backgroundMark x1="20703" y1="53711" x2="19727" y2="63477"/>
                          <a14:backgroundMark x1="19727" y1="63477" x2="20703" y2="67969"/>
                          <a14:backgroundMark x1="30781" y1="84051" x2="33203" y2="83984"/>
                          <a14:backgroundMark x1="22439" y1="84283" x2="29318" y2="84092"/>
                          <a14:backgroundMark x1="19141" y1="84375" x2="21102" y2="84320"/>
                          <a14:backgroundMark x1="33203" y1="83984" x2="72656" y2="84766"/>
                          <a14:backgroundMark x1="72656" y1="84766" x2="84570" y2="84180"/>
                          <a14:backgroundMark x1="84766" y1="84180" x2="73438" y2="51172"/>
                          <a14:backgroundMark x1="73242" y1="50781" x2="62109" y2="50586"/>
                          <a14:backgroundMark x1="68555" y1="50000" x2="64844" y2="50000"/>
                          <a14:backgroundMark x1="70508" y1="50000" x2="72266" y2="50000"/>
                          <a14:backgroundMark x1="74219" y1="50391" x2="74219" y2="53125"/>
                          <a14:backgroundMark x1="74414" y1="52344" x2="75781" y2="56250"/>
                          <a14:backgroundMark x1="74609" y1="52734" x2="78516" y2="62891"/>
                          <a14:backgroundMark x1="77734" y1="61523" x2="81641" y2="74414"/>
                          <a14:backgroundMark x1="19171" y1="82498" x2="19141" y2="84180"/>
                          <a14:backgroundMark x1="18945" y1="83008" x2="18908" y2="82533"/>
                          <a14:backgroundMark x1="18945" y1="70508" x2="18945" y2="69531"/>
                          <a14:backgroundMark x1="19336" y1="67188" x2="19141" y2="66211"/>
                          <a14:backgroundMark x1="18750" y1="66797" x2="18750" y2="67188"/>
                          <a14:backgroundMark x1="19922" y1="65820" x2="19922" y2="65820"/>
                          <a14:backgroundMark x1="19141" y1="61328" x2="18750" y2="63672"/>
                          <a14:backgroundMark x1="18945" y1="58203" x2="19141" y2="59180"/>
                          <a14:backgroundMark x1="19141" y1="58594" x2="19141" y2="59766"/>
                          <a14:backgroundMark x1="19141" y1="62109" x2="18945" y2="63281"/>
                          <a14:backgroundMark x1="19141" y1="54883" x2="23828" y2="50000"/>
                          <a14:backgroundMark x1="52076" y1="50000" x2="52734" y2="50000"/>
                          <a14:backgroundMark x1="55078" y1="50000" x2="56250" y2="49805"/>
                          <a14:backgroundMark x1="57813" y1="50000" x2="60156" y2="50195"/>
                          <a14:backgroundMark x1="20117" y1="84570" x2="20117" y2="84570"/>
                          <a14:backgroundMark x1="24609" y1="84570" x2="25781" y2="84570"/>
                          <a14:backgroundMark x1="28320" y1="84375" x2="29273" y2="84163"/>
                          <a14:backgroundMark x1="32617" y1="84375" x2="33594" y2="84375"/>
                          <a14:backgroundMark x1="36523" y1="84375" x2="37891" y2="84375"/>
                          <a14:backgroundMark x1="40039" y1="84570" x2="40625" y2="84570"/>
                          <a14:backgroundMark x1="43750" y1="84570" x2="44922" y2="84375"/>
                          <a14:backgroundMark x1="48047" y1="84570" x2="49219" y2="84570"/>
                          <a14:backgroundMark x1="50977" y1="84375" x2="53125" y2="84180"/>
                          <a14:backgroundMark x1="51953" y1="84375" x2="52930" y2="84375"/>
                          <a14:backgroundMark x1="55078" y1="84570" x2="56250" y2="84570"/>
                          <a14:backgroundMark x1="58984" y1="84375" x2="60156" y2="84375"/>
                          <a14:backgroundMark x1="82813" y1="84766" x2="83984" y2="84375"/>
                          <a14:backgroundMark x1="20703" y1="84375" x2="26367" y2="78906"/>
                          <a14:backgroundMark x1="21094" y1="84375" x2="22656" y2="84375"/>
                          <a14:backgroundMark x1="28125" y1="84375" x2="30078" y2="84375"/>
                          <a14:backgroundMark x1="62500" y1="50391" x2="63672" y2="50391"/>
                          <a14:backgroundMark x1="62500" y1="50195" x2="63672" y2="50195"/>
                          <a14:backgroundMark x1="14075" y1="71146" x2="14648" y2="52344"/>
                          <a14:backgroundMark x1="13672" y1="84375" x2="13813" y2="79751"/>
                          <a14:backgroundMark x1="19531" y1="72461" x2="19922" y2="78711"/>
                          <a14:backgroundMark x1="19336" y1="74219" x2="19336" y2="75000"/>
                          <a14:backgroundMark x1="18945" y1="74023" x2="18945" y2="74805"/>
                          <a14:backgroundMark x1="18945" y1="77734" x2="19141" y2="78516"/>
                          <a14:backgroundMark x1="18945" y1="78320" x2="18945" y2="79688"/>
                          <a14:backgroundMark x1="14063" y1="80193" x2="14063" y2="78516"/>
                          <a14:backgroundMark x1="14258" y1="76953" x2="14453" y2="74609"/>
                          <a14:backgroundMark x1="14258" y1="72266" x2="14063" y2="71289"/>
                          <a14:backgroundMark x1="13867" y1="68750" x2="14063" y2="66406"/>
                          <a14:backgroundMark x1="14063" y1="64453" x2="2734" y2="73633"/>
                          <a14:backgroundMark x1="2734" y1="73633" x2="5078" y2="42969"/>
                          <a14:backgroundMark x1="5859" y1="66797" x2="6250" y2="39844"/>
                          <a14:backgroundMark x1="6250" y1="39844" x2="6250" y2="39844"/>
                          <a14:backgroundMark x1="9570" y1="57813" x2="8398" y2="32813"/>
                          <a14:backgroundMark x1="8398" y1="32813" x2="8398" y2="32813"/>
                          <a14:backgroundMark x1="10938" y1="54688" x2="15039" y2="27344"/>
                          <a14:backgroundMark x1="12109" y1="47266" x2="23438" y2="27539"/>
                          <a14:backgroundMark x1="23438" y1="27539" x2="24219" y2="23828"/>
                          <a14:backgroundMark x1="17188" y1="43555" x2="31641" y2="42383"/>
                          <a14:backgroundMark x1="31641" y1="42383" x2="45508" y2="42383"/>
                          <a14:backgroundMark x1="31055" y1="40234" x2="44531" y2="24414"/>
                          <a14:backgroundMark x1="44531" y1="24414" x2="44727" y2="22266"/>
                          <a14:backgroundMark x1="39844" y1="41211" x2="53906" y2="44141"/>
                          <a14:backgroundMark x1="50266" y1="44727" x2="19336" y2="44727"/>
                          <a14:backgroundMark x1="34976" y1="50672" x2="36523" y2="50391"/>
                          <a14:backgroundMark x1="39453" y1="50000" x2="40820" y2="50000"/>
                          <a14:backgroundMark x1="43359" y1="50195" x2="44531" y2="50000"/>
                          <a14:backgroundMark x1="46875" y1="50000" x2="48828" y2="50000"/>
                          <a14:backgroundMark x1="43750" y1="45703" x2="45703" y2="45703"/>
                          <a14:backgroundMark x1="40625" y1="45313" x2="41211" y2="45313"/>
                          <a14:backgroundMark x1="48047" y1="45313" x2="49219" y2="45313"/>
                          <a14:backgroundMark x1="55273" y1="45313" x2="56641" y2="45313"/>
                          <a14:backgroundMark x1="24609" y1="45313" x2="25977" y2="45313"/>
                          <a14:backgroundMark x1="29297" y1="44922" x2="30078" y2="44922"/>
                          <a14:backgroundMark x1="28516" y1="45117" x2="29688" y2="45117"/>
                          <a14:backgroundMark x1="32031" y1="45313" x2="32220" y2="45313"/>
                          <a14:backgroundMark x1="21680" y1="45117" x2="18555" y2="46289"/>
                          <a14:backgroundMark x1="21875" y1="45313" x2="19922" y2="45898"/>
                          <a14:backgroundMark x1="15625" y1="50000" x2="14648" y2="53125"/>
                          <a14:backgroundMark x1="13672" y1="52734" x2="13086" y2="49609"/>
                          <a14:backgroundMark x1="13477" y1="49023" x2="17969" y2="45703"/>
                          <a14:backgroundMark x1="28516" y1="45117" x2="29883" y2="45117"/>
                          <a14:backgroundMark x1="19141" y1="54688" x2="19141" y2="55664"/>
                          <a14:backgroundMark x1="18945" y1="54492" x2="19922" y2="55859"/>
                          <a14:backgroundMark x1="19141" y1="54688" x2="19141" y2="55859"/>
                          <a14:backgroundMark x1="49219" y1="39453" x2="49609" y2="41016"/>
                          <a14:backgroundMark x1="48828" y1="35742" x2="53711" y2="37891"/>
                          <a14:backgroundMark x1="51563" y1="36133" x2="55664" y2="35938"/>
                          <a14:backgroundMark x1="50000" y1="43359" x2="60742" y2="33008"/>
                          <a14:backgroundMark x1="60742" y1="33008" x2="61719" y2="28320"/>
                          <a14:backgroundMark x1="56641" y1="37500" x2="55469" y2="35938"/>
                          <a14:backgroundMark x1="59180" y1="34961" x2="53320" y2="40234"/>
                          <a14:backgroundMark x1="52344" y1="41602" x2="55273" y2="39648"/>
                          <a14:backgroundMark x1="55859" y1="42969" x2="70703" y2="23633"/>
                          <a14:backgroundMark x1="64453" y1="33008" x2="80859" y2="16602"/>
                          <a14:backgroundMark x1="60938" y1="36328" x2="79688" y2="18555"/>
                          <a14:backgroundMark x1="61719" y1="36328" x2="66406" y2="32813"/>
                          <a14:backgroundMark x1="66406" y1="31641" x2="67773" y2="30469"/>
                          <a14:backgroundMark x1="63672" y1="30859" x2="63281" y2="27734"/>
                          <a14:backgroundMark x1="57227" y1="27930" x2="59766" y2="26758"/>
                          <a14:backgroundMark x1="59766" y1="26563" x2="66797" y2="21484"/>
                          <a14:backgroundMark x1="63086" y1="22852" x2="66797" y2="19531"/>
                          <a14:backgroundMark x1="13672" y1="71875" x2="1563" y2="84180"/>
                          <a14:backgroundMark x1="1563" y1="84180" x2="2344" y2="84375"/>
                          <a14:backgroundMark x1="1172" y1="84180" x2="2148" y2="84180"/>
                          <a14:backgroundMark x1="5078" y1="84375" x2="13867" y2="76367"/>
                          <a14:backgroundMark x1="13867" y1="76367" x2="13867" y2="75781"/>
                          <a14:backgroundMark x1="20508" y1="81250" x2="19141" y2="82031"/>
                          <a14:backgroundMark x1="12500" y1="81055" x2="9766" y2="83984"/>
                          <a14:backgroundMark x1="9766" y1="84570" x2="8594" y2="84570"/>
                          <a14:backgroundMark x1="6836" y1="84180" x2="4688" y2="84375"/>
                          <a14:backgroundMark x1="0" y1="85352" x2="0" y2="86328"/>
                          <a14:backgroundMark x1="0" y1="89453" x2="195" y2="90430"/>
                          <a14:backgroundMark x1="195" y1="93164" x2="0" y2="94141"/>
                          <a14:backgroundMark x1="1172" y1="96094" x2="3516" y2="95313"/>
                          <a14:backgroundMark x1="1563" y1="95313" x2="4297" y2="94922"/>
                          <a14:backgroundMark x1="1953" y1="95313" x2="3125" y2="95313"/>
                          <a14:backgroundMark x1="1953" y1="95703" x2="0" y2="97266"/>
                          <a14:backgroundMark x1="4883" y1="95703" x2="95703" y2="96094"/>
                          <a14:backgroundMark x1="95703" y1="96094" x2="98828" y2="96094"/>
                          <a14:backgroundMark x1="5469" y1="95117" x2="7031" y2="94922"/>
                          <a14:backgroundMark x1="9961" y1="95313" x2="11328" y2="95313"/>
                          <a14:backgroundMark x1="9570" y1="94727" x2="11328" y2="94922"/>
                          <a14:backgroundMark x1="13281" y1="95117" x2="15430" y2="94922"/>
                          <a14:backgroundMark x1="17578" y1="94922" x2="19531" y2="94922"/>
                          <a14:backgroundMark x1="21094" y1="95117" x2="22852" y2="95117"/>
                          <a14:backgroundMark x1="25000" y1="95313" x2="27148" y2="94922"/>
                          <a14:backgroundMark x1="28516" y1="95313" x2="31055" y2="95313"/>
                          <a14:backgroundMark x1="29297" y1="95117" x2="30273" y2="95117"/>
                          <a14:backgroundMark x1="32422" y1="95313" x2="35156" y2="95117"/>
                          <a14:backgroundMark x1="33398" y1="95117" x2="34180" y2="95117"/>
                          <a14:backgroundMark x1="30469" y1="95117" x2="31250" y2="95117"/>
                          <a14:backgroundMark x1="25781" y1="94922" x2="26563" y2="94922"/>
                          <a14:backgroundMark x1="36719" y1="95313" x2="39063" y2="95313"/>
                          <a14:backgroundMark x1="37305" y1="95117" x2="38867" y2="94922"/>
                          <a14:backgroundMark x1="40625" y1="95117" x2="43359" y2="95117"/>
                          <a14:backgroundMark x1="44531" y1="95313" x2="46484" y2="94922"/>
                          <a14:backgroundMark x1="44922" y1="94922" x2="46094" y2="94922"/>
                          <a14:backgroundMark x1="48438" y1="95117" x2="50391" y2="95117"/>
                          <a14:backgroundMark x1="51367" y1="94922" x2="54688" y2="94922"/>
                          <a14:backgroundMark x1="56641" y1="95313" x2="58984" y2="95313"/>
                          <a14:backgroundMark x1="56641" y1="94922" x2="58008" y2="94922"/>
                          <a14:backgroundMark x1="60352" y1="95117" x2="62695" y2="95117"/>
                          <a14:backgroundMark x1="64258" y1="94922" x2="66016" y2="95117"/>
                          <a14:backgroundMark x1="67969" y1="95313" x2="70117" y2="95313"/>
                          <a14:backgroundMark x1="68750" y1="94922" x2="69531" y2="94922"/>
                          <a14:backgroundMark x1="71875" y1="95313" x2="74023" y2="95313"/>
                          <a14:backgroundMark x1="72656" y1="94922" x2="73633" y2="94922"/>
                          <a14:backgroundMark x1="75586" y1="95313" x2="78125" y2="95117"/>
                          <a14:backgroundMark x1="76367" y1="95117" x2="77539" y2="94922"/>
                          <a14:backgroundMark x1="79688" y1="95313" x2="82227" y2="95313"/>
                          <a14:backgroundMark x1="1758" y1="95313" x2="3906" y2="95313"/>
                          <a14:backgroundMark x1="1953" y1="95313" x2="3711" y2="95313"/>
                          <a14:backgroundMark x1="2148" y1="94922" x2="4883" y2="94922"/>
                          <a14:backgroundMark x1="79883" y1="95117" x2="81641" y2="95117"/>
                          <a14:backgroundMark x1="83594" y1="95117" x2="85742" y2="95117"/>
                          <a14:backgroundMark x1="87695" y1="95313" x2="89844" y2="94922"/>
                          <a14:backgroundMark x1="87891" y1="95313" x2="90430" y2="95313"/>
                          <a14:backgroundMark x1="87891" y1="95313" x2="90625" y2="95117"/>
                          <a14:backgroundMark x1="91016" y1="95313" x2="94141" y2="95313"/>
                          <a14:backgroundMark x1="91992" y1="95117" x2="94336" y2="94727"/>
                          <a14:backgroundMark x1="95703" y1="95313" x2="98047" y2="95117"/>
                          <a14:backgroundMark x1="95313" y1="95117" x2="97656" y2="95313"/>
                          <a14:backgroundMark x1="99609" y1="95703" x2="99805" y2="95117"/>
                          <a14:backgroundMark x1="99219" y1="83984" x2="99805" y2="85938"/>
                          <a14:backgroundMark x1="98242" y1="84375" x2="99414" y2="84570"/>
                          <a14:backgroundMark x1="99219" y1="83594" x2="99609" y2="83594"/>
                          <a14:backgroundMark x1="94141" y1="84375" x2="96094" y2="84570"/>
                          <a14:backgroundMark x1="95703" y1="83984" x2="98828" y2="81836"/>
                          <a14:backgroundMark x1="94922" y1="83789" x2="95898" y2="84375"/>
                          <a14:backgroundMark x1="95703" y1="83594" x2="99805" y2="80859"/>
                          <a14:backgroundMark x1="96875" y1="81055" x2="99609" y2="80273"/>
                          <a14:backgroundMark x1="99609" y1="79883" x2="99609" y2="78125"/>
                          <a14:backgroundMark x1="80273" y1="40234" x2="94141" y2="83203"/>
                          <a14:backgroundMark x1="80859" y1="39648" x2="99805" y2="25391"/>
                          <a14:backgroundMark x1="84180" y1="37109" x2="99805" y2="21289"/>
                          <a14:backgroundMark x1="96680" y1="23438" x2="93164" y2="28125"/>
                          <a14:backgroundMark x1="91797" y1="28906" x2="87109" y2="33008"/>
                          <a14:backgroundMark x1="86914" y1="32422" x2="83984" y2="36719"/>
                          <a14:backgroundMark x1="87207" y1="30638" x2="99805" y2="18750"/>
                          <a14:backgroundMark x1="85938" y1="31836" x2="86727" y2="31091"/>
                          <a14:backgroundMark x1="88293" y1="28822" x2="91602" y2="24219"/>
                          <a14:backgroundMark x1="87109" y1="30469" x2="88235" y2="28902"/>
                          <a14:backgroundMark x1="92188" y1="25000" x2="96680" y2="20703"/>
                          <a14:backgroundMark x1="94336" y1="22656" x2="97070" y2="19141"/>
                          <a14:backgroundMark x1="88275" y1="24959" x2="95703" y2="18945"/>
                          <a14:backgroundMark x1="95703" y1="18945" x2="99414" y2="10547"/>
                          <a14:backgroundMark x1="66797" y1="45313" x2="68555" y2="45313"/>
                          <a14:backgroundMark x1="68555" y1="45313" x2="76367" y2="36719"/>
                          <a14:backgroundMark x1="73828" y1="38867" x2="70703" y2="40430"/>
                          <a14:backgroundMark x1="58594" y1="43164" x2="70508" y2="35352"/>
                          <a14:backgroundMark x1="70508" y1="35352" x2="92578" y2="12695"/>
                          <a14:backgroundMark x1="83313" y1="24987" x2="84375" y2="23828"/>
                          <a14:backgroundMark x1="75781" y1="33203" x2="83289" y2="25013"/>
                          <a14:backgroundMark x1="75391" y1="33984" x2="78516" y2="31836"/>
                          <a14:backgroundMark x1="78906" y1="31055" x2="80859" y2="29297"/>
                          <a14:backgroundMark x1="81250" y1="28906" x2="81641" y2="27930"/>
                          <a14:backgroundMark x1="83008" y1="26563" x2="84570" y2="25391"/>
                          <a14:backgroundMark x1="82617" y1="26953" x2="82031" y2="27734"/>
                          <a14:backgroundMark x1="71094" y1="38281" x2="66797" y2="41211"/>
                          <a14:backgroundMark x1="63477" y1="45117" x2="65039" y2="45117"/>
                          <a14:backgroundMark x1="59375" y1="44922" x2="62109" y2="44922"/>
                          <a14:backgroundMark x1="58984" y1="45313" x2="61133" y2="45313"/>
                          <a14:backgroundMark x1="63281" y1="44922" x2="65430" y2="44922"/>
                          <a14:backgroundMark x1="56641" y1="45117" x2="57617" y2="44531"/>
                          <a14:backgroundMark x1="51953" y1="45313" x2="52930" y2="45313"/>
                          <a14:backgroundMark x1="63281" y1="45313" x2="64844" y2="45117"/>
                          <a14:backgroundMark x1="63477" y1="45313" x2="64844" y2="45313"/>
                          <a14:backgroundMark x1="35547" y1="45508" x2="37109" y2="45508"/>
                          <a14:backgroundMark x1="32031" y1="44922" x2="34766" y2="44922"/>
                          <a14:backgroundMark x1="28125" y1="44922" x2="29688" y2="44922"/>
                          <a14:backgroundMark x1="27734" y1="44922" x2="30469" y2="44922"/>
                          <a14:backgroundMark x1="35156" y1="50000" x2="36328" y2="50000"/>
                          <a14:backgroundMark x1="26172" y1="51953" x2="27734" y2="50195"/>
                          <a14:backgroundMark x1="29883" y1="51563" x2="31836" y2="50391"/>
                          <a14:backgroundMark x1="30859" y1="50391" x2="31641" y2="50000"/>
                          <a14:backgroundMark x1="14063" y1="84375" x2="13867" y2="83203"/>
                          <a14:backgroundMark x1="14258" y1="83789" x2="14258" y2="82813"/>
                          <a14:backgroundMark x1="13477" y1="84570" x2="12305" y2="84570"/>
                          <a14:backgroundMark x1="12500" y1="84570" x2="13477" y2="84766"/>
                          <a14:backgroundMark x1="12305" y1="84570" x2="13086" y2="84570"/>
                          <a14:backgroundMark x1="11914" y1="84766" x2="13281" y2="84766"/>
                          <a14:backgroundMark x1="8398" y1="84766" x2="12891" y2="84766"/>
                          <a14:backgroundMark x1="1172" y1="84766" x2="8984" y2="84766"/>
                          <a14:backgroundMark x1="18945" y1="84961" x2="85156" y2="84961"/>
                          <a14:backgroundMark x1="18750" y1="54492" x2="19141" y2="56250"/>
                          <a14:backgroundMark x1="18555" y1="55273" x2="18555" y2="56445"/>
                          <a14:backgroundMark x1="18555" y1="58203" x2="18750" y2="59961"/>
                          <a14:backgroundMark x1="18555" y1="70703" x2="18750" y2="71680"/>
                          <a14:backgroundMark x1="18555" y1="71484" x2="18555" y2="72266"/>
                          <a14:backgroundMark x1="18555" y1="67188" x2="18555" y2="67969"/>
                          <a14:backgroundMark x1="14453" y1="66992" x2="14453" y2="67773"/>
                          <a14:backgroundMark x1="14453" y1="70898" x2="14453" y2="71875"/>
                          <a14:backgroundMark x1="14258" y1="78906" x2="14453" y2="79688"/>
                          <a14:backgroundMark x1="18555" y1="78906" x2="18555" y2="79688"/>
                          <a14:backgroundMark x1="18555" y1="82813" x2="18750" y2="83594"/>
                          <a14:backgroundMark x1="18555" y1="83398" x2="18750" y2="83789"/>
                          <a14:backgroundMark x1="18555" y1="75000" x2="18555" y2="75977"/>
                          <a14:backgroundMark x1="18555" y1="63086" x2="18750" y2="64258"/>
                          <a14:backgroundMark x1="18555" y1="63867" x2="18750" y2="64453"/>
                          <a14:backgroundMark x1="18555" y1="59180" x2="19141" y2="60156"/>
                          <a14:backgroundMark x1="18555" y1="59570" x2="18945" y2="60352"/>
                          <a14:backgroundMark x1="28125" y1="45508" x2="29297" y2="45703"/>
                          <a14:backgroundMark x1="32227" y1="45508" x2="33398" y2="45508"/>
                          <a14:backgroundMark x1="23828" y1="50000" x2="25000" y2="50000"/>
                          <a14:backgroundMark x1="24023" y1="50000" x2="25000" y2="49805"/>
                          <a14:backgroundMark x1="23828" y1="50000" x2="24609" y2="50000"/>
                          <a14:backgroundMark x1="24219" y1="49805" x2="24023" y2="49805"/>
                          <a14:backgroundMark x1="27930" y1="49805" x2="28711" y2="50000"/>
                          <a14:backgroundMark x1="28516" y1="49805" x2="28906" y2="49805"/>
                          <a14:backgroundMark x1="31836" y1="49805" x2="32813" y2="49805"/>
                          <a14:backgroundMark x1="35742" y1="50000" x2="36719" y2="49805"/>
                          <a14:backgroundMark x1="35938" y1="49805" x2="35742" y2="50000"/>
                          <a14:backgroundMark x1="39648" y1="50000" x2="40625" y2="50000"/>
                          <a14:backgroundMark x1="40820" y1="49805" x2="39844" y2="50000"/>
                          <a14:backgroundMark x1="39648" y1="49805" x2="40234" y2="49805"/>
                          <a14:backgroundMark x1="43750" y1="49805" x2="44336" y2="49805"/>
                          <a14:backgroundMark x1="47461" y1="49805" x2="48438" y2="49805"/>
                          <a14:backgroundMark x1="51367" y1="49805" x2="52344" y2="49805"/>
                          <a14:backgroundMark x1="55273" y1="49805" x2="55664" y2="49805"/>
                          <a14:backgroundMark x1="59180" y1="49805" x2="59961" y2="49805"/>
                          <a14:backgroundMark x1="63086" y1="49805" x2="63867" y2="49805"/>
                          <a14:backgroundMark x1="67188" y1="49805" x2="68164" y2="49805"/>
                          <a14:backgroundMark x1="70898" y1="49805" x2="71680" y2="49805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7" t="22809" r="475" b="5516"/>
            <a:stretch/>
          </p:blipFill>
          <p:spPr bwMode="auto">
            <a:xfrm flipH="1">
              <a:off x="542023" y="3226038"/>
              <a:ext cx="1135089" cy="97451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C915B7F9-64C2-2F19-C78F-44E322844756}"/>
              </a:ext>
            </a:extLst>
          </p:cNvPr>
          <p:cNvGrpSpPr/>
          <p:nvPr/>
        </p:nvGrpSpPr>
        <p:grpSpPr>
          <a:xfrm>
            <a:off x="503823" y="821845"/>
            <a:ext cx="1691611" cy="1233881"/>
            <a:chOff x="73511" y="1594570"/>
            <a:chExt cx="1691611" cy="1233881"/>
          </a:xfrm>
        </p:grpSpPr>
        <p:grpSp>
          <p:nvGrpSpPr>
            <p:cNvPr id="179" name="Group 178">
              <a:extLst>
                <a:ext uri="{FF2B5EF4-FFF2-40B4-BE49-F238E27FC236}">
                  <a16:creationId xmlns:a16="http://schemas.microsoft.com/office/drawing/2014/main" id="{B8772E69-AE5C-E67A-D82F-780560019ED9}"/>
                </a:ext>
              </a:extLst>
            </p:cNvPr>
            <p:cNvGrpSpPr/>
            <p:nvPr/>
          </p:nvGrpSpPr>
          <p:grpSpPr>
            <a:xfrm>
              <a:off x="73511" y="1616194"/>
              <a:ext cx="1691611" cy="1212257"/>
              <a:chOff x="2405141" y="4694926"/>
              <a:chExt cx="1846638" cy="1282687"/>
            </a:xfrm>
          </p:grpSpPr>
          <p:sp>
            <p:nvSpPr>
              <p:cNvPr id="181" name="Isosceles Triangle 180">
                <a:extLst>
                  <a:ext uri="{FF2B5EF4-FFF2-40B4-BE49-F238E27FC236}">
                    <a16:creationId xmlns:a16="http://schemas.microsoft.com/office/drawing/2014/main" id="{E6C0BEC2-6ADD-AE50-F547-BD7BF65908FB}"/>
                  </a:ext>
                </a:extLst>
              </p:cNvPr>
              <p:cNvSpPr/>
              <p:nvPr/>
            </p:nvSpPr>
            <p:spPr>
              <a:xfrm rot="6487704">
                <a:off x="3915727" y="5246998"/>
                <a:ext cx="182880" cy="489225"/>
              </a:xfrm>
              <a:prstGeom prst="triangle">
                <a:avLst/>
              </a:prstGeom>
              <a:solidFill>
                <a:srgbClr val="FFABA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83" name="Rectangle: Rounded Corners 182">
                <a:extLst>
                  <a:ext uri="{FF2B5EF4-FFF2-40B4-BE49-F238E27FC236}">
                    <a16:creationId xmlns:a16="http://schemas.microsoft.com/office/drawing/2014/main" id="{CFF5DD40-A2D9-AD83-A6BA-72FE3570AA2C}"/>
                  </a:ext>
                </a:extLst>
              </p:cNvPr>
              <p:cNvSpPr/>
              <p:nvPr/>
            </p:nvSpPr>
            <p:spPr>
              <a:xfrm>
                <a:off x="2405141" y="4694926"/>
                <a:ext cx="1422087" cy="1282687"/>
              </a:xfrm>
              <a:prstGeom prst="roundRect">
                <a:avLst/>
              </a:prstGeom>
              <a:solidFill>
                <a:srgbClr val="FFEBE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82" name="TextBox 181">
                <a:extLst>
                  <a:ext uri="{FF2B5EF4-FFF2-40B4-BE49-F238E27FC236}">
                    <a16:creationId xmlns:a16="http://schemas.microsoft.com/office/drawing/2014/main" id="{33DD94EC-7537-A352-52AF-0DBD4A1703B6}"/>
                  </a:ext>
                </a:extLst>
              </p:cNvPr>
              <p:cNvSpPr txBox="1"/>
              <p:nvPr/>
            </p:nvSpPr>
            <p:spPr>
              <a:xfrm>
                <a:off x="2410084" y="4786058"/>
                <a:ext cx="988161" cy="10095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r>
                  <a:rPr lang="en-US" sz="14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r Muscle Mass/</a:t>
                </a:r>
              </a:p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eight</a:t>
                </a:r>
                <a:r>
                  <a:rPr lang="en-US" sz="1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80" name="Picture 179">
              <a:extLst>
                <a:ext uri="{FF2B5EF4-FFF2-40B4-BE49-F238E27FC236}">
                  <a16:creationId xmlns:a16="http://schemas.microsoft.com/office/drawing/2014/main" id="{1E7B4C51-A75C-0461-9601-16881F740F8F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ackgroundRemoval t="5442" b="94966" l="9843" r="89764">
                          <a14:foregroundMark x1="19685" y1="10204" x2="56693" y2="9524"/>
                          <a14:foregroundMark x1="56693" y1="9524" x2="74803" y2="16054"/>
                          <a14:foregroundMark x1="74803" y1="16054" x2="87008" y2="25306"/>
                          <a14:foregroundMark x1="87008" y1="25306" x2="87402" y2="26122"/>
                          <a14:foregroundMark x1="31102" y1="8299" x2="24016" y2="8163"/>
                          <a14:foregroundMark x1="36614" y1="7075" x2="27953" y2="6395"/>
                          <a14:foregroundMark x1="31102" y1="5986" x2="25984" y2="5850"/>
                          <a14:foregroundMark x1="33071" y1="5578" x2="27953" y2="5578"/>
                          <a14:foregroundMark x1="9055" y1="33197" x2="9268" y2="65018"/>
                          <a14:foregroundMark x1="51216" y1="94202" x2="61811" y2="84354"/>
                          <a14:foregroundMark x1="15748" y1="77279" x2="17717" y2="85986"/>
                          <a14:foregroundMark x1="17717" y1="85986" x2="27165" y2="93469"/>
                          <a14:foregroundMark x1="52311" y1="94673" x2="52756" y2="94694"/>
                          <a14:foregroundMark x1="27165" y1="93469" x2="48946" y2="94512"/>
                          <a14:foregroundMark x1="56113" y1="93422" x2="64961" y2="90068"/>
                          <a14:backgroundMark x1="5118" y1="65170" x2="7087" y2="71565"/>
                          <a14:backgroundMark x1="6693" y1="74014" x2="394" y2="88844"/>
                          <a14:backgroundMark x1="10630" y1="72245" x2="10630" y2="77007"/>
                          <a14:backgroundMark x1="9449" y1="72245" x2="9843" y2="72653"/>
                          <a14:backgroundMark x1="9055" y1="70612" x2="12205" y2="75238"/>
                          <a14:backgroundMark x1="5118" y1="80952" x2="4331" y2="92653"/>
                          <a14:backgroundMark x1="4331" y1="92653" x2="3937" y2="92517"/>
                          <a14:backgroundMark x1="19371" y1="93081" x2="13386" y2="92789"/>
                          <a14:backgroundMark x1="13386" y1="92789" x2="7087" y2="90748"/>
                          <a14:backgroundMark x1="53150" y1="94830" x2="54331" y2="94558"/>
                          <a14:backgroundMark x1="53543" y1="96190" x2="53543" y2="96190"/>
                          <a14:backgroundMark x1="51575" y1="95374" x2="56299" y2="95374"/>
                          <a14:backgroundMark x1="53937" y1="95374" x2="51575" y2="95646"/>
                          <a14:backgroundMark x1="51969" y1="95646" x2="55906" y2="95238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44818" y="1594570"/>
              <a:ext cx="413299" cy="1233880"/>
            </a:xfrm>
            <a:prstGeom prst="rect">
              <a:avLst/>
            </a:prstGeom>
            <a:effectLst>
              <a:softEdge rad="19050"/>
            </a:effectLst>
          </p:spPr>
        </p:pic>
      </p:grpSp>
      <p:grpSp>
        <p:nvGrpSpPr>
          <p:cNvPr id="185" name="Group 184">
            <a:extLst>
              <a:ext uri="{FF2B5EF4-FFF2-40B4-BE49-F238E27FC236}">
                <a16:creationId xmlns:a16="http://schemas.microsoft.com/office/drawing/2014/main" id="{6C86BAF1-C36B-5757-B5BE-FBE50555B867}"/>
              </a:ext>
            </a:extLst>
          </p:cNvPr>
          <p:cNvGrpSpPr/>
          <p:nvPr/>
        </p:nvGrpSpPr>
        <p:grpSpPr>
          <a:xfrm>
            <a:off x="2029935" y="882494"/>
            <a:ext cx="2261615" cy="2189990"/>
            <a:chOff x="5065742" y="1685165"/>
            <a:chExt cx="2468880" cy="2317225"/>
          </a:xfrm>
          <a:noFill/>
        </p:grpSpPr>
        <p:sp>
          <p:nvSpPr>
            <p:cNvPr id="187" name="Oval 186">
              <a:extLst>
                <a:ext uri="{FF2B5EF4-FFF2-40B4-BE49-F238E27FC236}">
                  <a16:creationId xmlns:a16="http://schemas.microsoft.com/office/drawing/2014/main" id="{E838BB57-2611-9005-3119-7EDF5B431B26}"/>
                </a:ext>
              </a:extLst>
            </p:cNvPr>
            <p:cNvSpPr/>
            <p:nvPr/>
          </p:nvSpPr>
          <p:spPr>
            <a:xfrm>
              <a:off x="5065742" y="1685165"/>
              <a:ext cx="2468880" cy="2317225"/>
            </a:xfrm>
            <a:prstGeom prst="ellipse">
              <a:avLst/>
            </a:prstGeom>
            <a:solidFill>
              <a:schemeClr val="bg1"/>
            </a:solidFill>
            <a:ln w="57150">
              <a:solidFill>
                <a:srgbClr val="DAE3F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grpSp>
          <p:nvGrpSpPr>
            <p:cNvPr id="188" name="Group 187">
              <a:extLst>
                <a:ext uri="{FF2B5EF4-FFF2-40B4-BE49-F238E27FC236}">
                  <a16:creationId xmlns:a16="http://schemas.microsoft.com/office/drawing/2014/main" id="{4F5141C7-B13D-4699-1815-5940F4001011}"/>
                </a:ext>
              </a:extLst>
            </p:cNvPr>
            <p:cNvGrpSpPr/>
            <p:nvPr/>
          </p:nvGrpSpPr>
          <p:grpSpPr>
            <a:xfrm>
              <a:off x="5299011" y="2254495"/>
              <a:ext cx="2109318" cy="1499190"/>
              <a:chOff x="5298372" y="63958"/>
              <a:chExt cx="1718682" cy="1266875"/>
            </a:xfrm>
            <a:grpFill/>
          </p:grpSpPr>
          <p:sp>
            <p:nvSpPr>
              <p:cNvPr id="189" name="TextBox 188">
                <a:extLst>
                  <a:ext uri="{FF2B5EF4-FFF2-40B4-BE49-F238E27FC236}">
                    <a16:creationId xmlns:a16="http://schemas.microsoft.com/office/drawing/2014/main" id="{78B271E1-9581-F0D1-F9BB-96CE78F69FA4}"/>
                  </a:ext>
                </a:extLst>
              </p:cNvPr>
              <p:cNvSpPr txBox="1"/>
              <p:nvPr/>
            </p:nvSpPr>
            <p:spPr>
              <a:xfrm>
                <a:off x="5298372" y="1055639"/>
                <a:ext cx="1718682" cy="275194"/>
              </a:xfrm>
              <a:prstGeom prst="rect">
                <a:avLst/>
              </a:prstGeom>
              <a:grp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Primary Outcome</a:t>
                </a:r>
              </a:p>
            </p:txBody>
          </p:sp>
          <p:pic>
            <p:nvPicPr>
              <p:cNvPr id="190" name="Picture 189">
                <a:extLst>
                  <a:ext uri="{FF2B5EF4-FFF2-40B4-BE49-F238E27FC236}">
                    <a16:creationId xmlns:a16="http://schemas.microsoft.com/office/drawing/2014/main" id="{CF5C4F49-29E1-BCCC-330E-7BB81E36AD1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>
                <a:alphaModFix/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ackgroundRemoval t="4459" b="98408" l="3814" r="96186">
                            <a14:foregroundMark x1="9534" y1="17516" x2="9534" y2="17516"/>
                            <a14:foregroundMark x1="3814" y1="45860" x2="3814" y2="45860"/>
                            <a14:foregroundMark x1="11864" y1="93631" x2="11864" y2="93631"/>
                            <a14:foregroundMark x1="12500" y1="98726" x2="12500" y2="98726"/>
                            <a14:foregroundMark x1="51907" y1="70382" x2="51907" y2="70382"/>
                            <a14:foregroundMark x1="54449" y1="61783" x2="54449" y2="61783"/>
                            <a14:foregroundMark x1="32415" y1="4459" x2="32415" y2="4459"/>
                            <a14:foregroundMark x1="80297" y1="4459" x2="80297" y2="4459"/>
                            <a14:foregroundMark x1="92161" y1="10191" x2="92161" y2="10191"/>
                            <a14:foregroundMark x1="96186" y1="14331" x2="96186" y2="14331"/>
                          </a14:backgroundRemoval>
                        </a14:imgEffect>
                      </a14:imgLayer>
                    </a14:imgProps>
                  </a:ext>
                </a:extLst>
              </a:blip>
              <a:srcRect r="-2999"/>
              <a:stretch/>
            </p:blipFill>
            <p:spPr>
              <a:xfrm>
                <a:off x="5401903" y="63958"/>
                <a:ext cx="1506458" cy="1013243"/>
              </a:xfrm>
              <a:prstGeom prst="rect">
                <a:avLst/>
              </a:prstGeom>
              <a:grpFill/>
              <a:ln>
                <a:noFill/>
              </a:ln>
            </p:spPr>
          </p:pic>
        </p:grp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E43CE3C7-91E2-21C6-D58C-E16741F16F7B}"/>
              </a:ext>
            </a:extLst>
          </p:cNvPr>
          <p:cNvSpPr txBox="1"/>
          <p:nvPr/>
        </p:nvSpPr>
        <p:spPr>
          <a:xfrm>
            <a:off x="4411299" y="4076823"/>
            <a:ext cx="46488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39701" indent="-139701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Only in those with a high waist circumference</a:t>
            </a:r>
          </a:p>
          <a:p>
            <a:pPr marL="139701" indent="-139701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Attenuated following adjustment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69CF30A4-12DC-3A6E-75F0-16ECDCB5B17C}"/>
              </a:ext>
            </a:extLst>
          </p:cNvPr>
          <p:cNvSpPr txBox="1"/>
          <p:nvPr/>
        </p:nvSpPr>
        <p:spPr>
          <a:xfrm>
            <a:off x="2276543" y="976447"/>
            <a:ext cx="176839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iver Fat Percentage</a:t>
            </a:r>
          </a:p>
        </p:txBody>
      </p:sp>
    </p:spTree>
    <p:extLst>
      <p:ext uri="{BB962C8B-B14F-4D97-AF65-F5344CB8AC3E}">
        <p14:creationId xmlns:p14="http://schemas.microsoft.com/office/powerpoint/2010/main" val="19220184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72</TotalTime>
  <Words>91</Words>
  <Application>Microsoft Office PowerPoint</Application>
  <PresentationFormat>Custom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cinski, Justine</dc:creator>
  <cp:lastModifiedBy>Igudesman, Daria</cp:lastModifiedBy>
  <cp:revision>4</cp:revision>
  <dcterms:created xsi:type="dcterms:W3CDTF">2022-12-23T22:05:51Z</dcterms:created>
  <dcterms:modified xsi:type="dcterms:W3CDTF">2023-10-10T16:45:52Z</dcterms:modified>
</cp:coreProperties>
</file>